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xlsm" ContentType="application/vnd.ms-excel.sheet.macroEnabled.12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9CA05"/>
    <a:srgbClr val="5B66A5"/>
    <a:srgbClr val="D400FA"/>
    <a:srgbClr val="4E6428"/>
    <a:srgbClr val="4F11A7"/>
    <a:srgbClr val="D81DF9"/>
    <a:srgbClr val="4B21A7"/>
    <a:srgbClr val="41C505"/>
    <a:srgbClr val="5669A5"/>
    <a:srgbClr val="4E63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305" autoAdjust="0"/>
  </p:normalViewPr>
  <p:slideViewPr>
    <p:cSldViewPr snapToGrid="0" snapToObjects="1" showGuides="1">
      <p:cViewPr>
        <p:scale>
          <a:sx n="200" d="100"/>
          <a:sy n="200" d="100"/>
        </p:scale>
        <p:origin x="-728" y="30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notesViewPr>
    <p:cSldViewPr snapToGrid="0" snapToObjects="1">
      <p:cViewPr varScale="1">
        <p:scale>
          <a:sx n="108" d="100"/>
          <a:sy n="108" d="100"/>
        </p:scale>
        <p:origin x="-3520" y="-11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Macro-Enabled_Worksheet1.xlsm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Macro-Enabled_Worksheet2.xlsm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5801171405298"/>
          <c:y val="0.166914483032848"/>
          <c:w val="0.717633438201581"/>
          <c:h val="0.643322011036219"/>
        </c:manualLayout>
      </c:layout>
      <c:scatterChart>
        <c:scatterStyle val="lineMarker"/>
        <c:varyColors val="0"/>
        <c:ser>
          <c:idx val="1"/>
          <c:order val="0"/>
          <c:tx>
            <c:v>2000 P/uL</c:v>
          </c:tx>
          <c:spPr>
            <a:ln w="19050">
              <a:solidFill>
                <a:srgbClr val="4E6428"/>
              </a:solidFill>
              <a:prstDash val="solid"/>
            </a:ln>
          </c:spPr>
          <c:marker>
            <c:symbol val="none"/>
          </c:marker>
          <c:xVal>
            <c:numRef>
              <c:f>MCAndF!$A$2:$A$101</c:f>
              <c:numCache>
                <c:formatCode>General</c:formatCode>
                <c:ptCount val="100"/>
                <c:pt idx="0">
                  <c:v>70.0</c:v>
                </c:pt>
                <c:pt idx="1">
                  <c:v>70.20202019810677</c:v>
                </c:pt>
                <c:pt idx="2">
                  <c:v>70.40404039621353</c:v>
                </c:pt>
                <c:pt idx="3">
                  <c:v>70.6060605943203</c:v>
                </c:pt>
                <c:pt idx="4">
                  <c:v>70.80808079242645</c:v>
                </c:pt>
                <c:pt idx="5">
                  <c:v>71.01010099053383</c:v>
                </c:pt>
                <c:pt idx="6">
                  <c:v>71.2121211886406</c:v>
                </c:pt>
                <c:pt idx="7">
                  <c:v>71.4141413867474</c:v>
                </c:pt>
                <c:pt idx="8">
                  <c:v>71.61616158485413</c:v>
                </c:pt>
                <c:pt idx="9">
                  <c:v>71.81818178296088</c:v>
                </c:pt>
                <c:pt idx="10">
                  <c:v>72.0202019810677</c:v>
                </c:pt>
                <c:pt idx="11">
                  <c:v>72.22222217917441</c:v>
                </c:pt>
                <c:pt idx="12">
                  <c:v>72.42424237728115</c:v>
                </c:pt>
                <c:pt idx="13">
                  <c:v>72.62626257538795</c:v>
                </c:pt>
                <c:pt idx="14">
                  <c:v>72.82828277349408</c:v>
                </c:pt>
                <c:pt idx="15">
                  <c:v>73.03030297160122</c:v>
                </c:pt>
                <c:pt idx="16">
                  <c:v>73.23232316970826</c:v>
                </c:pt>
                <c:pt idx="17">
                  <c:v>73.434343367815</c:v>
                </c:pt>
                <c:pt idx="18">
                  <c:v>73.63636356592178</c:v>
                </c:pt>
                <c:pt idx="19">
                  <c:v>73.83838376402855</c:v>
                </c:pt>
                <c:pt idx="20">
                  <c:v>74.0404039621353</c:v>
                </c:pt>
                <c:pt idx="21">
                  <c:v>74.2424241602421</c:v>
                </c:pt>
                <c:pt idx="22">
                  <c:v>74.4444443583489</c:v>
                </c:pt>
                <c:pt idx="23">
                  <c:v>74.64646455645534</c:v>
                </c:pt>
                <c:pt idx="24">
                  <c:v>74.84848475456238</c:v>
                </c:pt>
                <c:pt idx="25">
                  <c:v>75.05050495266887</c:v>
                </c:pt>
                <c:pt idx="26">
                  <c:v>75.25252515077591</c:v>
                </c:pt>
                <c:pt idx="27">
                  <c:v>75.45454534888267</c:v>
                </c:pt>
                <c:pt idx="28">
                  <c:v>75.65656554698917</c:v>
                </c:pt>
                <c:pt idx="29">
                  <c:v>75.85858574509621</c:v>
                </c:pt>
                <c:pt idx="30">
                  <c:v>76.060605943203</c:v>
                </c:pt>
                <c:pt idx="31">
                  <c:v>76.26262614130973</c:v>
                </c:pt>
                <c:pt idx="32">
                  <c:v>76.4646463394165</c:v>
                </c:pt>
                <c:pt idx="33">
                  <c:v>76.666666537523</c:v>
                </c:pt>
                <c:pt idx="34">
                  <c:v>76.86868673563004</c:v>
                </c:pt>
                <c:pt idx="35">
                  <c:v>77.0707069337363</c:v>
                </c:pt>
                <c:pt idx="36">
                  <c:v>77.27272713184327</c:v>
                </c:pt>
                <c:pt idx="37">
                  <c:v>77.47474732995028</c:v>
                </c:pt>
                <c:pt idx="38">
                  <c:v>77.67676752805667</c:v>
                </c:pt>
                <c:pt idx="39">
                  <c:v>77.87878772616322</c:v>
                </c:pt>
                <c:pt idx="40">
                  <c:v>78.08080792427063</c:v>
                </c:pt>
                <c:pt idx="41">
                  <c:v>78.2828281223774</c:v>
                </c:pt>
                <c:pt idx="42">
                  <c:v>78.48484832048369</c:v>
                </c:pt>
                <c:pt idx="43">
                  <c:v>78.68686851859039</c:v>
                </c:pt>
                <c:pt idx="44">
                  <c:v>78.88888871669705</c:v>
                </c:pt>
                <c:pt idx="45">
                  <c:v>79.09090891480425</c:v>
                </c:pt>
                <c:pt idx="46">
                  <c:v>79.29292911291121</c:v>
                </c:pt>
                <c:pt idx="47">
                  <c:v>79.494949311018</c:v>
                </c:pt>
                <c:pt idx="48">
                  <c:v>79.69696950912475</c:v>
                </c:pt>
                <c:pt idx="49">
                  <c:v>79.89898970723151</c:v>
                </c:pt>
                <c:pt idx="50">
                  <c:v>80.1010099053383</c:v>
                </c:pt>
                <c:pt idx="51">
                  <c:v>80.30303010344456</c:v>
                </c:pt>
                <c:pt idx="52">
                  <c:v>80.50505030155134</c:v>
                </c:pt>
                <c:pt idx="53">
                  <c:v>80.70707049965858</c:v>
                </c:pt>
                <c:pt idx="54">
                  <c:v>80.90909069776536</c:v>
                </c:pt>
                <c:pt idx="55">
                  <c:v>81.1111108958721</c:v>
                </c:pt>
                <c:pt idx="56">
                  <c:v>81.31313109397888</c:v>
                </c:pt>
                <c:pt idx="57">
                  <c:v>81.51515129208565</c:v>
                </c:pt>
                <c:pt idx="58">
                  <c:v>81.7171714901924</c:v>
                </c:pt>
                <c:pt idx="59">
                  <c:v>81.9191916882992</c:v>
                </c:pt>
                <c:pt idx="60">
                  <c:v>82.12121188640585</c:v>
                </c:pt>
                <c:pt idx="61">
                  <c:v>82.32323208451271</c:v>
                </c:pt>
                <c:pt idx="62">
                  <c:v>82.52525228261948</c:v>
                </c:pt>
                <c:pt idx="63">
                  <c:v>82.72727248072624</c:v>
                </c:pt>
                <c:pt idx="64">
                  <c:v>82.929292678833</c:v>
                </c:pt>
                <c:pt idx="65">
                  <c:v>83.1313128769393</c:v>
                </c:pt>
                <c:pt idx="66">
                  <c:v>83.33333307504654</c:v>
                </c:pt>
                <c:pt idx="67">
                  <c:v>83.53535327315331</c:v>
                </c:pt>
                <c:pt idx="68">
                  <c:v>83.7373734712601</c:v>
                </c:pt>
                <c:pt idx="69">
                  <c:v>83.9393936693669</c:v>
                </c:pt>
                <c:pt idx="70">
                  <c:v>84.1414138674736</c:v>
                </c:pt>
                <c:pt idx="71">
                  <c:v>84.34343406558037</c:v>
                </c:pt>
                <c:pt idx="72">
                  <c:v>84.54545426368713</c:v>
                </c:pt>
                <c:pt idx="73">
                  <c:v>84.7474744617939</c:v>
                </c:pt>
                <c:pt idx="74">
                  <c:v>84.9494946599007</c:v>
                </c:pt>
                <c:pt idx="75">
                  <c:v>85.15151485800743</c:v>
                </c:pt>
                <c:pt idx="76">
                  <c:v>85.35353505611393</c:v>
                </c:pt>
                <c:pt idx="77">
                  <c:v>85.55555525422095</c:v>
                </c:pt>
                <c:pt idx="78">
                  <c:v>85.75757545232773</c:v>
                </c:pt>
                <c:pt idx="79">
                  <c:v>85.95959565043448</c:v>
                </c:pt>
                <c:pt idx="80">
                  <c:v>86.16161584854125</c:v>
                </c:pt>
                <c:pt idx="81">
                  <c:v>86.36363604664803</c:v>
                </c:pt>
                <c:pt idx="82">
                  <c:v>86.56565624475478</c:v>
                </c:pt>
                <c:pt idx="83">
                  <c:v>86.76767644286155</c:v>
                </c:pt>
                <c:pt idx="84">
                  <c:v>86.9696966409683</c:v>
                </c:pt>
                <c:pt idx="85">
                  <c:v>87.17171683907505</c:v>
                </c:pt>
                <c:pt idx="86">
                  <c:v>87.37373703718104</c:v>
                </c:pt>
                <c:pt idx="87">
                  <c:v>87.57575723528815</c:v>
                </c:pt>
                <c:pt idx="88">
                  <c:v>87.77777743339512</c:v>
                </c:pt>
                <c:pt idx="89">
                  <c:v>87.97979763150215</c:v>
                </c:pt>
                <c:pt idx="90">
                  <c:v>88.18181782960885</c:v>
                </c:pt>
                <c:pt idx="91">
                  <c:v>88.38383802771541</c:v>
                </c:pt>
                <c:pt idx="92">
                  <c:v>88.58585822582245</c:v>
                </c:pt>
                <c:pt idx="93">
                  <c:v>88.78787842392894</c:v>
                </c:pt>
                <c:pt idx="94">
                  <c:v>88.98989862203598</c:v>
                </c:pt>
                <c:pt idx="95">
                  <c:v>89.19191882014274</c:v>
                </c:pt>
                <c:pt idx="96">
                  <c:v>89.39393901824951</c:v>
                </c:pt>
                <c:pt idx="97">
                  <c:v>89.59595921635628</c:v>
                </c:pt>
                <c:pt idx="98">
                  <c:v>89.79797941446304</c:v>
                </c:pt>
                <c:pt idx="99">
                  <c:v>89.99999961256981</c:v>
                </c:pt>
              </c:numCache>
            </c:numRef>
          </c:xVal>
          <c:yVal>
            <c:numRef>
              <c:f>MCAndF!$C$2:$C$101</c:f>
              <c:numCache>
                <c:formatCode>General</c:formatCode>
                <c:ptCount val="100"/>
                <c:pt idx="0">
                  <c:v>-132.12890625</c:v>
                </c:pt>
                <c:pt idx="1">
                  <c:v>-155.615234375</c:v>
                </c:pt>
                <c:pt idx="2">
                  <c:v>-113.875</c:v>
                </c:pt>
                <c:pt idx="3">
                  <c:v>-17.36458396911621</c:v>
                </c:pt>
                <c:pt idx="4">
                  <c:v>27.9208984375</c:v>
                </c:pt>
                <c:pt idx="5">
                  <c:v>45.07152175903301</c:v>
                </c:pt>
                <c:pt idx="6">
                  <c:v>67.96994018554687</c:v>
                </c:pt>
                <c:pt idx="7">
                  <c:v>77.30573272705021</c:v>
                </c:pt>
                <c:pt idx="8">
                  <c:v>81.89600372314453</c:v>
                </c:pt>
                <c:pt idx="9">
                  <c:v>80.62015533447239</c:v>
                </c:pt>
                <c:pt idx="10">
                  <c:v>87.27012634277344</c:v>
                </c:pt>
                <c:pt idx="11">
                  <c:v>84.57971954345658</c:v>
                </c:pt>
                <c:pt idx="12">
                  <c:v>90.33753967285155</c:v>
                </c:pt>
                <c:pt idx="13">
                  <c:v>88.4809646606446</c:v>
                </c:pt>
                <c:pt idx="14">
                  <c:v>87.96183776855455</c:v>
                </c:pt>
                <c:pt idx="15">
                  <c:v>88.59469604492187</c:v>
                </c:pt>
                <c:pt idx="16">
                  <c:v>89.14250946044921</c:v>
                </c:pt>
                <c:pt idx="17">
                  <c:v>89.37549591064406</c:v>
                </c:pt>
                <c:pt idx="18">
                  <c:v>90.76707458496093</c:v>
                </c:pt>
                <c:pt idx="19">
                  <c:v>93.22776031494141</c:v>
                </c:pt>
                <c:pt idx="20">
                  <c:v>97.18280029296835</c:v>
                </c:pt>
                <c:pt idx="21">
                  <c:v>101.2498779296875</c:v>
                </c:pt>
                <c:pt idx="22">
                  <c:v>104.5652313232422</c:v>
                </c:pt>
                <c:pt idx="23">
                  <c:v>107.2180709838867</c:v>
                </c:pt>
                <c:pt idx="24">
                  <c:v>110.1575546264648</c:v>
                </c:pt>
                <c:pt idx="25">
                  <c:v>113.9227066040039</c:v>
                </c:pt>
                <c:pt idx="26">
                  <c:v>117.7752456665039</c:v>
                </c:pt>
                <c:pt idx="27">
                  <c:v>124.1469650268555</c:v>
                </c:pt>
                <c:pt idx="28">
                  <c:v>128.8785552978511</c:v>
                </c:pt>
                <c:pt idx="29">
                  <c:v>131.0521240234375</c:v>
                </c:pt>
                <c:pt idx="30">
                  <c:v>133.825912475586</c:v>
                </c:pt>
                <c:pt idx="31">
                  <c:v>136.4907684326172</c:v>
                </c:pt>
                <c:pt idx="32">
                  <c:v>139.986557006836</c:v>
                </c:pt>
                <c:pt idx="33">
                  <c:v>142.6315307617187</c:v>
                </c:pt>
                <c:pt idx="34">
                  <c:v>145.7173004150391</c:v>
                </c:pt>
                <c:pt idx="35">
                  <c:v>149.4423828125</c:v>
                </c:pt>
                <c:pt idx="36">
                  <c:v>159.1969299316406</c:v>
                </c:pt>
                <c:pt idx="37">
                  <c:v>167.0796813964844</c:v>
                </c:pt>
                <c:pt idx="38">
                  <c:v>179.3729400634766</c:v>
                </c:pt>
                <c:pt idx="39">
                  <c:v>192.7789459228516</c:v>
                </c:pt>
                <c:pt idx="40">
                  <c:v>207.508026123047</c:v>
                </c:pt>
                <c:pt idx="41">
                  <c:v>226.4729309082031</c:v>
                </c:pt>
                <c:pt idx="42">
                  <c:v>246.4120330810547</c:v>
                </c:pt>
                <c:pt idx="43">
                  <c:v>269.9620971679687</c:v>
                </c:pt>
                <c:pt idx="44">
                  <c:v>307.4608154296872</c:v>
                </c:pt>
                <c:pt idx="45">
                  <c:v>342.2558898925781</c:v>
                </c:pt>
                <c:pt idx="46">
                  <c:v>373.3470764160156</c:v>
                </c:pt>
                <c:pt idx="47">
                  <c:v>402.1380004882791</c:v>
                </c:pt>
                <c:pt idx="48">
                  <c:v>426.3374938964844</c:v>
                </c:pt>
                <c:pt idx="49">
                  <c:v>461.6325073242187</c:v>
                </c:pt>
                <c:pt idx="50">
                  <c:v>523.5300903320312</c:v>
                </c:pt>
                <c:pt idx="51">
                  <c:v>608.22998046875</c:v>
                </c:pt>
                <c:pt idx="52">
                  <c:v>736.1438598632812</c:v>
                </c:pt>
                <c:pt idx="53">
                  <c:v>869.8728637695312</c:v>
                </c:pt>
                <c:pt idx="54">
                  <c:v>1015.167358398437</c:v>
                </c:pt>
                <c:pt idx="55">
                  <c:v>1171.193237304687</c:v>
                </c:pt>
                <c:pt idx="56">
                  <c:v>1341.493774414062</c:v>
                </c:pt>
                <c:pt idx="57">
                  <c:v>1519.06103515625</c:v>
                </c:pt>
                <c:pt idx="58">
                  <c:v>1684.80078125</c:v>
                </c:pt>
                <c:pt idx="59">
                  <c:v>1841.749267578125</c:v>
                </c:pt>
                <c:pt idx="60">
                  <c:v>1965.230590820312</c:v>
                </c:pt>
                <c:pt idx="61">
                  <c:v>2084.92822265625</c:v>
                </c:pt>
                <c:pt idx="62">
                  <c:v>2168.2685546875</c:v>
                </c:pt>
                <c:pt idx="63">
                  <c:v>2210.95458984375</c:v>
                </c:pt>
                <c:pt idx="64">
                  <c:v>2219.510498046875</c:v>
                </c:pt>
                <c:pt idx="65">
                  <c:v>2189.035400390625</c:v>
                </c:pt>
                <c:pt idx="66">
                  <c:v>2115.656982421875</c:v>
                </c:pt>
                <c:pt idx="67">
                  <c:v>2022.781860351562</c:v>
                </c:pt>
                <c:pt idx="68">
                  <c:v>1910.826416015625</c:v>
                </c:pt>
                <c:pt idx="69">
                  <c:v>1784.03076171875</c:v>
                </c:pt>
                <c:pt idx="70">
                  <c:v>1645.406982421875</c:v>
                </c:pt>
                <c:pt idx="71">
                  <c:v>1482.500122070312</c:v>
                </c:pt>
                <c:pt idx="72">
                  <c:v>1301.851684570312</c:v>
                </c:pt>
                <c:pt idx="73">
                  <c:v>1110.842407226562</c:v>
                </c:pt>
                <c:pt idx="74">
                  <c:v>910.80419921875</c:v>
                </c:pt>
                <c:pt idx="75">
                  <c:v>742.7183227539062</c:v>
                </c:pt>
                <c:pt idx="76">
                  <c:v>586.9962768554674</c:v>
                </c:pt>
                <c:pt idx="77">
                  <c:v>446.8072814941406</c:v>
                </c:pt>
                <c:pt idx="78">
                  <c:v>321.5452575683594</c:v>
                </c:pt>
                <c:pt idx="79">
                  <c:v>218.3218994140625</c:v>
                </c:pt>
                <c:pt idx="80">
                  <c:v>145.830810546875</c:v>
                </c:pt>
                <c:pt idx="81">
                  <c:v>95.20876312255824</c:v>
                </c:pt>
                <c:pt idx="82">
                  <c:v>65.28929138183593</c:v>
                </c:pt>
                <c:pt idx="83">
                  <c:v>31.52091789245605</c:v>
                </c:pt>
                <c:pt idx="84">
                  <c:v>22.05415344238281</c:v>
                </c:pt>
                <c:pt idx="85">
                  <c:v>20.61348915100098</c:v>
                </c:pt>
                <c:pt idx="86">
                  <c:v>20.19244194030762</c:v>
                </c:pt>
                <c:pt idx="87">
                  <c:v>21.36968994140625</c:v>
                </c:pt>
                <c:pt idx="88">
                  <c:v>24.4173755645752</c:v>
                </c:pt>
                <c:pt idx="89">
                  <c:v>31.86584663391108</c:v>
                </c:pt>
                <c:pt idx="90">
                  <c:v>29.96057891845703</c:v>
                </c:pt>
                <c:pt idx="91">
                  <c:v>37.42858123779297</c:v>
                </c:pt>
                <c:pt idx="92">
                  <c:v>35.14294815063477</c:v>
                </c:pt>
                <c:pt idx="93">
                  <c:v>31.84606170654297</c:v>
                </c:pt>
                <c:pt idx="94">
                  <c:v>42.98961639404297</c:v>
                </c:pt>
                <c:pt idx="95">
                  <c:v>22.44906425476074</c:v>
                </c:pt>
                <c:pt idx="96">
                  <c:v>22.04599189758301</c:v>
                </c:pt>
                <c:pt idx="97">
                  <c:v>44.07958984375</c:v>
                </c:pt>
                <c:pt idx="98">
                  <c:v>82.419921875</c:v>
                </c:pt>
                <c:pt idx="99">
                  <c:v>87.20019531249947</c:v>
                </c:pt>
              </c:numCache>
            </c:numRef>
          </c:yVal>
          <c:smooth val="0"/>
        </c:ser>
        <c:ser>
          <c:idx val="3"/>
          <c:order val="1"/>
          <c:tx>
            <c:v>200 P/uL</c:v>
          </c:tx>
          <c:spPr>
            <a:ln w="19050">
              <a:solidFill>
                <a:srgbClr val="D400FA"/>
              </a:solidFill>
              <a:prstDash val="solid"/>
            </a:ln>
          </c:spPr>
          <c:marker>
            <c:symbol val="none"/>
          </c:marker>
          <c:xVal>
            <c:numRef>
              <c:f>MCAndF!$A$2:$A$101</c:f>
              <c:numCache>
                <c:formatCode>General</c:formatCode>
                <c:ptCount val="100"/>
                <c:pt idx="0">
                  <c:v>70.0</c:v>
                </c:pt>
                <c:pt idx="1">
                  <c:v>70.20202019810677</c:v>
                </c:pt>
                <c:pt idx="2">
                  <c:v>70.40404039621353</c:v>
                </c:pt>
                <c:pt idx="3">
                  <c:v>70.6060605943203</c:v>
                </c:pt>
                <c:pt idx="4">
                  <c:v>70.80808079242645</c:v>
                </c:pt>
                <c:pt idx="5">
                  <c:v>71.01010099053383</c:v>
                </c:pt>
                <c:pt idx="6">
                  <c:v>71.2121211886406</c:v>
                </c:pt>
                <c:pt idx="7">
                  <c:v>71.4141413867474</c:v>
                </c:pt>
                <c:pt idx="8">
                  <c:v>71.61616158485413</c:v>
                </c:pt>
                <c:pt idx="9">
                  <c:v>71.81818178296088</c:v>
                </c:pt>
                <c:pt idx="10">
                  <c:v>72.0202019810677</c:v>
                </c:pt>
                <c:pt idx="11">
                  <c:v>72.22222217917441</c:v>
                </c:pt>
                <c:pt idx="12">
                  <c:v>72.42424237728115</c:v>
                </c:pt>
                <c:pt idx="13">
                  <c:v>72.62626257538795</c:v>
                </c:pt>
                <c:pt idx="14">
                  <c:v>72.82828277349408</c:v>
                </c:pt>
                <c:pt idx="15">
                  <c:v>73.03030297160122</c:v>
                </c:pt>
                <c:pt idx="16">
                  <c:v>73.23232316970826</c:v>
                </c:pt>
                <c:pt idx="17">
                  <c:v>73.434343367815</c:v>
                </c:pt>
                <c:pt idx="18">
                  <c:v>73.63636356592178</c:v>
                </c:pt>
                <c:pt idx="19">
                  <c:v>73.83838376402855</c:v>
                </c:pt>
                <c:pt idx="20">
                  <c:v>74.0404039621353</c:v>
                </c:pt>
                <c:pt idx="21">
                  <c:v>74.2424241602421</c:v>
                </c:pt>
                <c:pt idx="22">
                  <c:v>74.4444443583489</c:v>
                </c:pt>
                <c:pt idx="23">
                  <c:v>74.64646455645534</c:v>
                </c:pt>
                <c:pt idx="24">
                  <c:v>74.84848475456238</c:v>
                </c:pt>
                <c:pt idx="25">
                  <c:v>75.05050495266887</c:v>
                </c:pt>
                <c:pt idx="26">
                  <c:v>75.25252515077591</c:v>
                </c:pt>
                <c:pt idx="27">
                  <c:v>75.45454534888267</c:v>
                </c:pt>
                <c:pt idx="28">
                  <c:v>75.65656554698917</c:v>
                </c:pt>
                <c:pt idx="29">
                  <c:v>75.85858574509621</c:v>
                </c:pt>
                <c:pt idx="30">
                  <c:v>76.060605943203</c:v>
                </c:pt>
                <c:pt idx="31">
                  <c:v>76.26262614130973</c:v>
                </c:pt>
                <c:pt idx="32">
                  <c:v>76.4646463394165</c:v>
                </c:pt>
                <c:pt idx="33">
                  <c:v>76.666666537523</c:v>
                </c:pt>
                <c:pt idx="34">
                  <c:v>76.86868673563004</c:v>
                </c:pt>
                <c:pt idx="35">
                  <c:v>77.0707069337363</c:v>
                </c:pt>
                <c:pt idx="36">
                  <c:v>77.27272713184327</c:v>
                </c:pt>
                <c:pt idx="37">
                  <c:v>77.47474732995028</c:v>
                </c:pt>
                <c:pt idx="38">
                  <c:v>77.67676752805667</c:v>
                </c:pt>
                <c:pt idx="39">
                  <c:v>77.87878772616322</c:v>
                </c:pt>
                <c:pt idx="40">
                  <c:v>78.08080792427063</c:v>
                </c:pt>
                <c:pt idx="41">
                  <c:v>78.2828281223774</c:v>
                </c:pt>
                <c:pt idx="42">
                  <c:v>78.48484832048369</c:v>
                </c:pt>
                <c:pt idx="43">
                  <c:v>78.68686851859039</c:v>
                </c:pt>
                <c:pt idx="44">
                  <c:v>78.88888871669705</c:v>
                </c:pt>
                <c:pt idx="45">
                  <c:v>79.09090891480425</c:v>
                </c:pt>
                <c:pt idx="46">
                  <c:v>79.29292911291121</c:v>
                </c:pt>
                <c:pt idx="47">
                  <c:v>79.494949311018</c:v>
                </c:pt>
                <c:pt idx="48">
                  <c:v>79.69696950912475</c:v>
                </c:pt>
                <c:pt idx="49">
                  <c:v>79.89898970723151</c:v>
                </c:pt>
                <c:pt idx="50">
                  <c:v>80.1010099053383</c:v>
                </c:pt>
                <c:pt idx="51">
                  <c:v>80.30303010344456</c:v>
                </c:pt>
                <c:pt idx="52">
                  <c:v>80.50505030155134</c:v>
                </c:pt>
                <c:pt idx="53">
                  <c:v>80.70707049965858</c:v>
                </c:pt>
                <c:pt idx="54">
                  <c:v>80.90909069776536</c:v>
                </c:pt>
                <c:pt idx="55">
                  <c:v>81.1111108958721</c:v>
                </c:pt>
                <c:pt idx="56">
                  <c:v>81.31313109397888</c:v>
                </c:pt>
                <c:pt idx="57">
                  <c:v>81.51515129208565</c:v>
                </c:pt>
                <c:pt idx="58">
                  <c:v>81.7171714901924</c:v>
                </c:pt>
                <c:pt idx="59">
                  <c:v>81.9191916882992</c:v>
                </c:pt>
                <c:pt idx="60">
                  <c:v>82.12121188640585</c:v>
                </c:pt>
                <c:pt idx="61">
                  <c:v>82.32323208451271</c:v>
                </c:pt>
                <c:pt idx="62">
                  <c:v>82.52525228261948</c:v>
                </c:pt>
                <c:pt idx="63">
                  <c:v>82.72727248072624</c:v>
                </c:pt>
                <c:pt idx="64">
                  <c:v>82.929292678833</c:v>
                </c:pt>
                <c:pt idx="65">
                  <c:v>83.1313128769393</c:v>
                </c:pt>
                <c:pt idx="66">
                  <c:v>83.33333307504654</c:v>
                </c:pt>
                <c:pt idx="67">
                  <c:v>83.53535327315331</c:v>
                </c:pt>
                <c:pt idx="68">
                  <c:v>83.7373734712601</c:v>
                </c:pt>
                <c:pt idx="69">
                  <c:v>83.9393936693669</c:v>
                </c:pt>
                <c:pt idx="70">
                  <c:v>84.1414138674736</c:v>
                </c:pt>
                <c:pt idx="71">
                  <c:v>84.34343406558037</c:v>
                </c:pt>
                <c:pt idx="72">
                  <c:v>84.54545426368713</c:v>
                </c:pt>
                <c:pt idx="73">
                  <c:v>84.7474744617939</c:v>
                </c:pt>
                <c:pt idx="74">
                  <c:v>84.9494946599007</c:v>
                </c:pt>
                <c:pt idx="75">
                  <c:v>85.15151485800743</c:v>
                </c:pt>
                <c:pt idx="76">
                  <c:v>85.35353505611393</c:v>
                </c:pt>
                <c:pt idx="77">
                  <c:v>85.55555525422095</c:v>
                </c:pt>
                <c:pt idx="78">
                  <c:v>85.75757545232773</c:v>
                </c:pt>
                <c:pt idx="79">
                  <c:v>85.95959565043448</c:v>
                </c:pt>
                <c:pt idx="80">
                  <c:v>86.16161584854125</c:v>
                </c:pt>
                <c:pt idx="81">
                  <c:v>86.36363604664803</c:v>
                </c:pt>
                <c:pt idx="82">
                  <c:v>86.56565624475478</c:v>
                </c:pt>
                <c:pt idx="83">
                  <c:v>86.76767644286155</c:v>
                </c:pt>
                <c:pt idx="84">
                  <c:v>86.9696966409683</c:v>
                </c:pt>
                <c:pt idx="85">
                  <c:v>87.17171683907505</c:v>
                </c:pt>
                <c:pt idx="86">
                  <c:v>87.37373703718104</c:v>
                </c:pt>
                <c:pt idx="87">
                  <c:v>87.57575723528815</c:v>
                </c:pt>
                <c:pt idx="88">
                  <c:v>87.77777743339512</c:v>
                </c:pt>
                <c:pt idx="89">
                  <c:v>87.97979763150215</c:v>
                </c:pt>
                <c:pt idx="90">
                  <c:v>88.18181782960885</c:v>
                </c:pt>
                <c:pt idx="91">
                  <c:v>88.38383802771541</c:v>
                </c:pt>
                <c:pt idx="92">
                  <c:v>88.58585822582245</c:v>
                </c:pt>
                <c:pt idx="93">
                  <c:v>88.78787842392894</c:v>
                </c:pt>
                <c:pt idx="94">
                  <c:v>88.98989862203598</c:v>
                </c:pt>
                <c:pt idx="95">
                  <c:v>89.19191882014274</c:v>
                </c:pt>
                <c:pt idx="96">
                  <c:v>89.39393901824951</c:v>
                </c:pt>
                <c:pt idx="97">
                  <c:v>89.59595921635628</c:v>
                </c:pt>
                <c:pt idx="98">
                  <c:v>89.79797941446304</c:v>
                </c:pt>
                <c:pt idx="99">
                  <c:v>89.99999961256981</c:v>
                </c:pt>
              </c:numCache>
            </c:numRef>
          </c:xVal>
          <c:yVal>
            <c:numRef>
              <c:f>MCAndF!$E$2:$E$101</c:f>
              <c:numCache>
                <c:formatCode>General</c:formatCode>
                <c:ptCount val="100"/>
                <c:pt idx="0">
                  <c:v>-514.1406249999975</c:v>
                </c:pt>
                <c:pt idx="1">
                  <c:v>-462.0703124999989</c:v>
                </c:pt>
                <c:pt idx="2">
                  <c:v>-313.654296875</c:v>
                </c:pt>
                <c:pt idx="3">
                  <c:v>-100.9765625</c:v>
                </c:pt>
                <c:pt idx="4">
                  <c:v>68.7115859985352</c:v>
                </c:pt>
                <c:pt idx="5">
                  <c:v>95.25319671630858</c:v>
                </c:pt>
                <c:pt idx="6">
                  <c:v>124.6075744628906</c:v>
                </c:pt>
                <c:pt idx="7">
                  <c:v>168.881805419922</c:v>
                </c:pt>
                <c:pt idx="8">
                  <c:v>194.730438232422</c:v>
                </c:pt>
                <c:pt idx="9">
                  <c:v>195.7865905761719</c:v>
                </c:pt>
                <c:pt idx="10">
                  <c:v>198.8192749023437</c:v>
                </c:pt>
                <c:pt idx="11">
                  <c:v>190.9420776367187</c:v>
                </c:pt>
                <c:pt idx="12">
                  <c:v>206.0680694580078</c:v>
                </c:pt>
                <c:pt idx="13">
                  <c:v>203.1620025634766</c:v>
                </c:pt>
                <c:pt idx="14">
                  <c:v>202.9487152099609</c:v>
                </c:pt>
                <c:pt idx="15">
                  <c:v>206.148406982422</c:v>
                </c:pt>
                <c:pt idx="16">
                  <c:v>210.7040557861311</c:v>
                </c:pt>
                <c:pt idx="17">
                  <c:v>214.8209533691406</c:v>
                </c:pt>
                <c:pt idx="18">
                  <c:v>221.5674438476562</c:v>
                </c:pt>
                <c:pt idx="19">
                  <c:v>232.8466339111328</c:v>
                </c:pt>
                <c:pt idx="20">
                  <c:v>247.1451721191405</c:v>
                </c:pt>
                <c:pt idx="21">
                  <c:v>260.3372497558594</c:v>
                </c:pt>
                <c:pt idx="22">
                  <c:v>271.1484680175781</c:v>
                </c:pt>
                <c:pt idx="23">
                  <c:v>279.60498046875</c:v>
                </c:pt>
                <c:pt idx="24">
                  <c:v>286.4664306640625</c:v>
                </c:pt>
                <c:pt idx="25">
                  <c:v>289.3286132812489</c:v>
                </c:pt>
                <c:pt idx="26">
                  <c:v>296.1384582519531</c:v>
                </c:pt>
                <c:pt idx="27">
                  <c:v>307.8485717773437</c:v>
                </c:pt>
                <c:pt idx="28">
                  <c:v>317.7344970703125</c:v>
                </c:pt>
                <c:pt idx="29">
                  <c:v>326.2494201660156</c:v>
                </c:pt>
                <c:pt idx="30">
                  <c:v>333.6846618652344</c:v>
                </c:pt>
                <c:pt idx="31">
                  <c:v>340.0345153808594</c:v>
                </c:pt>
                <c:pt idx="32">
                  <c:v>342.9829101562489</c:v>
                </c:pt>
                <c:pt idx="33">
                  <c:v>344.75927734375</c:v>
                </c:pt>
                <c:pt idx="34">
                  <c:v>350.6365966796872</c:v>
                </c:pt>
                <c:pt idx="35">
                  <c:v>361.5562133789062</c:v>
                </c:pt>
                <c:pt idx="36">
                  <c:v>395.9492797851562</c:v>
                </c:pt>
                <c:pt idx="37">
                  <c:v>428.72802734375</c:v>
                </c:pt>
                <c:pt idx="38">
                  <c:v>464.9140625</c:v>
                </c:pt>
                <c:pt idx="39">
                  <c:v>510.5446472167968</c:v>
                </c:pt>
                <c:pt idx="40">
                  <c:v>568.727783203125</c:v>
                </c:pt>
                <c:pt idx="41">
                  <c:v>642.2669067382812</c:v>
                </c:pt>
                <c:pt idx="42">
                  <c:v>732.8566894531225</c:v>
                </c:pt>
                <c:pt idx="43">
                  <c:v>841.1038208007812</c:v>
                </c:pt>
                <c:pt idx="44">
                  <c:v>983.3634643554674</c:v>
                </c:pt>
                <c:pt idx="45">
                  <c:v>1116.011108398437</c:v>
                </c:pt>
                <c:pt idx="46">
                  <c:v>1238.170776367187</c:v>
                </c:pt>
                <c:pt idx="47">
                  <c:v>1356.646362304687</c:v>
                </c:pt>
                <c:pt idx="48">
                  <c:v>1469.324462890625</c:v>
                </c:pt>
                <c:pt idx="49">
                  <c:v>1575.808471679687</c:v>
                </c:pt>
                <c:pt idx="50">
                  <c:v>1677.272338867187</c:v>
                </c:pt>
                <c:pt idx="51">
                  <c:v>1772.55322265625</c:v>
                </c:pt>
                <c:pt idx="52">
                  <c:v>1863.861328125</c:v>
                </c:pt>
                <c:pt idx="53">
                  <c:v>1928.113647460937</c:v>
                </c:pt>
                <c:pt idx="54">
                  <c:v>1961.447143554687</c:v>
                </c:pt>
                <c:pt idx="55">
                  <c:v>1961.126098632812</c:v>
                </c:pt>
                <c:pt idx="56">
                  <c:v>1923.765380859375</c:v>
                </c:pt>
                <c:pt idx="57">
                  <c:v>1845.851318359375</c:v>
                </c:pt>
                <c:pt idx="58">
                  <c:v>1724.327392578125</c:v>
                </c:pt>
                <c:pt idx="59">
                  <c:v>1592.6826171875</c:v>
                </c:pt>
                <c:pt idx="60">
                  <c:v>1437.297241210937</c:v>
                </c:pt>
                <c:pt idx="61">
                  <c:v>1264.434692382812</c:v>
                </c:pt>
                <c:pt idx="62">
                  <c:v>1079.000732421875</c:v>
                </c:pt>
                <c:pt idx="63">
                  <c:v>886.0087280273437</c:v>
                </c:pt>
                <c:pt idx="64">
                  <c:v>694.8502197265624</c:v>
                </c:pt>
                <c:pt idx="65">
                  <c:v>512.691284179688</c:v>
                </c:pt>
                <c:pt idx="66">
                  <c:v>342.4100952148437</c:v>
                </c:pt>
                <c:pt idx="67">
                  <c:v>226.0642852783203</c:v>
                </c:pt>
                <c:pt idx="68">
                  <c:v>143.8636322021484</c:v>
                </c:pt>
                <c:pt idx="69">
                  <c:v>88.10287475585891</c:v>
                </c:pt>
                <c:pt idx="70">
                  <c:v>54.89400863647461</c:v>
                </c:pt>
                <c:pt idx="71">
                  <c:v>37.74755477905273</c:v>
                </c:pt>
                <c:pt idx="72">
                  <c:v>31.29410743713379</c:v>
                </c:pt>
                <c:pt idx="73">
                  <c:v>23.80968284606928</c:v>
                </c:pt>
                <c:pt idx="74">
                  <c:v>15.39420700073242</c:v>
                </c:pt>
                <c:pt idx="75">
                  <c:v>16.0671615600586</c:v>
                </c:pt>
                <c:pt idx="76">
                  <c:v>20.77106475830078</c:v>
                </c:pt>
                <c:pt idx="77">
                  <c:v>24.35572242736816</c:v>
                </c:pt>
                <c:pt idx="78">
                  <c:v>28.77552223205558</c:v>
                </c:pt>
                <c:pt idx="79">
                  <c:v>32.25632095336914</c:v>
                </c:pt>
                <c:pt idx="80">
                  <c:v>36.26867675781249</c:v>
                </c:pt>
                <c:pt idx="81">
                  <c:v>36.41487121582012</c:v>
                </c:pt>
                <c:pt idx="82">
                  <c:v>36.83698272705078</c:v>
                </c:pt>
                <c:pt idx="83">
                  <c:v>35.05236816406249</c:v>
                </c:pt>
                <c:pt idx="84">
                  <c:v>34.25125122070312</c:v>
                </c:pt>
                <c:pt idx="85">
                  <c:v>35.19012451171875</c:v>
                </c:pt>
                <c:pt idx="86">
                  <c:v>34.43376541137695</c:v>
                </c:pt>
                <c:pt idx="87">
                  <c:v>32.58434295654297</c:v>
                </c:pt>
                <c:pt idx="88">
                  <c:v>29.48111915588379</c:v>
                </c:pt>
                <c:pt idx="89">
                  <c:v>27.7412109375</c:v>
                </c:pt>
                <c:pt idx="90">
                  <c:v>22.01014518737793</c:v>
                </c:pt>
                <c:pt idx="91">
                  <c:v>22.21937561035156</c:v>
                </c:pt>
                <c:pt idx="92">
                  <c:v>26.83443832397461</c:v>
                </c:pt>
                <c:pt idx="93">
                  <c:v>22.26232719421387</c:v>
                </c:pt>
                <c:pt idx="94">
                  <c:v>6.95292329788208</c:v>
                </c:pt>
                <c:pt idx="95">
                  <c:v>-11.3063497543335</c:v>
                </c:pt>
                <c:pt idx="96">
                  <c:v>-3.528215646743774</c:v>
                </c:pt>
                <c:pt idx="97">
                  <c:v>34.80468749999973</c:v>
                </c:pt>
                <c:pt idx="98">
                  <c:v>59.90478515624999</c:v>
                </c:pt>
                <c:pt idx="99">
                  <c:v>50.2001953125</c:v>
                </c:pt>
              </c:numCache>
            </c:numRef>
          </c:yVal>
          <c:smooth val="0"/>
        </c:ser>
        <c:ser>
          <c:idx val="5"/>
          <c:order val="2"/>
          <c:tx>
            <c:v>20 P/uL</c:v>
          </c:tx>
          <c:spPr>
            <a:ln w="19050">
              <a:solidFill>
                <a:srgbClr val="5B66A5"/>
              </a:solidFill>
              <a:prstDash val="solid"/>
            </a:ln>
          </c:spPr>
          <c:marker>
            <c:symbol val="none"/>
          </c:marker>
          <c:xVal>
            <c:numRef>
              <c:f>MCAndF!$A$2:$A$101</c:f>
              <c:numCache>
                <c:formatCode>General</c:formatCode>
                <c:ptCount val="100"/>
                <c:pt idx="0">
                  <c:v>70.0</c:v>
                </c:pt>
                <c:pt idx="1">
                  <c:v>70.20202019810677</c:v>
                </c:pt>
                <c:pt idx="2">
                  <c:v>70.40404039621353</c:v>
                </c:pt>
                <c:pt idx="3">
                  <c:v>70.6060605943203</c:v>
                </c:pt>
                <c:pt idx="4">
                  <c:v>70.80808079242645</c:v>
                </c:pt>
                <c:pt idx="5">
                  <c:v>71.01010099053383</c:v>
                </c:pt>
                <c:pt idx="6">
                  <c:v>71.2121211886406</c:v>
                </c:pt>
                <c:pt idx="7">
                  <c:v>71.4141413867474</c:v>
                </c:pt>
                <c:pt idx="8">
                  <c:v>71.61616158485413</c:v>
                </c:pt>
                <c:pt idx="9">
                  <c:v>71.81818178296088</c:v>
                </c:pt>
                <c:pt idx="10">
                  <c:v>72.0202019810677</c:v>
                </c:pt>
                <c:pt idx="11">
                  <c:v>72.22222217917441</c:v>
                </c:pt>
                <c:pt idx="12">
                  <c:v>72.42424237728115</c:v>
                </c:pt>
                <c:pt idx="13">
                  <c:v>72.62626257538795</c:v>
                </c:pt>
                <c:pt idx="14">
                  <c:v>72.82828277349408</c:v>
                </c:pt>
                <c:pt idx="15">
                  <c:v>73.03030297160122</c:v>
                </c:pt>
                <c:pt idx="16">
                  <c:v>73.23232316970826</c:v>
                </c:pt>
                <c:pt idx="17">
                  <c:v>73.434343367815</c:v>
                </c:pt>
                <c:pt idx="18">
                  <c:v>73.63636356592178</c:v>
                </c:pt>
                <c:pt idx="19">
                  <c:v>73.83838376402855</c:v>
                </c:pt>
                <c:pt idx="20">
                  <c:v>74.0404039621353</c:v>
                </c:pt>
                <c:pt idx="21">
                  <c:v>74.2424241602421</c:v>
                </c:pt>
                <c:pt idx="22">
                  <c:v>74.4444443583489</c:v>
                </c:pt>
                <c:pt idx="23">
                  <c:v>74.64646455645534</c:v>
                </c:pt>
                <c:pt idx="24">
                  <c:v>74.84848475456238</c:v>
                </c:pt>
                <c:pt idx="25">
                  <c:v>75.05050495266887</c:v>
                </c:pt>
                <c:pt idx="26">
                  <c:v>75.25252515077591</c:v>
                </c:pt>
                <c:pt idx="27">
                  <c:v>75.45454534888267</c:v>
                </c:pt>
                <c:pt idx="28">
                  <c:v>75.65656554698917</c:v>
                </c:pt>
                <c:pt idx="29">
                  <c:v>75.85858574509621</c:v>
                </c:pt>
                <c:pt idx="30">
                  <c:v>76.060605943203</c:v>
                </c:pt>
                <c:pt idx="31">
                  <c:v>76.26262614130973</c:v>
                </c:pt>
                <c:pt idx="32">
                  <c:v>76.4646463394165</c:v>
                </c:pt>
                <c:pt idx="33">
                  <c:v>76.666666537523</c:v>
                </c:pt>
                <c:pt idx="34">
                  <c:v>76.86868673563004</c:v>
                </c:pt>
                <c:pt idx="35">
                  <c:v>77.0707069337363</c:v>
                </c:pt>
                <c:pt idx="36">
                  <c:v>77.27272713184327</c:v>
                </c:pt>
                <c:pt idx="37">
                  <c:v>77.47474732995028</c:v>
                </c:pt>
                <c:pt idx="38">
                  <c:v>77.67676752805667</c:v>
                </c:pt>
                <c:pt idx="39">
                  <c:v>77.87878772616322</c:v>
                </c:pt>
                <c:pt idx="40">
                  <c:v>78.08080792427063</c:v>
                </c:pt>
                <c:pt idx="41">
                  <c:v>78.2828281223774</c:v>
                </c:pt>
                <c:pt idx="42">
                  <c:v>78.48484832048369</c:v>
                </c:pt>
                <c:pt idx="43">
                  <c:v>78.68686851859039</c:v>
                </c:pt>
                <c:pt idx="44">
                  <c:v>78.88888871669705</c:v>
                </c:pt>
                <c:pt idx="45">
                  <c:v>79.09090891480425</c:v>
                </c:pt>
                <c:pt idx="46">
                  <c:v>79.29292911291121</c:v>
                </c:pt>
                <c:pt idx="47">
                  <c:v>79.494949311018</c:v>
                </c:pt>
                <c:pt idx="48">
                  <c:v>79.69696950912475</c:v>
                </c:pt>
                <c:pt idx="49">
                  <c:v>79.89898970723151</c:v>
                </c:pt>
                <c:pt idx="50">
                  <c:v>80.1010099053383</c:v>
                </c:pt>
                <c:pt idx="51">
                  <c:v>80.30303010344456</c:v>
                </c:pt>
                <c:pt idx="52">
                  <c:v>80.50505030155134</c:v>
                </c:pt>
                <c:pt idx="53">
                  <c:v>80.70707049965858</c:v>
                </c:pt>
                <c:pt idx="54">
                  <c:v>80.90909069776536</c:v>
                </c:pt>
                <c:pt idx="55">
                  <c:v>81.1111108958721</c:v>
                </c:pt>
                <c:pt idx="56">
                  <c:v>81.31313109397888</c:v>
                </c:pt>
                <c:pt idx="57">
                  <c:v>81.51515129208565</c:v>
                </c:pt>
                <c:pt idx="58">
                  <c:v>81.7171714901924</c:v>
                </c:pt>
                <c:pt idx="59">
                  <c:v>81.9191916882992</c:v>
                </c:pt>
                <c:pt idx="60">
                  <c:v>82.12121188640585</c:v>
                </c:pt>
                <c:pt idx="61">
                  <c:v>82.32323208451271</c:v>
                </c:pt>
                <c:pt idx="62">
                  <c:v>82.52525228261948</c:v>
                </c:pt>
                <c:pt idx="63">
                  <c:v>82.72727248072624</c:v>
                </c:pt>
                <c:pt idx="64">
                  <c:v>82.929292678833</c:v>
                </c:pt>
                <c:pt idx="65">
                  <c:v>83.1313128769393</c:v>
                </c:pt>
                <c:pt idx="66">
                  <c:v>83.33333307504654</c:v>
                </c:pt>
                <c:pt idx="67">
                  <c:v>83.53535327315331</c:v>
                </c:pt>
                <c:pt idx="68">
                  <c:v>83.7373734712601</c:v>
                </c:pt>
                <c:pt idx="69">
                  <c:v>83.9393936693669</c:v>
                </c:pt>
                <c:pt idx="70">
                  <c:v>84.1414138674736</c:v>
                </c:pt>
                <c:pt idx="71">
                  <c:v>84.34343406558037</c:v>
                </c:pt>
                <c:pt idx="72">
                  <c:v>84.54545426368713</c:v>
                </c:pt>
                <c:pt idx="73">
                  <c:v>84.7474744617939</c:v>
                </c:pt>
                <c:pt idx="74">
                  <c:v>84.9494946599007</c:v>
                </c:pt>
                <c:pt idx="75">
                  <c:v>85.15151485800743</c:v>
                </c:pt>
                <c:pt idx="76">
                  <c:v>85.35353505611393</c:v>
                </c:pt>
                <c:pt idx="77">
                  <c:v>85.55555525422095</c:v>
                </c:pt>
                <c:pt idx="78">
                  <c:v>85.75757545232773</c:v>
                </c:pt>
                <c:pt idx="79">
                  <c:v>85.95959565043448</c:v>
                </c:pt>
                <c:pt idx="80">
                  <c:v>86.16161584854125</c:v>
                </c:pt>
                <c:pt idx="81">
                  <c:v>86.36363604664803</c:v>
                </c:pt>
                <c:pt idx="82">
                  <c:v>86.56565624475478</c:v>
                </c:pt>
                <c:pt idx="83">
                  <c:v>86.76767644286155</c:v>
                </c:pt>
                <c:pt idx="84">
                  <c:v>86.9696966409683</c:v>
                </c:pt>
                <c:pt idx="85">
                  <c:v>87.17171683907505</c:v>
                </c:pt>
                <c:pt idx="86">
                  <c:v>87.37373703718104</c:v>
                </c:pt>
                <c:pt idx="87">
                  <c:v>87.57575723528815</c:v>
                </c:pt>
                <c:pt idx="88">
                  <c:v>87.77777743339512</c:v>
                </c:pt>
                <c:pt idx="89">
                  <c:v>87.97979763150215</c:v>
                </c:pt>
                <c:pt idx="90">
                  <c:v>88.18181782960885</c:v>
                </c:pt>
                <c:pt idx="91">
                  <c:v>88.38383802771541</c:v>
                </c:pt>
                <c:pt idx="92">
                  <c:v>88.58585822582245</c:v>
                </c:pt>
                <c:pt idx="93">
                  <c:v>88.78787842392894</c:v>
                </c:pt>
                <c:pt idx="94">
                  <c:v>88.98989862203598</c:v>
                </c:pt>
                <c:pt idx="95">
                  <c:v>89.19191882014274</c:v>
                </c:pt>
                <c:pt idx="96">
                  <c:v>89.39393901824951</c:v>
                </c:pt>
                <c:pt idx="97">
                  <c:v>89.59595921635628</c:v>
                </c:pt>
                <c:pt idx="98">
                  <c:v>89.79797941446304</c:v>
                </c:pt>
                <c:pt idx="99">
                  <c:v>89.99999961256981</c:v>
                </c:pt>
              </c:numCache>
            </c:numRef>
          </c:xVal>
          <c:yVal>
            <c:numRef>
              <c:f>MCAndF!$G$2:$G$101</c:f>
              <c:numCache>
                <c:formatCode>General</c:formatCode>
                <c:ptCount val="100"/>
                <c:pt idx="0">
                  <c:v>-455.890625</c:v>
                </c:pt>
                <c:pt idx="1">
                  <c:v>-510.669921875</c:v>
                </c:pt>
                <c:pt idx="2">
                  <c:v>-427.4257812499989</c:v>
                </c:pt>
                <c:pt idx="3">
                  <c:v>-158.1555938720703</c:v>
                </c:pt>
                <c:pt idx="4">
                  <c:v>-17.38834571838379</c:v>
                </c:pt>
                <c:pt idx="5">
                  <c:v>32.57096481323218</c:v>
                </c:pt>
                <c:pt idx="6">
                  <c:v>97.0489501953125</c:v>
                </c:pt>
                <c:pt idx="7">
                  <c:v>131.6206817626953</c:v>
                </c:pt>
                <c:pt idx="8">
                  <c:v>162.4635620117187</c:v>
                </c:pt>
                <c:pt idx="9">
                  <c:v>169.1171417236328</c:v>
                </c:pt>
                <c:pt idx="10">
                  <c:v>181.7498931884766</c:v>
                </c:pt>
                <c:pt idx="11">
                  <c:v>177.7777557373047</c:v>
                </c:pt>
                <c:pt idx="12">
                  <c:v>197.2772064208984</c:v>
                </c:pt>
                <c:pt idx="13">
                  <c:v>195.9260559082031</c:v>
                </c:pt>
                <c:pt idx="14">
                  <c:v>199.5965881347656</c:v>
                </c:pt>
                <c:pt idx="15">
                  <c:v>206.6635742187499</c:v>
                </c:pt>
                <c:pt idx="16">
                  <c:v>213.0116119384766</c:v>
                </c:pt>
                <c:pt idx="17">
                  <c:v>220.465545654297</c:v>
                </c:pt>
                <c:pt idx="18">
                  <c:v>231.268051147461</c:v>
                </c:pt>
                <c:pt idx="19">
                  <c:v>245.6896820068359</c:v>
                </c:pt>
                <c:pt idx="20">
                  <c:v>264.06005859375</c:v>
                </c:pt>
                <c:pt idx="21">
                  <c:v>280.5693359374989</c:v>
                </c:pt>
                <c:pt idx="22">
                  <c:v>297.0661926269531</c:v>
                </c:pt>
                <c:pt idx="23">
                  <c:v>311.9559020996094</c:v>
                </c:pt>
                <c:pt idx="24">
                  <c:v>322.4828796386719</c:v>
                </c:pt>
                <c:pt idx="25">
                  <c:v>332.4305725097656</c:v>
                </c:pt>
                <c:pt idx="26">
                  <c:v>345.4360961914062</c:v>
                </c:pt>
                <c:pt idx="27">
                  <c:v>366.8988647460936</c:v>
                </c:pt>
                <c:pt idx="28">
                  <c:v>385.7593383789062</c:v>
                </c:pt>
                <c:pt idx="29">
                  <c:v>401.94677734375</c:v>
                </c:pt>
                <c:pt idx="30">
                  <c:v>420.165771484375</c:v>
                </c:pt>
                <c:pt idx="31">
                  <c:v>437.2995300292969</c:v>
                </c:pt>
                <c:pt idx="32">
                  <c:v>455.2598266601563</c:v>
                </c:pt>
                <c:pt idx="33">
                  <c:v>468.7031249999989</c:v>
                </c:pt>
                <c:pt idx="34">
                  <c:v>485.4477233886719</c:v>
                </c:pt>
                <c:pt idx="35">
                  <c:v>505.4044189453122</c:v>
                </c:pt>
                <c:pt idx="36">
                  <c:v>532.990234375</c:v>
                </c:pt>
                <c:pt idx="37">
                  <c:v>556.4501953124975</c:v>
                </c:pt>
                <c:pt idx="38">
                  <c:v>578.1414184570312</c:v>
                </c:pt>
                <c:pt idx="39">
                  <c:v>597.366027832027</c:v>
                </c:pt>
                <c:pt idx="40">
                  <c:v>614.3458862304684</c:v>
                </c:pt>
                <c:pt idx="41">
                  <c:v>630.6082153320312</c:v>
                </c:pt>
                <c:pt idx="42">
                  <c:v>640.567932128904</c:v>
                </c:pt>
                <c:pt idx="43">
                  <c:v>659.4893798828124</c:v>
                </c:pt>
                <c:pt idx="44">
                  <c:v>699.7320556640624</c:v>
                </c:pt>
                <c:pt idx="45">
                  <c:v>737.1701049804684</c:v>
                </c:pt>
                <c:pt idx="46">
                  <c:v>776.3018188476562</c:v>
                </c:pt>
                <c:pt idx="47">
                  <c:v>817.27685546875</c:v>
                </c:pt>
                <c:pt idx="48">
                  <c:v>867.200134277344</c:v>
                </c:pt>
                <c:pt idx="49">
                  <c:v>927.778198242188</c:v>
                </c:pt>
                <c:pt idx="50">
                  <c:v>1016.565734863281</c:v>
                </c:pt>
                <c:pt idx="51">
                  <c:v>1129.291748046875</c:v>
                </c:pt>
                <c:pt idx="52">
                  <c:v>1269.713134765625</c:v>
                </c:pt>
                <c:pt idx="53">
                  <c:v>1405.085083007812</c:v>
                </c:pt>
                <c:pt idx="54">
                  <c:v>1532.498413085937</c:v>
                </c:pt>
                <c:pt idx="55">
                  <c:v>1647.105346679687</c:v>
                </c:pt>
                <c:pt idx="56">
                  <c:v>1740.943969726562</c:v>
                </c:pt>
                <c:pt idx="57">
                  <c:v>1803.027587890625</c:v>
                </c:pt>
                <c:pt idx="58">
                  <c:v>1825.13720703125</c:v>
                </c:pt>
                <c:pt idx="59">
                  <c:v>1814.212890625</c:v>
                </c:pt>
                <c:pt idx="60">
                  <c:v>1759.256225585937</c:v>
                </c:pt>
                <c:pt idx="61">
                  <c:v>1663.941162109375</c:v>
                </c:pt>
                <c:pt idx="62">
                  <c:v>1528.690185546875</c:v>
                </c:pt>
                <c:pt idx="63">
                  <c:v>1363.866577148437</c:v>
                </c:pt>
                <c:pt idx="64">
                  <c:v>1178.555541992187</c:v>
                </c:pt>
                <c:pt idx="65">
                  <c:v>976.179931640625</c:v>
                </c:pt>
                <c:pt idx="66">
                  <c:v>767.097534179688</c:v>
                </c:pt>
                <c:pt idx="67">
                  <c:v>590.5899047851562</c:v>
                </c:pt>
                <c:pt idx="68">
                  <c:v>440.6884765624989</c:v>
                </c:pt>
                <c:pt idx="69">
                  <c:v>320.4901428222656</c:v>
                </c:pt>
                <c:pt idx="70">
                  <c:v>228.4590148925781</c:v>
                </c:pt>
                <c:pt idx="71">
                  <c:v>159.8194427490234</c:v>
                </c:pt>
                <c:pt idx="72">
                  <c:v>107.1221237182617</c:v>
                </c:pt>
                <c:pt idx="73">
                  <c:v>65.041748046875</c:v>
                </c:pt>
                <c:pt idx="74">
                  <c:v>31.39510726928711</c:v>
                </c:pt>
                <c:pt idx="75">
                  <c:v>27.59346961975098</c:v>
                </c:pt>
                <c:pt idx="76">
                  <c:v>25.98490905761719</c:v>
                </c:pt>
                <c:pt idx="77">
                  <c:v>25.95112419128418</c:v>
                </c:pt>
                <c:pt idx="78">
                  <c:v>28.91766548156738</c:v>
                </c:pt>
                <c:pt idx="79">
                  <c:v>36.6595458984375</c:v>
                </c:pt>
                <c:pt idx="80">
                  <c:v>45.40616989135739</c:v>
                </c:pt>
                <c:pt idx="81">
                  <c:v>55.4217185974121</c:v>
                </c:pt>
                <c:pt idx="82">
                  <c:v>63.29191589355468</c:v>
                </c:pt>
                <c:pt idx="83">
                  <c:v>70.45209503173828</c:v>
                </c:pt>
                <c:pt idx="84">
                  <c:v>85.75311279296875</c:v>
                </c:pt>
                <c:pt idx="85">
                  <c:v>94.38063049316405</c:v>
                </c:pt>
                <c:pt idx="86">
                  <c:v>96.9870529174802</c:v>
                </c:pt>
                <c:pt idx="87">
                  <c:v>93.25493621826168</c:v>
                </c:pt>
                <c:pt idx="88">
                  <c:v>83.26850891113281</c:v>
                </c:pt>
                <c:pt idx="89">
                  <c:v>90.9019012451172</c:v>
                </c:pt>
                <c:pt idx="90">
                  <c:v>64.8195571899414</c:v>
                </c:pt>
                <c:pt idx="91">
                  <c:v>35.75433731079102</c:v>
                </c:pt>
                <c:pt idx="92">
                  <c:v>-10.3428783416748</c:v>
                </c:pt>
                <c:pt idx="93">
                  <c:v>-34.19455337524414</c:v>
                </c:pt>
                <c:pt idx="94">
                  <c:v>-113.5859298706055</c:v>
                </c:pt>
                <c:pt idx="95">
                  <c:v>-123.2692489624023</c:v>
                </c:pt>
                <c:pt idx="96">
                  <c:v>-26.4766902923584</c:v>
                </c:pt>
                <c:pt idx="97">
                  <c:v>63.615234375</c:v>
                </c:pt>
                <c:pt idx="98">
                  <c:v>96.0849609375</c:v>
                </c:pt>
                <c:pt idx="99">
                  <c:v>132.19921875</c:v>
                </c:pt>
              </c:numCache>
            </c:numRef>
          </c:yVal>
          <c:smooth val="0"/>
        </c:ser>
        <c:ser>
          <c:idx val="7"/>
          <c:order val="3"/>
          <c:tx>
            <c:v>2 P/uL</c:v>
          </c:tx>
          <c:spPr>
            <a:ln w="19050">
              <a:solidFill>
                <a:srgbClr val="41C505"/>
              </a:solidFill>
              <a:prstDash val="solid"/>
            </a:ln>
          </c:spPr>
          <c:marker>
            <c:symbol val="none"/>
          </c:marker>
          <c:xVal>
            <c:numRef>
              <c:f>MCAndF!$A$2:$A$101</c:f>
              <c:numCache>
                <c:formatCode>General</c:formatCode>
                <c:ptCount val="100"/>
                <c:pt idx="0">
                  <c:v>70.0</c:v>
                </c:pt>
                <c:pt idx="1">
                  <c:v>70.20202019810677</c:v>
                </c:pt>
                <c:pt idx="2">
                  <c:v>70.40404039621353</c:v>
                </c:pt>
                <c:pt idx="3">
                  <c:v>70.6060605943203</c:v>
                </c:pt>
                <c:pt idx="4">
                  <c:v>70.80808079242645</c:v>
                </c:pt>
                <c:pt idx="5">
                  <c:v>71.01010099053383</c:v>
                </c:pt>
                <c:pt idx="6">
                  <c:v>71.2121211886406</c:v>
                </c:pt>
                <c:pt idx="7">
                  <c:v>71.4141413867474</c:v>
                </c:pt>
                <c:pt idx="8">
                  <c:v>71.61616158485413</c:v>
                </c:pt>
                <c:pt idx="9">
                  <c:v>71.81818178296088</c:v>
                </c:pt>
                <c:pt idx="10">
                  <c:v>72.0202019810677</c:v>
                </c:pt>
                <c:pt idx="11">
                  <c:v>72.22222217917441</c:v>
                </c:pt>
                <c:pt idx="12">
                  <c:v>72.42424237728115</c:v>
                </c:pt>
                <c:pt idx="13">
                  <c:v>72.62626257538795</c:v>
                </c:pt>
                <c:pt idx="14">
                  <c:v>72.82828277349408</c:v>
                </c:pt>
                <c:pt idx="15">
                  <c:v>73.03030297160122</c:v>
                </c:pt>
                <c:pt idx="16">
                  <c:v>73.23232316970826</c:v>
                </c:pt>
                <c:pt idx="17">
                  <c:v>73.434343367815</c:v>
                </c:pt>
                <c:pt idx="18">
                  <c:v>73.63636356592178</c:v>
                </c:pt>
                <c:pt idx="19">
                  <c:v>73.83838376402855</c:v>
                </c:pt>
                <c:pt idx="20">
                  <c:v>74.0404039621353</c:v>
                </c:pt>
                <c:pt idx="21">
                  <c:v>74.2424241602421</c:v>
                </c:pt>
                <c:pt idx="22">
                  <c:v>74.4444443583489</c:v>
                </c:pt>
                <c:pt idx="23">
                  <c:v>74.64646455645534</c:v>
                </c:pt>
                <c:pt idx="24">
                  <c:v>74.84848475456238</c:v>
                </c:pt>
                <c:pt idx="25">
                  <c:v>75.05050495266887</c:v>
                </c:pt>
                <c:pt idx="26">
                  <c:v>75.25252515077591</c:v>
                </c:pt>
                <c:pt idx="27">
                  <c:v>75.45454534888267</c:v>
                </c:pt>
                <c:pt idx="28">
                  <c:v>75.65656554698917</c:v>
                </c:pt>
                <c:pt idx="29">
                  <c:v>75.85858574509621</c:v>
                </c:pt>
                <c:pt idx="30">
                  <c:v>76.060605943203</c:v>
                </c:pt>
                <c:pt idx="31">
                  <c:v>76.26262614130973</c:v>
                </c:pt>
                <c:pt idx="32">
                  <c:v>76.4646463394165</c:v>
                </c:pt>
                <c:pt idx="33">
                  <c:v>76.666666537523</c:v>
                </c:pt>
                <c:pt idx="34">
                  <c:v>76.86868673563004</c:v>
                </c:pt>
                <c:pt idx="35">
                  <c:v>77.0707069337363</c:v>
                </c:pt>
                <c:pt idx="36">
                  <c:v>77.27272713184327</c:v>
                </c:pt>
                <c:pt idx="37">
                  <c:v>77.47474732995028</c:v>
                </c:pt>
                <c:pt idx="38">
                  <c:v>77.67676752805667</c:v>
                </c:pt>
                <c:pt idx="39">
                  <c:v>77.87878772616322</c:v>
                </c:pt>
                <c:pt idx="40">
                  <c:v>78.08080792427063</c:v>
                </c:pt>
                <c:pt idx="41">
                  <c:v>78.2828281223774</c:v>
                </c:pt>
                <c:pt idx="42">
                  <c:v>78.48484832048369</c:v>
                </c:pt>
                <c:pt idx="43">
                  <c:v>78.68686851859039</c:v>
                </c:pt>
                <c:pt idx="44">
                  <c:v>78.88888871669705</c:v>
                </c:pt>
                <c:pt idx="45">
                  <c:v>79.09090891480425</c:v>
                </c:pt>
                <c:pt idx="46">
                  <c:v>79.29292911291121</c:v>
                </c:pt>
                <c:pt idx="47">
                  <c:v>79.494949311018</c:v>
                </c:pt>
                <c:pt idx="48">
                  <c:v>79.69696950912475</c:v>
                </c:pt>
                <c:pt idx="49">
                  <c:v>79.89898970723151</c:v>
                </c:pt>
                <c:pt idx="50">
                  <c:v>80.1010099053383</c:v>
                </c:pt>
                <c:pt idx="51">
                  <c:v>80.30303010344456</c:v>
                </c:pt>
                <c:pt idx="52">
                  <c:v>80.50505030155134</c:v>
                </c:pt>
                <c:pt idx="53">
                  <c:v>80.70707049965858</c:v>
                </c:pt>
                <c:pt idx="54">
                  <c:v>80.90909069776536</c:v>
                </c:pt>
                <c:pt idx="55">
                  <c:v>81.1111108958721</c:v>
                </c:pt>
                <c:pt idx="56">
                  <c:v>81.31313109397888</c:v>
                </c:pt>
                <c:pt idx="57">
                  <c:v>81.51515129208565</c:v>
                </c:pt>
                <c:pt idx="58">
                  <c:v>81.7171714901924</c:v>
                </c:pt>
                <c:pt idx="59">
                  <c:v>81.9191916882992</c:v>
                </c:pt>
                <c:pt idx="60">
                  <c:v>82.12121188640585</c:v>
                </c:pt>
                <c:pt idx="61">
                  <c:v>82.32323208451271</c:v>
                </c:pt>
                <c:pt idx="62">
                  <c:v>82.52525228261948</c:v>
                </c:pt>
                <c:pt idx="63">
                  <c:v>82.72727248072624</c:v>
                </c:pt>
                <c:pt idx="64">
                  <c:v>82.929292678833</c:v>
                </c:pt>
                <c:pt idx="65">
                  <c:v>83.1313128769393</c:v>
                </c:pt>
                <c:pt idx="66">
                  <c:v>83.33333307504654</c:v>
                </c:pt>
                <c:pt idx="67">
                  <c:v>83.53535327315331</c:v>
                </c:pt>
                <c:pt idx="68">
                  <c:v>83.7373734712601</c:v>
                </c:pt>
                <c:pt idx="69">
                  <c:v>83.9393936693669</c:v>
                </c:pt>
                <c:pt idx="70">
                  <c:v>84.1414138674736</c:v>
                </c:pt>
                <c:pt idx="71">
                  <c:v>84.34343406558037</c:v>
                </c:pt>
                <c:pt idx="72">
                  <c:v>84.54545426368713</c:v>
                </c:pt>
                <c:pt idx="73">
                  <c:v>84.7474744617939</c:v>
                </c:pt>
                <c:pt idx="74">
                  <c:v>84.9494946599007</c:v>
                </c:pt>
                <c:pt idx="75">
                  <c:v>85.15151485800743</c:v>
                </c:pt>
                <c:pt idx="76">
                  <c:v>85.35353505611393</c:v>
                </c:pt>
                <c:pt idx="77">
                  <c:v>85.55555525422095</c:v>
                </c:pt>
                <c:pt idx="78">
                  <c:v>85.75757545232773</c:v>
                </c:pt>
                <c:pt idx="79">
                  <c:v>85.95959565043448</c:v>
                </c:pt>
                <c:pt idx="80">
                  <c:v>86.16161584854125</c:v>
                </c:pt>
                <c:pt idx="81">
                  <c:v>86.36363604664803</c:v>
                </c:pt>
                <c:pt idx="82">
                  <c:v>86.56565624475478</c:v>
                </c:pt>
                <c:pt idx="83">
                  <c:v>86.76767644286155</c:v>
                </c:pt>
                <c:pt idx="84">
                  <c:v>86.9696966409683</c:v>
                </c:pt>
                <c:pt idx="85">
                  <c:v>87.17171683907505</c:v>
                </c:pt>
                <c:pt idx="86">
                  <c:v>87.37373703718104</c:v>
                </c:pt>
                <c:pt idx="87">
                  <c:v>87.57575723528815</c:v>
                </c:pt>
                <c:pt idx="88">
                  <c:v>87.77777743339512</c:v>
                </c:pt>
                <c:pt idx="89">
                  <c:v>87.97979763150215</c:v>
                </c:pt>
                <c:pt idx="90">
                  <c:v>88.18181782960885</c:v>
                </c:pt>
                <c:pt idx="91">
                  <c:v>88.38383802771541</c:v>
                </c:pt>
                <c:pt idx="92">
                  <c:v>88.58585822582245</c:v>
                </c:pt>
                <c:pt idx="93">
                  <c:v>88.78787842392894</c:v>
                </c:pt>
                <c:pt idx="94">
                  <c:v>88.98989862203598</c:v>
                </c:pt>
                <c:pt idx="95">
                  <c:v>89.19191882014274</c:v>
                </c:pt>
                <c:pt idx="96">
                  <c:v>89.39393901824951</c:v>
                </c:pt>
                <c:pt idx="97">
                  <c:v>89.59595921635628</c:v>
                </c:pt>
                <c:pt idx="98">
                  <c:v>89.79797941446304</c:v>
                </c:pt>
                <c:pt idx="99">
                  <c:v>89.99999961256981</c:v>
                </c:pt>
              </c:numCache>
            </c:numRef>
          </c:xVal>
          <c:yVal>
            <c:numRef>
              <c:f>MCAndF!$I$2:$I$101</c:f>
              <c:numCache>
                <c:formatCode>General</c:formatCode>
                <c:ptCount val="100"/>
                <c:pt idx="0">
                  <c:v>-473.546875</c:v>
                </c:pt>
                <c:pt idx="1">
                  <c:v>-494.0390625</c:v>
                </c:pt>
                <c:pt idx="2">
                  <c:v>-394.240234375</c:v>
                </c:pt>
                <c:pt idx="3">
                  <c:v>-153.8857421875</c:v>
                </c:pt>
                <c:pt idx="4">
                  <c:v>-16.58040428161621</c:v>
                </c:pt>
                <c:pt idx="5">
                  <c:v>33.75241851806641</c:v>
                </c:pt>
                <c:pt idx="6">
                  <c:v>105.0542678833008</c:v>
                </c:pt>
                <c:pt idx="7">
                  <c:v>137.1935882568359</c:v>
                </c:pt>
                <c:pt idx="8">
                  <c:v>170.0108642578125</c:v>
                </c:pt>
                <c:pt idx="9">
                  <c:v>175.3985137939453</c:v>
                </c:pt>
                <c:pt idx="10">
                  <c:v>192.056640625</c:v>
                </c:pt>
                <c:pt idx="11">
                  <c:v>191.1201324462891</c:v>
                </c:pt>
                <c:pt idx="12">
                  <c:v>215.3829650878906</c:v>
                </c:pt>
                <c:pt idx="13">
                  <c:v>218.378631591797</c:v>
                </c:pt>
                <c:pt idx="14">
                  <c:v>224.3310089111328</c:v>
                </c:pt>
                <c:pt idx="15">
                  <c:v>233.3892517089844</c:v>
                </c:pt>
                <c:pt idx="16">
                  <c:v>242.3189849853516</c:v>
                </c:pt>
                <c:pt idx="17">
                  <c:v>253.7471923828125</c:v>
                </c:pt>
                <c:pt idx="18">
                  <c:v>271.9264831542969</c:v>
                </c:pt>
                <c:pt idx="19">
                  <c:v>292.2820739746089</c:v>
                </c:pt>
                <c:pt idx="20">
                  <c:v>322.7108459472656</c:v>
                </c:pt>
                <c:pt idx="21">
                  <c:v>350.609588623047</c:v>
                </c:pt>
                <c:pt idx="22">
                  <c:v>380.0719604492186</c:v>
                </c:pt>
                <c:pt idx="23">
                  <c:v>406.2056274414062</c:v>
                </c:pt>
                <c:pt idx="24">
                  <c:v>432.7007446289062</c:v>
                </c:pt>
                <c:pt idx="25">
                  <c:v>456.5892333984375</c:v>
                </c:pt>
                <c:pt idx="26">
                  <c:v>484.5333862304687</c:v>
                </c:pt>
                <c:pt idx="27">
                  <c:v>519.6686401367184</c:v>
                </c:pt>
                <c:pt idx="28">
                  <c:v>553.7471313476565</c:v>
                </c:pt>
                <c:pt idx="29">
                  <c:v>583.4528198242147</c:v>
                </c:pt>
                <c:pt idx="30">
                  <c:v>614.6276245117174</c:v>
                </c:pt>
                <c:pt idx="31">
                  <c:v>645.20703125</c:v>
                </c:pt>
                <c:pt idx="32">
                  <c:v>669.952392578125</c:v>
                </c:pt>
                <c:pt idx="33">
                  <c:v>687.644287109375</c:v>
                </c:pt>
                <c:pt idx="34">
                  <c:v>706.3596191406225</c:v>
                </c:pt>
                <c:pt idx="35">
                  <c:v>725.4994506835934</c:v>
                </c:pt>
                <c:pt idx="36">
                  <c:v>747.2708129882815</c:v>
                </c:pt>
                <c:pt idx="37">
                  <c:v>760.8146362304684</c:v>
                </c:pt>
                <c:pt idx="38">
                  <c:v>765.9632568359334</c:v>
                </c:pt>
                <c:pt idx="39">
                  <c:v>760.0647583007812</c:v>
                </c:pt>
                <c:pt idx="40">
                  <c:v>743.20263671875</c:v>
                </c:pt>
                <c:pt idx="41">
                  <c:v>715.704772949219</c:v>
                </c:pt>
                <c:pt idx="42">
                  <c:v>676.1336059570315</c:v>
                </c:pt>
                <c:pt idx="43">
                  <c:v>642.7736206054684</c:v>
                </c:pt>
                <c:pt idx="44">
                  <c:v>618.2417602539062</c:v>
                </c:pt>
                <c:pt idx="45">
                  <c:v>592.5597534179684</c:v>
                </c:pt>
                <c:pt idx="46">
                  <c:v>567.3671264648397</c:v>
                </c:pt>
                <c:pt idx="47">
                  <c:v>551.0243530273437</c:v>
                </c:pt>
                <c:pt idx="48">
                  <c:v>545.4407348632812</c:v>
                </c:pt>
                <c:pt idx="49">
                  <c:v>548.59423828125</c:v>
                </c:pt>
                <c:pt idx="50">
                  <c:v>574.0081176757812</c:v>
                </c:pt>
                <c:pt idx="51">
                  <c:v>621.1201171874975</c:v>
                </c:pt>
                <c:pt idx="52">
                  <c:v>690.118408203125</c:v>
                </c:pt>
                <c:pt idx="53">
                  <c:v>762.842102050779</c:v>
                </c:pt>
                <c:pt idx="54">
                  <c:v>835.5911865234374</c:v>
                </c:pt>
                <c:pt idx="55">
                  <c:v>904.0593872070315</c:v>
                </c:pt>
                <c:pt idx="56">
                  <c:v>958.88427734375</c:v>
                </c:pt>
                <c:pt idx="57">
                  <c:v>993.326721191402</c:v>
                </c:pt>
                <c:pt idx="58">
                  <c:v>1003.000244140625</c:v>
                </c:pt>
                <c:pt idx="59">
                  <c:v>997.1627807617184</c:v>
                </c:pt>
                <c:pt idx="60">
                  <c:v>968.8771362304684</c:v>
                </c:pt>
                <c:pt idx="61">
                  <c:v>921.7882690429684</c:v>
                </c:pt>
                <c:pt idx="62">
                  <c:v>855.4201660156225</c:v>
                </c:pt>
                <c:pt idx="63">
                  <c:v>776.0941162109374</c:v>
                </c:pt>
                <c:pt idx="64">
                  <c:v>687.2510375976565</c:v>
                </c:pt>
                <c:pt idx="65">
                  <c:v>591.9287109375</c:v>
                </c:pt>
                <c:pt idx="66">
                  <c:v>494.3319702148437</c:v>
                </c:pt>
                <c:pt idx="67">
                  <c:v>413.3911132812479</c:v>
                </c:pt>
                <c:pt idx="68">
                  <c:v>344.7234802246094</c:v>
                </c:pt>
                <c:pt idx="69">
                  <c:v>286.3594970703125</c:v>
                </c:pt>
                <c:pt idx="70">
                  <c:v>239.2460784912109</c:v>
                </c:pt>
                <c:pt idx="71">
                  <c:v>201.5064544677734</c:v>
                </c:pt>
                <c:pt idx="72">
                  <c:v>168.471160888672</c:v>
                </c:pt>
                <c:pt idx="73">
                  <c:v>134.4814758300781</c:v>
                </c:pt>
                <c:pt idx="74">
                  <c:v>101.4680862426758</c:v>
                </c:pt>
                <c:pt idx="75">
                  <c:v>86.18442535400391</c:v>
                </c:pt>
                <c:pt idx="76">
                  <c:v>72.32952880859335</c:v>
                </c:pt>
                <c:pt idx="77">
                  <c:v>57.40753555297852</c:v>
                </c:pt>
                <c:pt idx="78">
                  <c:v>43.79969024658203</c:v>
                </c:pt>
                <c:pt idx="79">
                  <c:v>32.21328353881835</c:v>
                </c:pt>
                <c:pt idx="80">
                  <c:v>24.43751525878906</c:v>
                </c:pt>
                <c:pt idx="81">
                  <c:v>17.09414291381836</c:v>
                </c:pt>
                <c:pt idx="82">
                  <c:v>11.34311962127686</c:v>
                </c:pt>
                <c:pt idx="83">
                  <c:v>6.731893539428711</c:v>
                </c:pt>
                <c:pt idx="84">
                  <c:v>5.893842220306396</c:v>
                </c:pt>
                <c:pt idx="85">
                  <c:v>7.643793106079101</c:v>
                </c:pt>
                <c:pt idx="86">
                  <c:v>9.25309753417969</c:v>
                </c:pt>
                <c:pt idx="87">
                  <c:v>11.65523910522461</c:v>
                </c:pt>
                <c:pt idx="88">
                  <c:v>11.8700532913208</c:v>
                </c:pt>
                <c:pt idx="89">
                  <c:v>19.87021064758301</c:v>
                </c:pt>
                <c:pt idx="90">
                  <c:v>24.08491134643555</c:v>
                </c:pt>
                <c:pt idx="91">
                  <c:v>52.26646423339844</c:v>
                </c:pt>
                <c:pt idx="92">
                  <c:v>47.2296752929688</c:v>
                </c:pt>
                <c:pt idx="93">
                  <c:v>41.10506057739228</c:v>
                </c:pt>
                <c:pt idx="94">
                  <c:v>45.80959320068359</c:v>
                </c:pt>
                <c:pt idx="95">
                  <c:v>34.32390594482421</c:v>
                </c:pt>
                <c:pt idx="96">
                  <c:v>28.93765449523926</c:v>
                </c:pt>
                <c:pt idx="97">
                  <c:v>64.97509765624973</c:v>
                </c:pt>
                <c:pt idx="98">
                  <c:v>131.7597656249999</c:v>
                </c:pt>
                <c:pt idx="99">
                  <c:v>196.83984375</c:v>
                </c:pt>
              </c:numCache>
            </c:numRef>
          </c:yVal>
          <c:smooth val="0"/>
        </c:ser>
        <c:ser>
          <c:idx val="9"/>
          <c:order val="4"/>
          <c:tx>
            <c:v>0.2 P/uL</c:v>
          </c:tx>
          <c:spPr>
            <a:ln w="19050">
              <a:solidFill>
                <a:srgbClr val="4F11A7"/>
              </a:solidFill>
              <a:prstDash val="solid"/>
            </a:ln>
          </c:spPr>
          <c:marker>
            <c:symbol val="none"/>
          </c:marker>
          <c:xVal>
            <c:numRef>
              <c:f>MCAndF!$A$2:$A$101</c:f>
              <c:numCache>
                <c:formatCode>General</c:formatCode>
                <c:ptCount val="100"/>
                <c:pt idx="0">
                  <c:v>70.0</c:v>
                </c:pt>
                <c:pt idx="1">
                  <c:v>70.20202019810677</c:v>
                </c:pt>
                <c:pt idx="2">
                  <c:v>70.40404039621353</c:v>
                </c:pt>
                <c:pt idx="3">
                  <c:v>70.6060605943203</c:v>
                </c:pt>
                <c:pt idx="4">
                  <c:v>70.80808079242645</c:v>
                </c:pt>
                <c:pt idx="5">
                  <c:v>71.01010099053383</c:v>
                </c:pt>
                <c:pt idx="6">
                  <c:v>71.2121211886406</c:v>
                </c:pt>
                <c:pt idx="7">
                  <c:v>71.4141413867474</c:v>
                </c:pt>
                <c:pt idx="8">
                  <c:v>71.61616158485413</c:v>
                </c:pt>
                <c:pt idx="9">
                  <c:v>71.81818178296088</c:v>
                </c:pt>
                <c:pt idx="10">
                  <c:v>72.0202019810677</c:v>
                </c:pt>
                <c:pt idx="11">
                  <c:v>72.22222217917441</c:v>
                </c:pt>
                <c:pt idx="12">
                  <c:v>72.42424237728115</c:v>
                </c:pt>
                <c:pt idx="13">
                  <c:v>72.62626257538795</c:v>
                </c:pt>
                <c:pt idx="14">
                  <c:v>72.82828277349408</c:v>
                </c:pt>
                <c:pt idx="15">
                  <c:v>73.03030297160122</c:v>
                </c:pt>
                <c:pt idx="16">
                  <c:v>73.23232316970826</c:v>
                </c:pt>
                <c:pt idx="17">
                  <c:v>73.434343367815</c:v>
                </c:pt>
                <c:pt idx="18">
                  <c:v>73.63636356592178</c:v>
                </c:pt>
                <c:pt idx="19">
                  <c:v>73.83838376402855</c:v>
                </c:pt>
                <c:pt idx="20">
                  <c:v>74.0404039621353</c:v>
                </c:pt>
                <c:pt idx="21">
                  <c:v>74.2424241602421</c:v>
                </c:pt>
                <c:pt idx="22">
                  <c:v>74.4444443583489</c:v>
                </c:pt>
                <c:pt idx="23">
                  <c:v>74.64646455645534</c:v>
                </c:pt>
                <c:pt idx="24">
                  <c:v>74.84848475456238</c:v>
                </c:pt>
                <c:pt idx="25">
                  <c:v>75.05050495266887</c:v>
                </c:pt>
                <c:pt idx="26">
                  <c:v>75.25252515077591</c:v>
                </c:pt>
                <c:pt idx="27">
                  <c:v>75.45454534888267</c:v>
                </c:pt>
                <c:pt idx="28">
                  <c:v>75.65656554698917</c:v>
                </c:pt>
                <c:pt idx="29">
                  <c:v>75.85858574509621</c:v>
                </c:pt>
                <c:pt idx="30">
                  <c:v>76.060605943203</c:v>
                </c:pt>
                <c:pt idx="31">
                  <c:v>76.26262614130973</c:v>
                </c:pt>
                <c:pt idx="32">
                  <c:v>76.4646463394165</c:v>
                </c:pt>
                <c:pt idx="33">
                  <c:v>76.666666537523</c:v>
                </c:pt>
                <c:pt idx="34">
                  <c:v>76.86868673563004</c:v>
                </c:pt>
                <c:pt idx="35">
                  <c:v>77.0707069337363</c:v>
                </c:pt>
                <c:pt idx="36">
                  <c:v>77.27272713184327</c:v>
                </c:pt>
                <c:pt idx="37">
                  <c:v>77.47474732995028</c:v>
                </c:pt>
                <c:pt idx="38">
                  <c:v>77.67676752805667</c:v>
                </c:pt>
                <c:pt idx="39">
                  <c:v>77.87878772616322</c:v>
                </c:pt>
                <c:pt idx="40">
                  <c:v>78.08080792427063</c:v>
                </c:pt>
                <c:pt idx="41">
                  <c:v>78.2828281223774</c:v>
                </c:pt>
                <c:pt idx="42">
                  <c:v>78.48484832048369</c:v>
                </c:pt>
                <c:pt idx="43">
                  <c:v>78.68686851859039</c:v>
                </c:pt>
                <c:pt idx="44">
                  <c:v>78.88888871669705</c:v>
                </c:pt>
                <c:pt idx="45">
                  <c:v>79.09090891480425</c:v>
                </c:pt>
                <c:pt idx="46">
                  <c:v>79.29292911291121</c:v>
                </c:pt>
                <c:pt idx="47">
                  <c:v>79.494949311018</c:v>
                </c:pt>
                <c:pt idx="48">
                  <c:v>79.69696950912475</c:v>
                </c:pt>
                <c:pt idx="49">
                  <c:v>79.89898970723151</c:v>
                </c:pt>
                <c:pt idx="50">
                  <c:v>80.1010099053383</c:v>
                </c:pt>
                <c:pt idx="51">
                  <c:v>80.30303010344456</c:v>
                </c:pt>
                <c:pt idx="52">
                  <c:v>80.50505030155134</c:v>
                </c:pt>
                <c:pt idx="53">
                  <c:v>80.70707049965858</c:v>
                </c:pt>
                <c:pt idx="54">
                  <c:v>80.90909069776536</c:v>
                </c:pt>
                <c:pt idx="55">
                  <c:v>81.1111108958721</c:v>
                </c:pt>
                <c:pt idx="56">
                  <c:v>81.31313109397888</c:v>
                </c:pt>
                <c:pt idx="57">
                  <c:v>81.51515129208565</c:v>
                </c:pt>
                <c:pt idx="58">
                  <c:v>81.7171714901924</c:v>
                </c:pt>
                <c:pt idx="59">
                  <c:v>81.9191916882992</c:v>
                </c:pt>
                <c:pt idx="60">
                  <c:v>82.12121188640585</c:v>
                </c:pt>
                <c:pt idx="61">
                  <c:v>82.32323208451271</c:v>
                </c:pt>
                <c:pt idx="62">
                  <c:v>82.52525228261948</c:v>
                </c:pt>
                <c:pt idx="63">
                  <c:v>82.72727248072624</c:v>
                </c:pt>
                <c:pt idx="64">
                  <c:v>82.929292678833</c:v>
                </c:pt>
                <c:pt idx="65">
                  <c:v>83.1313128769393</c:v>
                </c:pt>
                <c:pt idx="66">
                  <c:v>83.33333307504654</c:v>
                </c:pt>
                <c:pt idx="67">
                  <c:v>83.53535327315331</c:v>
                </c:pt>
                <c:pt idx="68">
                  <c:v>83.7373734712601</c:v>
                </c:pt>
                <c:pt idx="69">
                  <c:v>83.9393936693669</c:v>
                </c:pt>
                <c:pt idx="70">
                  <c:v>84.1414138674736</c:v>
                </c:pt>
                <c:pt idx="71">
                  <c:v>84.34343406558037</c:v>
                </c:pt>
                <c:pt idx="72">
                  <c:v>84.54545426368713</c:v>
                </c:pt>
                <c:pt idx="73">
                  <c:v>84.7474744617939</c:v>
                </c:pt>
                <c:pt idx="74">
                  <c:v>84.9494946599007</c:v>
                </c:pt>
                <c:pt idx="75">
                  <c:v>85.15151485800743</c:v>
                </c:pt>
                <c:pt idx="76">
                  <c:v>85.35353505611393</c:v>
                </c:pt>
                <c:pt idx="77">
                  <c:v>85.55555525422095</c:v>
                </c:pt>
                <c:pt idx="78">
                  <c:v>85.75757545232773</c:v>
                </c:pt>
                <c:pt idx="79">
                  <c:v>85.95959565043448</c:v>
                </c:pt>
                <c:pt idx="80">
                  <c:v>86.16161584854125</c:v>
                </c:pt>
                <c:pt idx="81">
                  <c:v>86.36363604664803</c:v>
                </c:pt>
                <c:pt idx="82">
                  <c:v>86.56565624475478</c:v>
                </c:pt>
                <c:pt idx="83">
                  <c:v>86.76767644286155</c:v>
                </c:pt>
                <c:pt idx="84">
                  <c:v>86.9696966409683</c:v>
                </c:pt>
                <c:pt idx="85">
                  <c:v>87.17171683907505</c:v>
                </c:pt>
                <c:pt idx="86">
                  <c:v>87.37373703718104</c:v>
                </c:pt>
                <c:pt idx="87">
                  <c:v>87.57575723528815</c:v>
                </c:pt>
                <c:pt idx="88">
                  <c:v>87.77777743339512</c:v>
                </c:pt>
                <c:pt idx="89">
                  <c:v>87.97979763150215</c:v>
                </c:pt>
                <c:pt idx="90">
                  <c:v>88.18181782960885</c:v>
                </c:pt>
                <c:pt idx="91">
                  <c:v>88.38383802771541</c:v>
                </c:pt>
                <c:pt idx="92">
                  <c:v>88.58585822582245</c:v>
                </c:pt>
                <c:pt idx="93">
                  <c:v>88.78787842392894</c:v>
                </c:pt>
                <c:pt idx="94">
                  <c:v>88.98989862203598</c:v>
                </c:pt>
                <c:pt idx="95">
                  <c:v>89.19191882014274</c:v>
                </c:pt>
                <c:pt idx="96">
                  <c:v>89.39393901824951</c:v>
                </c:pt>
                <c:pt idx="97">
                  <c:v>89.59595921635628</c:v>
                </c:pt>
                <c:pt idx="98">
                  <c:v>89.79797941446304</c:v>
                </c:pt>
                <c:pt idx="99">
                  <c:v>89.99999961256981</c:v>
                </c:pt>
              </c:numCache>
            </c:numRef>
          </c:xVal>
          <c:yVal>
            <c:numRef>
              <c:f>MCAndF!$K$2:$K$101</c:f>
              <c:numCache>
                <c:formatCode>General</c:formatCode>
                <c:ptCount val="100"/>
                <c:pt idx="0">
                  <c:v>-739.45703125</c:v>
                </c:pt>
                <c:pt idx="1">
                  <c:v>-826.3046875</c:v>
                </c:pt>
                <c:pt idx="2">
                  <c:v>-660.9609375</c:v>
                </c:pt>
                <c:pt idx="3">
                  <c:v>-163.3444061279297</c:v>
                </c:pt>
                <c:pt idx="4">
                  <c:v>32.953125</c:v>
                </c:pt>
                <c:pt idx="5">
                  <c:v>85.79971313476561</c:v>
                </c:pt>
                <c:pt idx="6">
                  <c:v>165.6767272949219</c:v>
                </c:pt>
                <c:pt idx="7">
                  <c:v>222.4348907470703</c:v>
                </c:pt>
                <c:pt idx="8">
                  <c:v>278.2825927734375</c:v>
                </c:pt>
                <c:pt idx="9">
                  <c:v>291.1570129394531</c:v>
                </c:pt>
                <c:pt idx="10">
                  <c:v>335.5057678222656</c:v>
                </c:pt>
                <c:pt idx="11">
                  <c:v>337.595703125</c:v>
                </c:pt>
                <c:pt idx="12">
                  <c:v>381.5330200195312</c:v>
                </c:pt>
                <c:pt idx="13">
                  <c:v>385.7255554199219</c:v>
                </c:pt>
                <c:pt idx="14">
                  <c:v>393.4696044921872</c:v>
                </c:pt>
                <c:pt idx="15">
                  <c:v>406.5617675781239</c:v>
                </c:pt>
                <c:pt idx="16">
                  <c:v>419.2066345214839</c:v>
                </c:pt>
                <c:pt idx="17">
                  <c:v>434.6285705566406</c:v>
                </c:pt>
                <c:pt idx="18">
                  <c:v>456.1314392089824</c:v>
                </c:pt>
                <c:pt idx="19">
                  <c:v>486.0551452636719</c:v>
                </c:pt>
                <c:pt idx="20">
                  <c:v>523.751831054688</c:v>
                </c:pt>
                <c:pt idx="21">
                  <c:v>557.3460693359334</c:v>
                </c:pt>
                <c:pt idx="22">
                  <c:v>587.338500976563</c:v>
                </c:pt>
                <c:pt idx="23">
                  <c:v>614.9151611328124</c:v>
                </c:pt>
                <c:pt idx="24">
                  <c:v>636.7965698242174</c:v>
                </c:pt>
                <c:pt idx="25">
                  <c:v>659.1636352539062</c:v>
                </c:pt>
                <c:pt idx="26">
                  <c:v>687.279418945313</c:v>
                </c:pt>
                <c:pt idx="27">
                  <c:v>723.9786376953124</c:v>
                </c:pt>
                <c:pt idx="28">
                  <c:v>753.683471679688</c:v>
                </c:pt>
                <c:pt idx="29">
                  <c:v>778.9649658203124</c:v>
                </c:pt>
                <c:pt idx="30">
                  <c:v>802.834716796875</c:v>
                </c:pt>
                <c:pt idx="31">
                  <c:v>822.202392578125</c:v>
                </c:pt>
                <c:pt idx="32">
                  <c:v>833.1364135742184</c:v>
                </c:pt>
                <c:pt idx="33">
                  <c:v>837.5816650390624</c:v>
                </c:pt>
                <c:pt idx="34">
                  <c:v>848.9860229492184</c:v>
                </c:pt>
                <c:pt idx="35">
                  <c:v>862.1802978515624</c:v>
                </c:pt>
                <c:pt idx="36">
                  <c:v>888.9639282226562</c:v>
                </c:pt>
                <c:pt idx="37">
                  <c:v>909.3929443359374</c:v>
                </c:pt>
                <c:pt idx="38">
                  <c:v>921.5772094726562</c:v>
                </c:pt>
                <c:pt idx="39">
                  <c:v>923.9627075195312</c:v>
                </c:pt>
                <c:pt idx="40">
                  <c:v>915.711669921875</c:v>
                </c:pt>
                <c:pt idx="41">
                  <c:v>890.5209960937475</c:v>
                </c:pt>
                <c:pt idx="42">
                  <c:v>854.3986206054674</c:v>
                </c:pt>
                <c:pt idx="43">
                  <c:v>825.0756225585937</c:v>
                </c:pt>
                <c:pt idx="44">
                  <c:v>794.0000610351562</c:v>
                </c:pt>
                <c:pt idx="45">
                  <c:v>755.909423828125</c:v>
                </c:pt>
                <c:pt idx="46">
                  <c:v>709.6790161132812</c:v>
                </c:pt>
                <c:pt idx="47">
                  <c:v>658.386596679688</c:v>
                </c:pt>
                <c:pt idx="48">
                  <c:v>602.9834594726565</c:v>
                </c:pt>
                <c:pt idx="49">
                  <c:v>543.8392944335924</c:v>
                </c:pt>
                <c:pt idx="50">
                  <c:v>501.4720764160156</c:v>
                </c:pt>
                <c:pt idx="51">
                  <c:v>466.6930236816406</c:v>
                </c:pt>
                <c:pt idx="52">
                  <c:v>444.5416564941406</c:v>
                </c:pt>
                <c:pt idx="53">
                  <c:v>432.0427551269531</c:v>
                </c:pt>
                <c:pt idx="54">
                  <c:v>429.0655822753906</c:v>
                </c:pt>
                <c:pt idx="55">
                  <c:v>433.5060119628885</c:v>
                </c:pt>
                <c:pt idx="56">
                  <c:v>438.0723571777344</c:v>
                </c:pt>
                <c:pt idx="57">
                  <c:v>438.4485168457031</c:v>
                </c:pt>
                <c:pt idx="58">
                  <c:v>433.5173034667969</c:v>
                </c:pt>
                <c:pt idx="59">
                  <c:v>436.1070861816406</c:v>
                </c:pt>
                <c:pt idx="60">
                  <c:v>439.5461730957031</c:v>
                </c:pt>
                <c:pt idx="61">
                  <c:v>440.958312988278</c:v>
                </c:pt>
                <c:pt idx="62">
                  <c:v>437.6889038085936</c:v>
                </c:pt>
                <c:pt idx="63">
                  <c:v>429.8682861328125</c:v>
                </c:pt>
                <c:pt idx="64">
                  <c:v>414.3818969726562</c:v>
                </c:pt>
                <c:pt idx="65">
                  <c:v>387.2028198242187</c:v>
                </c:pt>
                <c:pt idx="66">
                  <c:v>354.6612854003906</c:v>
                </c:pt>
                <c:pt idx="67">
                  <c:v>324.7037963867187</c:v>
                </c:pt>
                <c:pt idx="68">
                  <c:v>296.4178466796875</c:v>
                </c:pt>
                <c:pt idx="69">
                  <c:v>265.2395935058594</c:v>
                </c:pt>
                <c:pt idx="70">
                  <c:v>238.3031768798828</c:v>
                </c:pt>
                <c:pt idx="71">
                  <c:v>211.1414031982422</c:v>
                </c:pt>
                <c:pt idx="72">
                  <c:v>184.4878997802734</c:v>
                </c:pt>
                <c:pt idx="73">
                  <c:v>155.7669982910156</c:v>
                </c:pt>
                <c:pt idx="74">
                  <c:v>127.5603103637695</c:v>
                </c:pt>
                <c:pt idx="75">
                  <c:v>109.3001022338867</c:v>
                </c:pt>
                <c:pt idx="76">
                  <c:v>95.48100280761718</c:v>
                </c:pt>
                <c:pt idx="77">
                  <c:v>81.65287780761658</c:v>
                </c:pt>
                <c:pt idx="78">
                  <c:v>72.8047256469727</c:v>
                </c:pt>
                <c:pt idx="79">
                  <c:v>70.72981262207031</c:v>
                </c:pt>
                <c:pt idx="80">
                  <c:v>70.67456817626906</c:v>
                </c:pt>
                <c:pt idx="81">
                  <c:v>74.2482299804688</c:v>
                </c:pt>
                <c:pt idx="82">
                  <c:v>77.88272857665943</c:v>
                </c:pt>
                <c:pt idx="83">
                  <c:v>80.01628875732418</c:v>
                </c:pt>
                <c:pt idx="84">
                  <c:v>80.95672607421874</c:v>
                </c:pt>
                <c:pt idx="85">
                  <c:v>83.45905303955078</c:v>
                </c:pt>
                <c:pt idx="86">
                  <c:v>82.82582855224574</c:v>
                </c:pt>
                <c:pt idx="87">
                  <c:v>82.60451507568358</c:v>
                </c:pt>
                <c:pt idx="88">
                  <c:v>77.65620422363281</c:v>
                </c:pt>
                <c:pt idx="89">
                  <c:v>83.2682571411133</c:v>
                </c:pt>
                <c:pt idx="90">
                  <c:v>69.57736206054685</c:v>
                </c:pt>
                <c:pt idx="91">
                  <c:v>55.3740348815918</c:v>
                </c:pt>
                <c:pt idx="92">
                  <c:v>30.3513355255127</c:v>
                </c:pt>
                <c:pt idx="93">
                  <c:v>12.5078821182251</c:v>
                </c:pt>
                <c:pt idx="94">
                  <c:v>31.99296951293945</c:v>
                </c:pt>
                <c:pt idx="95">
                  <c:v>49.2433967590332</c:v>
                </c:pt>
                <c:pt idx="96">
                  <c:v>45.39129638671875</c:v>
                </c:pt>
                <c:pt idx="97">
                  <c:v>63.63525390625</c:v>
                </c:pt>
                <c:pt idx="98">
                  <c:v>102.080078125</c:v>
                </c:pt>
                <c:pt idx="99">
                  <c:v>156.3896484375</c:v>
                </c:pt>
              </c:numCache>
            </c:numRef>
          </c:yVal>
          <c:smooth val="0"/>
        </c:ser>
        <c:ser>
          <c:idx val="10"/>
          <c:order val="5"/>
          <c:tx>
            <c:v>negative control</c:v>
          </c:tx>
          <c:spPr>
            <a:ln w="19050">
              <a:solidFill>
                <a:schemeClr val="tx1">
                  <a:lumMod val="65000"/>
                  <a:lumOff val="35000"/>
                </a:schemeClr>
              </a:solidFill>
              <a:prstDash val="solid"/>
            </a:ln>
          </c:spPr>
          <c:marker>
            <c:symbol val="none"/>
          </c:marker>
          <c:xVal>
            <c:numRef>
              <c:f>MCAndF!$A$2:$A$101</c:f>
              <c:numCache>
                <c:formatCode>General</c:formatCode>
                <c:ptCount val="100"/>
                <c:pt idx="0">
                  <c:v>70.0</c:v>
                </c:pt>
                <c:pt idx="1">
                  <c:v>70.20202019810677</c:v>
                </c:pt>
                <c:pt idx="2">
                  <c:v>70.40404039621353</c:v>
                </c:pt>
                <c:pt idx="3">
                  <c:v>70.6060605943203</c:v>
                </c:pt>
                <c:pt idx="4">
                  <c:v>70.80808079242645</c:v>
                </c:pt>
                <c:pt idx="5">
                  <c:v>71.01010099053383</c:v>
                </c:pt>
                <c:pt idx="6">
                  <c:v>71.2121211886406</c:v>
                </c:pt>
                <c:pt idx="7">
                  <c:v>71.4141413867474</c:v>
                </c:pt>
                <c:pt idx="8">
                  <c:v>71.61616158485413</c:v>
                </c:pt>
                <c:pt idx="9">
                  <c:v>71.81818178296088</c:v>
                </c:pt>
                <c:pt idx="10">
                  <c:v>72.0202019810677</c:v>
                </c:pt>
                <c:pt idx="11">
                  <c:v>72.22222217917441</c:v>
                </c:pt>
                <c:pt idx="12">
                  <c:v>72.42424237728115</c:v>
                </c:pt>
                <c:pt idx="13">
                  <c:v>72.62626257538795</c:v>
                </c:pt>
                <c:pt idx="14">
                  <c:v>72.82828277349408</c:v>
                </c:pt>
                <c:pt idx="15">
                  <c:v>73.03030297160122</c:v>
                </c:pt>
                <c:pt idx="16">
                  <c:v>73.23232316970826</c:v>
                </c:pt>
                <c:pt idx="17">
                  <c:v>73.434343367815</c:v>
                </c:pt>
                <c:pt idx="18">
                  <c:v>73.63636356592178</c:v>
                </c:pt>
                <c:pt idx="19">
                  <c:v>73.83838376402855</c:v>
                </c:pt>
                <c:pt idx="20">
                  <c:v>74.0404039621353</c:v>
                </c:pt>
                <c:pt idx="21">
                  <c:v>74.2424241602421</c:v>
                </c:pt>
                <c:pt idx="22">
                  <c:v>74.4444443583489</c:v>
                </c:pt>
                <c:pt idx="23">
                  <c:v>74.64646455645534</c:v>
                </c:pt>
                <c:pt idx="24">
                  <c:v>74.84848475456238</c:v>
                </c:pt>
                <c:pt idx="25">
                  <c:v>75.05050495266887</c:v>
                </c:pt>
                <c:pt idx="26">
                  <c:v>75.25252515077591</c:v>
                </c:pt>
                <c:pt idx="27">
                  <c:v>75.45454534888267</c:v>
                </c:pt>
                <c:pt idx="28">
                  <c:v>75.65656554698917</c:v>
                </c:pt>
                <c:pt idx="29">
                  <c:v>75.85858574509621</c:v>
                </c:pt>
                <c:pt idx="30">
                  <c:v>76.060605943203</c:v>
                </c:pt>
                <c:pt idx="31">
                  <c:v>76.26262614130973</c:v>
                </c:pt>
                <c:pt idx="32">
                  <c:v>76.4646463394165</c:v>
                </c:pt>
                <c:pt idx="33">
                  <c:v>76.666666537523</c:v>
                </c:pt>
                <c:pt idx="34">
                  <c:v>76.86868673563004</c:v>
                </c:pt>
                <c:pt idx="35">
                  <c:v>77.0707069337363</c:v>
                </c:pt>
                <c:pt idx="36">
                  <c:v>77.27272713184327</c:v>
                </c:pt>
                <c:pt idx="37">
                  <c:v>77.47474732995028</c:v>
                </c:pt>
                <c:pt idx="38">
                  <c:v>77.67676752805667</c:v>
                </c:pt>
                <c:pt idx="39">
                  <c:v>77.87878772616322</c:v>
                </c:pt>
                <c:pt idx="40">
                  <c:v>78.08080792427063</c:v>
                </c:pt>
                <c:pt idx="41">
                  <c:v>78.2828281223774</c:v>
                </c:pt>
                <c:pt idx="42">
                  <c:v>78.48484832048369</c:v>
                </c:pt>
                <c:pt idx="43">
                  <c:v>78.68686851859039</c:v>
                </c:pt>
                <c:pt idx="44">
                  <c:v>78.88888871669705</c:v>
                </c:pt>
                <c:pt idx="45">
                  <c:v>79.09090891480425</c:v>
                </c:pt>
                <c:pt idx="46">
                  <c:v>79.29292911291121</c:v>
                </c:pt>
                <c:pt idx="47">
                  <c:v>79.494949311018</c:v>
                </c:pt>
                <c:pt idx="48">
                  <c:v>79.69696950912475</c:v>
                </c:pt>
                <c:pt idx="49">
                  <c:v>79.89898970723151</c:v>
                </c:pt>
                <c:pt idx="50">
                  <c:v>80.1010099053383</c:v>
                </c:pt>
                <c:pt idx="51">
                  <c:v>80.30303010344456</c:v>
                </c:pt>
                <c:pt idx="52">
                  <c:v>80.50505030155134</c:v>
                </c:pt>
                <c:pt idx="53">
                  <c:v>80.70707049965858</c:v>
                </c:pt>
                <c:pt idx="54">
                  <c:v>80.90909069776536</c:v>
                </c:pt>
                <c:pt idx="55">
                  <c:v>81.1111108958721</c:v>
                </c:pt>
                <c:pt idx="56">
                  <c:v>81.31313109397888</c:v>
                </c:pt>
                <c:pt idx="57">
                  <c:v>81.51515129208565</c:v>
                </c:pt>
                <c:pt idx="58">
                  <c:v>81.7171714901924</c:v>
                </c:pt>
                <c:pt idx="59">
                  <c:v>81.9191916882992</c:v>
                </c:pt>
                <c:pt idx="60">
                  <c:v>82.12121188640585</c:v>
                </c:pt>
                <c:pt idx="61">
                  <c:v>82.32323208451271</c:v>
                </c:pt>
                <c:pt idx="62">
                  <c:v>82.52525228261948</c:v>
                </c:pt>
                <c:pt idx="63">
                  <c:v>82.72727248072624</c:v>
                </c:pt>
                <c:pt idx="64">
                  <c:v>82.929292678833</c:v>
                </c:pt>
                <c:pt idx="65">
                  <c:v>83.1313128769393</c:v>
                </c:pt>
                <c:pt idx="66">
                  <c:v>83.33333307504654</c:v>
                </c:pt>
                <c:pt idx="67">
                  <c:v>83.53535327315331</c:v>
                </c:pt>
                <c:pt idx="68">
                  <c:v>83.7373734712601</c:v>
                </c:pt>
                <c:pt idx="69">
                  <c:v>83.9393936693669</c:v>
                </c:pt>
                <c:pt idx="70">
                  <c:v>84.1414138674736</c:v>
                </c:pt>
                <c:pt idx="71">
                  <c:v>84.34343406558037</c:v>
                </c:pt>
                <c:pt idx="72">
                  <c:v>84.54545426368713</c:v>
                </c:pt>
                <c:pt idx="73">
                  <c:v>84.7474744617939</c:v>
                </c:pt>
                <c:pt idx="74">
                  <c:v>84.9494946599007</c:v>
                </c:pt>
                <c:pt idx="75">
                  <c:v>85.15151485800743</c:v>
                </c:pt>
                <c:pt idx="76">
                  <c:v>85.35353505611393</c:v>
                </c:pt>
                <c:pt idx="77">
                  <c:v>85.55555525422095</c:v>
                </c:pt>
                <c:pt idx="78">
                  <c:v>85.75757545232773</c:v>
                </c:pt>
                <c:pt idx="79">
                  <c:v>85.95959565043448</c:v>
                </c:pt>
                <c:pt idx="80">
                  <c:v>86.16161584854125</c:v>
                </c:pt>
                <c:pt idx="81">
                  <c:v>86.36363604664803</c:v>
                </c:pt>
                <c:pt idx="82">
                  <c:v>86.56565624475478</c:v>
                </c:pt>
                <c:pt idx="83">
                  <c:v>86.76767644286155</c:v>
                </c:pt>
                <c:pt idx="84">
                  <c:v>86.9696966409683</c:v>
                </c:pt>
                <c:pt idx="85">
                  <c:v>87.17171683907505</c:v>
                </c:pt>
                <c:pt idx="86">
                  <c:v>87.37373703718104</c:v>
                </c:pt>
                <c:pt idx="87">
                  <c:v>87.57575723528815</c:v>
                </c:pt>
                <c:pt idx="88">
                  <c:v>87.77777743339512</c:v>
                </c:pt>
                <c:pt idx="89">
                  <c:v>87.97979763150215</c:v>
                </c:pt>
                <c:pt idx="90">
                  <c:v>88.18181782960885</c:v>
                </c:pt>
                <c:pt idx="91">
                  <c:v>88.38383802771541</c:v>
                </c:pt>
                <c:pt idx="92">
                  <c:v>88.58585822582245</c:v>
                </c:pt>
                <c:pt idx="93">
                  <c:v>88.78787842392894</c:v>
                </c:pt>
                <c:pt idx="94">
                  <c:v>88.98989862203598</c:v>
                </c:pt>
                <c:pt idx="95">
                  <c:v>89.19191882014274</c:v>
                </c:pt>
                <c:pt idx="96">
                  <c:v>89.39393901824951</c:v>
                </c:pt>
                <c:pt idx="97">
                  <c:v>89.59595921635628</c:v>
                </c:pt>
                <c:pt idx="98">
                  <c:v>89.79797941446304</c:v>
                </c:pt>
                <c:pt idx="99">
                  <c:v>89.99999961256981</c:v>
                </c:pt>
              </c:numCache>
            </c:numRef>
          </c:xVal>
          <c:yVal>
            <c:numRef>
              <c:f>MCAndF!$L$2:$L$101</c:f>
              <c:numCache>
                <c:formatCode>General</c:formatCode>
                <c:ptCount val="100"/>
                <c:pt idx="0">
                  <c:v>-663.3828125</c:v>
                </c:pt>
                <c:pt idx="1">
                  <c:v>-661.076171875</c:v>
                </c:pt>
                <c:pt idx="2">
                  <c:v>-542.173828125</c:v>
                </c:pt>
                <c:pt idx="3">
                  <c:v>-203.162109375</c:v>
                </c:pt>
                <c:pt idx="4">
                  <c:v>93.046875</c:v>
                </c:pt>
                <c:pt idx="5">
                  <c:v>143.2510375976562</c:v>
                </c:pt>
                <c:pt idx="6">
                  <c:v>209.8382415771484</c:v>
                </c:pt>
                <c:pt idx="7">
                  <c:v>258.9473876953125</c:v>
                </c:pt>
                <c:pt idx="8">
                  <c:v>288.2059326171872</c:v>
                </c:pt>
                <c:pt idx="9">
                  <c:v>285.7834472656239</c:v>
                </c:pt>
                <c:pt idx="10">
                  <c:v>331.21334838867</c:v>
                </c:pt>
                <c:pt idx="11">
                  <c:v>331.4483947753906</c:v>
                </c:pt>
                <c:pt idx="12">
                  <c:v>360.3299255371094</c:v>
                </c:pt>
                <c:pt idx="13">
                  <c:v>360.014892578125</c:v>
                </c:pt>
                <c:pt idx="14">
                  <c:v>359.2460937499989</c:v>
                </c:pt>
                <c:pt idx="15">
                  <c:v>364.5078125</c:v>
                </c:pt>
                <c:pt idx="16">
                  <c:v>370.5875854492186</c:v>
                </c:pt>
                <c:pt idx="17">
                  <c:v>379.0582275390625</c:v>
                </c:pt>
                <c:pt idx="18">
                  <c:v>393.3049926757813</c:v>
                </c:pt>
                <c:pt idx="19">
                  <c:v>417.2827758789062</c:v>
                </c:pt>
                <c:pt idx="20">
                  <c:v>450.8090209960937</c:v>
                </c:pt>
                <c:pt idx="21">
                  <c:v>484.4101562499979</c:v>
                </c:pt>
                <c:pt idx="22">
                  <c:v>516.3848266601565</c:v>
                </c:pt>
                <c:pt idx="23">
                  <c:v>545.7741088867184</c:v>
                </c:pt>
                <c:pt idx="24">
                  <c:v>580.317199707029</c:v>
                </c:pt>
                <c:pt idx="25">
                  <c:v>617.0642700195312</c:v>
                </c:pt>
                <c:pt idx="26">
                  <c:v>662.9840087890624</c:v>
                </c:pt>
                <c:pt idx="27">
                  <c:v>721.0294799804684</c:v>
                </c:pt>
                <c:pt idx="28">
                  <c:v>771.0090942382815</c:v>
                </c:pt>
                <c:pt idx="29">
                  <c:v>816.811096191402</c:v>
                </c:pt>
                <c:pt idx="30">
                  <c:v>861.7438354492187</c:v>
                </c:pt>
                <c:pt idx="31">
                  <c:v>901.6225585937475</c:v>
                </c:pt>
                <c:pt idx="32">
                  <c:v>929.7680053710937</c:v>
                </c:pt>
                <c:pt idx="33">
                  <c:v>947.6705932617187</c:v>
                </c:pt>
                <c:pt idx="34">
                  <c:v>965.57275390625</c:v>
                </c:pt>
                <c:pt idx="35">
                  <c:v>983.581176757813</c:v>
                </c:pt>
                <c:pt idx="36">
                  <c:v>1006.981384277344</c:v>
                </c:pt>
                <c:pt idx="37">
                  <c:v>1023.115051269531</c:v>
                </c:pt>
                <c:pt idx="38">
                  <c:v>1027.699829101562</c:v>
                </c:pt>
                <c:pt idx="39">
                  <c:v>1017.655151367187</c:v>
                </c:pt>
                <c:pt idx="40">
                  <c:v>995.014526367188</c:v>
                </c:pt>
                <c:pt idx="41">
                  <c:v>953.484802246094</c:v>
                </c:pt>
                <c:pt idx="42">
                  <c:v>899.344055175779</c:v>
                </c:pt>
                <c:pt idx="43">
                  <c:v>849.5676269531225</c:v>
                </c:pt>
                <c:pt idx="44">
                  <c:v>796.842102050779</c:v>
                </c:pt>
                <c:pt idx="45">
                  <c:v>737.8302612304674</c:v>
                </c:pt>
                <c:pt idx="46">
                  <c:v>669.0813598632812</c:v>
                </c:pt>
                <c:pt idx="47">
                  <c:v>596.6124877929674</c:v>
                </c:pt>
                <c:pt idx="48">
                  <c:v>520.2223510742184</c:v>
                </c:pt>
                <c:pt idx="49">
                  <c:v>436.8103332519531</c:v>
                </c:pt>
                <c:pt idx="50">
                  <c:v>367.6461486816406</c:v>
                </c:pt>
                <c:pt idx="51">
                  <c:v>303.5001220703125</c:v>
                </c:pt>
                <c:pt idx="52">
                  <c:v>247.8298492431641</c:v>
                </c:pt>
                <c:pt idx="53">
                  <c:v>202.4244537353516</c:v>
                </c:pt>
                <c:pt idx="54">
                  <c:v>168.6237335205078</c:v>
                </c:pt>
                <c:pt idx="55">
                  <c:v>144.5552520751953</c:v>
                </c:pt>
                <c:pt idx="56">
                  <c:v>126.2850036621094</c:v>
                </c:pt>
                <c:pt idx="57">
                  <c:v>106.5123291015625</c:v>
                </c:pt>
                <c:pt idx="58">
                  <c:v>87.57449340820312</c:v>
                </c:pt>
                <c:pt idx="59">
                  <c:v>79.39247894287074</c:v>
                </c:pt>
                <c:pt idx="60">
                  <c:v>78.7015457153321</c:v>
                </c:pt>
                <c:pt idx="61">
                  <c:v>81.49234008789061</c:v>
                </c:pt>
                <c:pt idx="62">
                  <c:v>84.9722137451172</c:v>
                </c:pt>
                <c:pt idx="63">
                  <c:v>91.35004425048798</c:v>
                </c:pt>
                <c:pt idx="64">
                  <c:v>95.4936065673828</c:v>
                </c:pt>
                <c:pt idx="65">
                  <c:v>95.56932830810547</c:v>
                </c:pt>
                <c:pt idx="66">
                  <c:v>95.2371292114258</c:v>
                </c:pt>
                <c:pt idx="67">
                  <c:v>94.63880157470658</c:v>
                </c:pt>
                <c:pt idx="68">
                  <c:v>94.2161407470703</c:v>
                </c:pt>
                <c:pt idx="69">
                  <c:v>89.6014862060542</c:v>
                </c:pt>
                <c:pt idx="70">
                  <c:v>84.9890899658203</c:v>
                </c:pt>
                <c:pt idx="71">
                  <c:v>81.22850036621094</c:v>
                </c:pt>
                <c:pt idx="72">
                  <c:v>75.35409545898435</c:v>
                </c:pt>
                <c:pt idx="73">
                  <c:v>67.57480621337891</c:v>
                </c:pt>
                <c:pt idx="74">
                  <c:v>60.16104888916016</c:v>
                </c:pt>
                <c:pt idx="75">
                  <c:v>54.84852600097656</c:v>
                </c:pt>
                <c:pt idx="76">
                  <c:v>50.87847518920898</c:v>
                </c:pt>
                <c:pt idx="77">
                  <c:v>45.85114288330077</c:v>
                </c:pt>
                <c:pt idx="78">
                  <c:v>44.36944198608398</c:v>
                </c:pt>
                <c:pt idx="79">
                  <c:v>43.51802444458008</c:v>
                </c:pt>
                <c:pt idx="80">
                  <c:v>43.85980224609375</c:v>
                </c:pt>
                <c:pt idx="81">
                  <c:v>42.91726684570293</c:v>
                </c:pt>
                <c:pt idx="82">
                  <c:v>42.50425338745117</c:v>
                </c:pt>
                <c:pt idx="83">
                  <c:v>41.36244201660156</c:v>
                </c:pt>
                <c:pt idx="84">
                  <c:v>40.2222557067871</c:v>
                </c:pt>
                <c:pt idx="85">
                  <c:v>38.70796585083008</c:v>
                </c:pt>
                <c:pt idx="86">
                  <c:v>37.93729782104489</c:v>
                </c:pt>
                <c:pt idx="87">
                  <c:v>38.82646179199199</c:v>
                </c:pt>
                <c:pt idx="88">
                  <c:v>37.923828125</c:v>
                </c:pt>
                <c:pt idx="89">
                  <c:v>38.03656005859375</c:v>
                </c:pt>
                <c:pt idx="90">
                  <c:v>37.02627182006836</c:v>
                </c:pt>
                <c:pt idx="91">
                  <c:v>34.39785385131817</c:v>
                </c:pt>
                <c:pt idx="92">
                  <c:v>39.6854476928711</c:v>
                </c:pt>
                <c:pt idx="93">
                  <c:v>40.82444381713864</c:v>
                </c:pt>
                <c:pt idx="94">
                  <c:v>42.26263809204101</c:v>
                </c:pt>
                <c:pt idx="95">
                  <c:v>64.18583679199205</c:v>
                </c:pt>
                <c:pt idx="96">
                  <c:v>55.367919921875</c:v>
                </c:pt>
                <c:pt idx="97">
                  <c:v>40.93505859375</c:v>
                </c:pt>
                <c:pt idx="98">
                  <c:v>59.58984375</c:v>
                </c:pt>
                <c:pt idx="99">
                  <c:v>89.9599609375</c:v>
                </c:pt>
              </c:numCache>
            </c:numRef>
          </c:yVal>
          <c:smooth val="0"/>
        </c:ser>
        <c:ser>
          <c:idx val="11"/>
          <c:order val="6"/>
          <c:tx>
            <c:v>positive control</c:v>
          </c:tx>
          <c:spPr>
            <a:ln w="1905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MCAndF!$A$2:$A$101</c:f>
              <c:numCache>
                <c:formatCode>General</c:formatCode>
                <c:ptCount val="100"/>
                <c:pt idx="0">
                  <c:v>70.0</c:v>
                </c:pt>
                <c:pt idx="1">
                  <c:v>70.20202019810677</c:v>
                </c:pt>
                <c:pt idx="2">
                  <c:v>70.40404039621353</c:v>
                </c:pt>
                <c:pt idx="3">
                  <c:v>70.6060605943203</c:v>
                </c:pt>
                <c:pt idx="4">
                  <c:v>70.80808079242645</c:v>
                </c:pt>
                <c:pt idx="5">
                  <c:v>71.01010099053383</c:v>
                </c:pt>
                <c:pt idx="6">
                  <c:v>71.2121211886406</c:v>
                </c:pt>
                <c:pt idx="7">
                  <c:v>71.4141413867474</c:v>
                </c:pt>
                <c:pt idx="8">
                  <c:v>71.61616158485413</c:v>
                </c:pt>
                <c:pt idx="9">
                  <c:v>71.81818178296088</c:v>
                </c:pt>
                <c:pt idx="10">
                  <c:v>72.0202019810677</c:v>
                </c:pt>
                <c:pt idx="11">
                  <c:v>72.22222217917441</c:v>
                </c:pt>
                <c:pt idx="12">
                  <c:v>72.42424237728115</c:v>
                </c:pt>
                <c:pt idx="13">
                  <c:v>72.62626257538795</c:v>
                </c:pt>
                <c:pt idx="14">
                  <c:v>72.82828277349408</c:v>
                </c:pt>
                <c:pt idx="15">
                  <c:v>73.03030297160122</c:v>
                </c:pt>
                <c:pt idx="16">
                  <c:v>73.23232316970826</c:v>
                </c:pt>
                <c:pt idx="17">
                  <c:v>73.434343367815</c:v>
                </c:pt>
                <c:pt idx="18">
                  <c:v>73.63636356592178</c:v>
                </c:pt>
                <c:pt idx="19">
                  <c:v>73.83838376402855</c:v>
                </c:pt>
                <c:pt idx="20">
                  <c:v>74.0404039621353</c:v>
                </c:pt>
                <c:pt idx="21">
                  <c:v>74.2424241602421</c:v>
                </c:pt>
                <c:pt idx="22">
                  <c:v>74.4444443583489</c:v>
                </c:pt>
                <c:pt idx="23">
                  <c:v>74.64646455645534</c:v>
                </c:pt>
                <c:pt idx="24">
                  <c:v>74.84848475456238</c:v>
                </c:pt>
                <c:pt idx="25">
                  <c:v>75.05050495266887</c:v>
                </c:pt>
                <c:pt idx="26">
                  <c:v>75.25252515077591</c:v>
                </c:pt>
                <c:pt idx="27">
                  <c:v>75.45454534888267</c:v>
                </c:pt>
                <c:pt idx="28">
                  <c:v>75.65656554698917</c:v>
                </c:pt>
                <c:pt idx="29">
                  <c:v>75.85858574509621</c:v>
                </c:pt>
                <c:pt idx="30">
                  <c:v>76.060605943203</c:v>
                </c:pt>
                <c:pt idx="31">
                  <c:v>76.26262614130973</c:v>
                </c:pt>
                <c:pt idx="32">
                  <c:v>76.4646463394165</c:v>
                </c:pt>
                <c:pt idx="33">
                  <c:v>76.666666537523</c:v>
                </c:pt>
                <c:pt idx="34">
                  <c:v>76.86868673563004</c:v>
                </c:pt>
                <c:pt idx="35">
                  <c:v>77.0707069337363</c:v>
                </c:pt>
                <c:pt idx="36">
                  <c:v>77.27272713184327</c:v>
                </c:pt>
                <c:pt idx="37">
                  <c:v>77.47474732995028</c:v>
                </c:pt>
                <c:pt idx="38">
                  <c:v>77.67676752805667</c:v>
                </c:pt>
                <c:pt idx="39">
                  <c:v>77.87878772616322</c:v>
                </c:pt>
                <c:pt idx="40">
                  <c:v>78.08080792427063</c:v>
                </c:pt>
                <c:pt idx="41">
                  <c:v>78.2828281223774</c:v>
                </c:pt>
                <c:pt idx="42">
                  <c:v>78.48484832048369</c:v>
                </c:pt>
                <c:pt idx="43">
                  <c:v>78.68686851859039</c:v>
                </c:pt>
                <c:pt idx="44">
                  <c:v>78.88888871669705</c:v>
                </c:pt>
                <c:pt idx="45">
                  <c:v>79.09090891480425</c:v>
                </c:pt>
                <c:pt idx="46">
                  <c:v>79.29292911291121</c:v>
                </c:pt>
                <c:pt idx="47">
                  <c:v>79.494949311018</c:v>
                </c:pt>
                <c:pt idx="48">
                  <c:v>79.69696950912475</c:v>
                </c:pt>
                <c:pt idx="49">
                  <c:v>79.89898970723151</c:v>
                </c:pt>
                <c:pt idx="50">
                  <c:v>80.1010099053383</c:v>
                </c:pt>
                <c:pt idx="51">
                  <c:v>80.30303010344456</c:v>
                </c:pt>
                <c:pt idx="52">
                  <c:v>80.50505030155134</c:v>
                </c:pt>
                <c:pt idx="53">
                  <c:v>80.70707049965858</c:v>
                </c:pt>
                <c:pt idx="54">
                  <c:v>80.90909069776536</c:v>
                </c:pt>
                <c:pt idx="55">
                  <c:v>81.1111108958721</c:v>
                </c:pt>
                <c:pt idx="56">
                  <c:v>81.31313109397888</c:v>
                </c:pt>
                <c:pt idx="57">
                  <c:v>81.51515129208565</c:v>
                </c:pt>
                <c:pt idx="58">
                  <c:v>81.7171714901924</c:v>
                </c:pt>
                <c:pt idx="59">
                  <c:v>81.9191916882992</c:v>
                </c:pt>
                <c:pt idx="60">
                  <c:v>82.12121188640585</c:v>
                </c:pt>
                <c:pt idx="61">
                  <c:v>82.32323208451271</c:v>
                </c:pt>
                <c:pt idx="62">
                  <c:v>82.52525228261948</c:v>
                </c:pt>
                <c:pt idx="63">
                  <c:v>82.72727248072624</c:v>
                </c:pt>
                <c:pt idx="64">
                  <c:v>82.929292678833</c:v>
                </c:pt>
                <c:pt idx="65">
                  <c:v>83.1313128769393</c:v>
                </c:pt>
                <c:pt idx="66">
                  <c:v>83.33333307504654</c:v>
                </c:pt>
                <c:pt idx="67">
                  <c:v>83.53535327315331</c:v>
                </c:pt>
                <c:pt idx="68">
                  <c:v>83.7373734712601</c:v>
                </c:pt>
                <c:pt idx="69">
                  <c:v>83.9393936693669</c:v>
                </c:pt>
                <c:pt idx="70">
                  <c:v>84.1414138674736</c:v>
                </c:pt>
                <c:pt idx="71">
                  <c:v>84.34343406558037</c:v>
                </c:pt>
                <c:pt idx="72">
                  <c:v>84.54545426368713</c:v>
                </c:pt>
                <c:pt idx="73">
                  <c:v>84.7474744617939</c:v>
                </c:pt>
                <c:pt idx="74">
                  <c:v>84.9494946599007</c:v>
                </c:pt>
                <c:pt idx="75">
                  <c:v>85.15151485800743</c:v>
                </c:pt>
                <c:pt idx="76">
                  <c:v>85.35353505611393</c:v>
                </c:pt>
                <c:pt idx="77">
                  <c:v>85.55555525422095</c:v>
                </c:pt>
                <c:pt idx="78">
                  <c:v>85.75757545232773</c:v>
                </c:pt>
                <c:pt idx="79">
                  <c:v>85.95959565043448</c:v>
                </c:pt>
                <c:pt idx="80">
                  <c:v>86.16161584854125</c:v>
                </c:pt>
                <c:pt idx="81">
                  <c:v>86.36363604664803</c:v>
                </c:pt>
                <c:pt idx="82">
                  <c:v>86.56565624475478</c:v>
                </c:pt>
                <c:pt idx="83">
                  <c:v>86.76767644286155</c:v>
                </c:pt>
                <c:pt idx="84">
                  <c:v>86.9696966409683</c:v>
                </c:pt>
                <c:pt idx="85">
                  <c:v>87.17171683907505</c:v>
                </c:pt>
                <c:pt idx="86">
                  <c:v>87.37373703718104</c:v>
                </c:pt>
                <c:pt idx="87">
                  <c:v>87.57575723528815</c:v>
                </c:pt>
                <c:pt idx="88">
                  <c:v>87.77777743339512</c:v>
                </c:pt>
                <c:pt idx="89">
                  <c:v>87.97979763150215</c:v>
                </c:pt>
                <c:pt idx="90">
                  <c:v>88.18181782960885</c:v>
                </c:pt>
                <c:pt idx="91">
                  <c:v>88.38383802771541</c:v>
                </c:pt>
                <c:pt idx="92">
                  <c:v>88.58585822582245</c:v>
                </c:pt>
                <c:pt idx="93">
                  <c:v>88.78787842392894</c:v>
                </c:pt>
                <c:pt idx="94">
                  <c:v>88.98989862203598</c:v>
                </c:pt>
                <c:pt idx="95">
                  <c:v>89.19191882014274</c:v>
                </c:pt>
                <c:pt idx="96">
                  <c:v>89.39393901824951</c:v>
                </c:pt>
                <c:pt idx="97">
                  <c:v>89.59595921635628</c:v>
                </c:pt>
                <c:pt idx="98">
                  <c:v>89.79797941446304</c:v>
                </c:pt>
                <c:pt idx="99">
                  <c:v>89.99999961256981</c:v>
                </c:pt>
              </c:numCache>
            </c:numRef>
          </c:xVal>
          <c:yVal>
            <c:numRef>
              <c:f>MCAndF!$M$2:$M$101</c:f>
              <c:numCache>
                <c:formatCode>General</c:formatCode>
                <c:ptCount val="100"/>
                <c:pt idx="0">
                  <c:v>-31.69921875</c:v>
                </c:pt>
                <c:pt idx="1">
                  <c:v>-25.30078125</c:v>
                </c:pt>
                <c:pt idx="2">
                  <c:v>-14.0546875</c:v>
                </c:pt>
                <c:pt idx="3">
                  <c:v>-5.4931640625</c:v>
                </c:pt>
                <c:pt idx="4">
                  <c:v>-1.400065064430237</c:v>
                </c:pt>
                <c:pt idx="5">
                  <c:v>2.227213621139526</c:v>
                </c:pt>
                <c:pt idx="6">
                  <c:v>3.295960426330566</c:v>
                </c:pt>
                <c:pt idx="7">
                  <c:v>3.801868677139276</c:v>
                </c:pt>
                <c:pt idx="8">
                  <c:v>6.150901794433594</c:v>
                </c:pt>
                <c:pt idx="9">
                  <c:v>7.031441688537597</c:v>
                </c:pt>
                <c:pt idx="10">
                  <c:v>7.77070140838623</c:v>
                </c:pt>
                <c:pt idx="11">
                  <c:v>8.312977790832518</c:v>
                </c:pt>
                <c:pt idx="12">
                  <c:v>9.363365173339843</c:v>
                </c:pt>
                <c:pt idx="13">
                  <c:v>9.90726947784424</c:v>
                </c:pt>
                <c:pt idx="14">
                  <c:v>10.62859058380127</c:v>
                </c:pt>
                <c:pt idx="15">
                  <c:v>11.1063928604126</c:v>
                </c:pt>
                <c:pt idx="16">
                  <c:v>11.57142066955566</c:v>
                </c:pt>
                <c:pt idx="17">
                  <c:v>12.3458709716797</c:v>
                </c:pt>
                <c:pt idx="18">
                  <c:v>12.4800329208374</c:v>
                </c:pt>
                <c:pt idx="19">
                  <c:v>13.47385597229004</c:v>
                </c:pt>
                <c:pt idx="20">
                  <c:v>14.86171531677246</c:v>
                </c:pt>
                <c:pt idx="21">
                  <c:v>16.06737899780273</c:v>
                </c:pt>
                <c:pt idx="22">
                  <c:v>16.95114326477051</c:v>
                </c:pt>
                <c:pt idx="23">
                  <c:v>17.74188995361328</c:v>
                </c:pt>
                <c:pt idx="24">
                  <c:v>19.22942733764648</c:v>
                </c:pt>
                <c:pt idx="25">
                  <c:v>20.88356018066406</c:v>
                </c:pt>
                <c:pt idx="26">
                  <c:v>22.4057960510252</c:v>
                </c:pt>
                <c:pt idx="27">
                  <c:v>25.27049827575684</c:v>
                </c:pt>
                <c:pt idx="28">
                  <c:v>27.86874580383298</c:v>
                </c:pt>
                <c:pt idx="29">
                  <c:v>30.61451721191406</c:v>
                </c:pt>
                <c:pt idx="30">
                  <c:v>33.58716583251953</c:v>
                </c:pt>
                <c:pt idx="31">
                  <c:v>36.64947509765624</c:v>
                </c:pt>
                <c:pt idx="32">
                  <c:v>38.94474411010739</c:v>
                </c:pt>
                <c:pt idx="33">
                  <c:v>42.25033950805664</c:v>
                </c:pt>
                <c:pt idx="34">
                  <c:v>45.27913665771484</c:v>
                </c:pt>
                <c:pt idx="35">
                  <c:v>50.23207855224609</c:v>
                </c:pt>
                <c:pt idx="36">
                  <c:v>59.56534576416015</c:v>
                </c:pt>
                <c:pt idx="37">
                  <c:v>69.6912078857422</c:v>
                </c:pt>
                <c:pt idx="38">
                  <c:v>78.72103118896457</c:v>
                </c:pt>
                <c:pt idx="39">
                  <c:v>87.7645492553711</c:v>
                </c:pt>
                <c:pt idx="40">
                  <c:v>98.75019836425781</c:v>
                </c:pt>
                <c:pt idx="41">
                  <c:v>108.4298477172852</c:v>
                </c:pt>
                <c:pt idx="42">
                  <c:v>118.3422241210937</c:v>
                </c:pt>
                <c:pt idx="43">
                  <c:v>132.7963104248047</c:v>
                </c:pt>
                <c:pt idx="44">
                  <c:v>161.4637908935547</c:v>
                </c:pt>
                <c:pt idx="45">
                  <c:v>187.0216674804687</c:v>
                </c:pt>
                <c:pt idx="46">
                  <c:v>211.3969116210937</c:v>
                </c:pt>
                <c:pt idx="47">
                  <c:v>240.3501739501953</c:v>
                </c:pt>
                <c:pt idx="48">
                  <c:v>276.0286254882791</c:v>
                </c:pt>
                <c:pt idx="49">
                  <c:v>319.0029296875</c:v>
                </c:pt>
                <c:pt idx="50">
                  <c:v>375.1542663574218</c:v>
                </c:pt>
                <c:pt idx="51">
                  <c:v>445.8624572753906</c:v>
                </c:pt>
                <c:pt idx="52">
                  <c:v>561.0978393554684</c:v>
                </c:pt>
                <c:pt idx="53">
                  <c:v>684.7012329101565</c:v>
                </c:pt>
                <c:pt idx="54">
                  <c:v>813.0830688476565</c:v>
                </c:pt>
                <c:pt idx="55">
                  <c:v>950.33447265625</c:v>
                </c:pt>
                <c:pt idx="56">
                  <c:v>1085.153442382812</c:v>
                </c:pt>
                <c:pt idx="57">
                  <c:v>1221.646484375</c:v>
                </c:pt>
                <c:pt idx="58">
                  <c:v>1375.444946289062</c:v>
                </c:pt>
                <c:pt idx="59">
                  <c:v>1548.74658203125</c:v>
                </c:pt>
                <c:pt idx="60">
                  <c:v>1742.968383789062</c:v>
                </c:pt>
                <c:pt idx="61">
                  <c:v>1970.891479492187</c:v>
                </c:pt>
                <c:pt idx="62">
                  <c:v>2187.2734375</c:v>
                </c:pt>
                <c:pt idx="63">
                  <c:v>2389.07568359375</c:v>
                </c:pt>
                <c:pt idx="64">
                  <c:v>2558.297607421875</c:v>
                </c:pt>
                <c:pt idx="65">
                  <c:v>2675.322509765625</c:v>
                </c:pt>
                <c:pt idx="66">
                  <c:v>2737.310546875</c:v>
                </c:pt>
                <c:pt idx="67">
                  <c:v>2754.813720703125</c:v>
                </c:pt>
                <c:pt idx="68">
                  <c:v>2718.419189453125</c:v>
                </c:pt>
                <c:pt idx="69">
                  <c:v>2622.3662109375</c:v>
                </c:pt>
                <c:pt idx="70">
                  <c:v>2470.421142578124</c:v>
                </c:pt>
                <c:pt idx="71">
                  <c:v>2264.28759765625</c:v>
                </c:pt>
                <c:pt idx="72">
                  <c:v>2009.887084960937</c:v>
                </c:pt>
                <c:pt idx="73">
                  <c:v>1717.8095703125</c:v>
                </c:pt>
                <c:pt idx="74">
                  <c:v>1394.638671875</c:v>
                </c:pt>
                <c:pt idx="75">
                  <c:v>1097.919921875</c:v>
                </c:pt>
                <c:pt idx="76">
                  <c:v>831.6417236328124</c:v>
                </c:pt>
                <c:pt idx="77">
                  <c:v>603.295043945313</c:v>
                </c:pt>
                <c:pt idx="78">
                  <c:v>430.0242614746094</c:v>
                </c:pt>
                <c:pt idx="79">
                  <c:v>301.4309692382791</c:v>
                </c:pt>
                <c:pt idx="80">
                  <c:v>200.3740692138672</c:v>
                </c:pt>
                <c:pt idx="81">
                  <c:v>131.4578247070312</c:v>
                </c:pt>
                <c:pt idx="82">
                  <c:v>76.00113677978515</c:v>
                </c:pt>
                <c:pt idx="83">
                  <c:v>30.07063293457012</c:v>
                </c:pt>
                <c:pt idx="84">
                  <c:v>23.020751953125</c:v>
                </c:pt>
                <c:pt idx="85">
                  <c:v>26.26979637145988</c:v>
                </c:pt>
                <c:pt idx="86">
                  <c:v>41.18363571166992</c:v>
                </c:pt>
                <c:pt idx="87">
                  <c:v>62.69923400878906</c:v>
                </c:pt>
                <c:pt idx="88">
                  <c:v>78.90135955810546</c:v>
                </c:pt>
                <c:pt idx="89">
                  <c:v>104.4668350219727</c:v>
                </c:pt>
                <c:pt idx="90">
                  <c:v>108.9771194458008</c:v>
                </c:pt>
                <c:pt idx="91">
                  <c:v>136.2606201171875</c:v>
                </c:pt>
                <c:pt idx="92">
                  <c:v>132.3538970947266</c:v>
                </c:pt>
                <c:pt idx="93">
                  <c:v>107.7195892333984</c:v>
                </c:pt>
                <c:pt idx="94">
                  <c:v>71.86408233642521</c:v>
                </c:pt>
                <c:pt idx="95">
                  <c:v>13.38923740386963</c:v>
                </c:pt>
                <c:pt idx="96">
                  <c:v>19.47712135314941</c:v>
                </c:pt>
                <c:pt idx="97">
                  <c:v>29.8046875</c:v>
                </c:pt>
                <c:pt idx="98">
                  <c:v>63.22509765625</c:v>
                </c:pt>
                <c:pt idx="99">
                  <c:v>90.8203124999997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8094488"/>
        <c:axId val="2128440344"/>
      </c:scatterChart>
      <c:valAx>
        <c:axId val="2128094488"/>
        <c:scaling>
          <c:orientation val="minMax"/>
          <c:max val="90.0"/>
          <c:min val="70.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128440344"/>
        <c:crosses val="autoZero"/>
        <c:crossBetween val="midCat"/>
      </c:valAx>
      <c:valAx>
        <c:axId val="2128440344"/>
        <c:scaling>
          <c:orientation val="minMax"/>
          <c:max val="300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128094488"/>
        <c:crosses val="autoZero"/>
        <c:crossBetween val="midCat"/>
        <c:majorUnit val="1500.0"/>
      </c:valAx>
      <c:spPr>
        <a:noFill/>
        <a:ln w="9241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437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5155071666369"/>
          <c:y val="0.177608935594696"/>
          <c:w val="0.707835810471877"/>
          <c:h val="0.677891865002254"/>
        </c:manualLayout>
      </c:layout>
      <c:scatterChart>
        <c:scatterStyle val="lineMarker"/>
        <c:varyColors val="0"/>
        <c:ser>
          <c:idx val="1"/>
          <c:order val="0"/>
          <c:tx>
            <c:v>2000 P/uL</c:v>
          </c:tx>
          <c:spPr>
            <a:ln w="19050">
              <a:solidFill>
                <a:srgbClr val="4E6328"/>
              </a:solidFill>
              <a:prstDash val="solid"/>
            </a:ln>
          </c:spPr>
          <c:marker>
            <c:symbol val="none"/>
          </c:marker>
          <c:xVal>
            <c:numRef>
              <c:f>'qPCR Analysis'!$A$1200:$A$1239</c:f>
              <c:numCache>
                <c:formatCode>General</c:formatCode>
                <c:ptCount val="40"/>
                <c:pt idx="0">
                  <c:v>1.0</c:v>
                </c:pt>
                <c:pt idx="1">
                  <c:v>2.0</c:v>
                </c:pt>
                <c:pt idx="2">
                  <c:v>3.0</c:v>
                </c:pt>
                <c:pt idx="3">
                  <c:v>4.0</c:v>
                </c:pt>
                <c:pt idx="4">
                  <c:v>5.0</c:v>
                </c:pt>
                <c:pt idx="5">
                  <c:v>6.0</c:v>
                </c:pt>
                <c:pt idx="6">
                  <c:v>7.0</c:v>
                </c:pt>
                <c:pt idx="7">
                  <c:v>8.0</c:v>
                </c:pt>
                <c:pt idx="8">
                  <c:v>9.0</c:v>
                </c:pt>
                <c:pt idx="9">
                  <c:v>10.0</c:v>
                </c:pt>
                <c:pt idx="10">
                  <c:v>11.0</c:v>
                </c:pt>
                <c:pt idx="11">
                  <c:v>12.0</c:v>
                </c:pt>
                <c:pt idx="12">
                  <c:v>13.0</c:v>
                </c:pt>
                <c:pt idx="13">
                  <c:v>14.0</c:v>
                </c:pt>
                <c:pt idx="14">
                  <c:v>15.0</c:v>
                </c:pt>
                <c:pt idx="15">
                  <c:v>16.0</c:v>
                </c:pt>
                <c:pt idx="16">
                  <c:v>17.0</c:v>
                </c:pt>
                <c:pt idx="17">
                  <c:v>18.0</c:v>
                </c:pt>
                <c:pt idx="18">
                  <c:v>19.0</c:v>
                </c:pt>
                <c:pt idx="19">
                  <c:v>20.0</c:v>
                </c:pt>
                <c:pt idx="20">
                  <c:v>21.0</c:v>
                </c:pt>
                <c:pt idx="21">
                  <c:v>22.0</c:v>
                </c:pt>
                <c:pt idx="22">
                  <c:v>23.0</c:v>
                </c:pt>
                <c:pt idx="23">
                  <c:v>24.0</c:v>
                </c:pt>
                <c:pt idx="24">
                  <c:v>25.0</c:v>
                </c:pt>
                <c:pt idx="25">
                  <c:v>26.0</c:v>
                </c:pt>
                <c:pt idx="26">
                  <c:v>27.0</c:v>
                </c:pt>
                <c:pt idx="27">
                  <c:v>28.0</c:v>
                </c:pt>
                <c:pt idx="28">
                  <c:v>29.0</c:v>
                </c:pt>
                <c:pt idx="29">
                  <c:v>30.0</c:v>
                </c:pt>
                <c:pt idx="30">
                  <c:v>31.0</c:v>
                </c:pt>
                <c:pt idx="31">
                  <c:v>32.0</c:v>
                </c:pt>
                <c:pt idx="32">
                  <c:v>33.0</c:v>
                </c:pt>
                <c:pt idx="33">
                  <c:v>34.0</c:v>
                </c:pt>
                <c:pt idx="34">
                  <c:v>35.0</c:v>
                </c:pt>
                <c:pt idx="35">
                  <c:v>36.0</c:v>
                </c:pt>
                <c:pt idx="36">
                  <c:v>37.0</c:v>
                </c:pt>
                <c:pt idx="37">
                  <c:v>38.0</c:v>
                </c:pt>
                <c:pt idx="38">
                  <c:v>39.0</c:v>
                </c:pt>
                <c:pt idx="39">
                  <c:v>40.0</c:v>
                </c:pt>
              </c:numCache>
            </c:numRef>
          </c:xVal>
          <c:yVal>
            <c:numRef>
              <c:f>'qPCR Analysis'!$C$1200:$C$1239</c:f>
              <c:numCache>
                <c:formatCode>General</c:formatCode>
                <c:ptCount val="40"/>
                <c:pt idx="0">
                  <c:v>0.00663277611602098</c:v>
                </c:pt>
                <c:pt idx="1">
                  <c:v>0.0109037531947251</c:v>
                </c:pt>
                <c:pt idx="2">
                  <c:v>0.0179248967688181</c:v>
                </c:pt>
                <c:pt idx="3">
                  <c:v>0.0294670916828181</c:v>
                </c:pt>
                <c:pt idx="4">
                  <c:v>0.0484415265600546</c:v>
                </c:pt>
                <c:pt idx="5">
                  <c:v>0.0796339505159267</c:v>
                </c:pt>
                <c:pt idx="6">
                  <c:v>0.130911719194046</c:v>
                </c:pt>
                <c:pt idx="7">
                  <c:v>0.215208045967302</c:v>
                </c:pt>
                <c:pt idx="8">
                  <c:v>0.353783854934591</c:v>
                </c:pt>
                <c:pt idx="9">
                  <c:v>0.581589743291261</c:v>
                </c:pt>
                <c:pt idx="10">
                  <c:v>0.956079907336971</c:v>
                </c:pt>
                <c:pt idx="11">
                  <c:v>1.571699609135976</c:v>
                </c:pt>
                <c:pt idx="12">
                  <c:v>2.583696216413955</c:v>
                </c:pt>
                <c:pt idx="13">
                  <c:v>4.24724860459537</c:v>
                </c:pt>
                <c:pt idx="14">
                  <c:v>6.9817548197625</c:v>
                </c:pt>
                <c:pt idx="15">
                  <c:v>11.47641334870787</c:v>
                </c:pt>
                <c:pt idx="16">
                  <c:v>18.86351344114701</c:v>
                </c:pt>
                <c:pt idx="17">
                  <c:v>31.00256319661639</c:v>
                </c:pt>
                <c:pt idx="18">
                  <c:v>50.94535738049308</c:v>
                </c:pt>
                <c:pt idx="19">
                  <c:v>83.69507962850165</c:v>
                </c:pt>
                <c:pt idx="20">
                  <c:v>137.4395974325253</c:v>
                </c:pt>
                <c:pt idx="21">
                  <c:v>225.5397388368037</c:v>
                </c:pt>
                <c:pt idx="22">
                  <c:v>369.6934217021769</c:v>
                </c:pt>
                <c:pt idx="23">
                  <c:v>604.8610830280029</c:v>
                </c:pt>
                <c:pt idx="24">
                  <c:v>986.6427857327817</c:v>
                </c:pt>
                <c:pt idx="25">
                  <c:v>1601.572224223055</c:v>
                </c:pt>
                <c:pt idx="26">
                  <c:v>2579.548523222405</c:v>
                </c:pt>
                <c:pt idx="27">
                  <c:v>4103.97116568223</c:v>
                </c:pt>
                <c:pt idx="28">
                  <c:v>6407.30076155853</c:v>
                </c:pt>
                <c:pt idx="29">
                  <c:v>9728.755800640163</c:v>
                </c:pt>
                <c:pt idx="30">
                  <c:v>14209.51809912046</c:v>
                </c:pt>
                <c:pt idx="31">
                  <c:v>19739.9657586801</c:v>
                </c:pt>
                <c:pt idx="32">
                  <c:v>25863.22974346432</c:v>
                </c:pt>
                <c:pt idx="33">
                  <c:v>31878.47627406272</c:v>
                </c:pt>
                <c:pt idx="34">
                  <c:v>37131.82536729384</c:v>
                </c:pt>
                <c:pt idx="35">
                  <c:v>41268.76800406496</c:v>
                </c:pt>
                <c:pt idx="36">
                  <c:v>44268.98044790712</c:v>
                </c:pt>
                <c:pt idx="37">
                  <c:v>46317.27688962322</c:v>
                </c:pt>
                <c:pt idx="38">
                  <c:v>47658.66499781753</c:v>
                </c:pt>
                <c:pt idx="39">
                  <c:v>48513.32176233255</c:v>
                </c:pt>
              </c:numCache>
            </c:numRef>
          </c:yVal>
          <c:smooth val="0"/>
        </c:ser>
        <c:ser>
          <c:idx val="3"/>
          <c:order val="1"/>
          <c:tx>
            <c:v>200 P/uL</c:v>
          </c:tx>
          <c:spPr>
            <a:ln w="19050">
              <a:solidFill>
                <a:srgbClr val="D81DF9"/>
              </a:solidFill>
              <a:prstDash val="solid"/>
            </a:ln>
          </c:spPr>
          <c:marker>
            <c:symbol val="none"/>
          </c:marker>
          <c:xVal>
            <c:numRef>
              <c:f>'qPCR Analysis'!$A$1200:$A$1239</c:f>
              <c:numCache>
                <c:formatCode>General</c:formatCode>
                <c:ptCount val="40"/>
                <c:pt idx="0">
                  <c:v>1.0</c:v>
                </c:pt>
                <c:pt idx="1">
                  <c:v>2.0</c:v>
                </c:pt>
                <c:pt idx="2">
                  <c:v>3.0</c:v>
                </c:pt>
                <c:pt idx="3">
                  <c:v>4.0</c:v>
                </c:pt>
                <c:pt idx="4">
                  <c:v>5.0</c:v>
                </c:pt>
                <c:pt idx="5">
                  <c:v>6.0</c:v>
                </c:pt>
                <c:pt idx="6">
                  <c:v>7.0</c:v>
                </c:pt>
                <c:pt idx="7">
                  <c:v>8.0</c:v>
                </c:pt>
                <c:pt idx="8">
                  <c:v>9.0</c:v>
                </c:pt>
                <c:pt idx="9">
                  <c:v>10.0</c:v>
                </c:pt>
                <c:pt idx="10">
                  <c:v>11.0</c:v>
                </c:pt>
                <c:pt idx="11">
                  <c:v>12.0</c:v>
                </c:pt>
                <c:pt idx="12">
                  <c:v>13.0</c:v>
                </c:pt>
                <c:pt idx="13">
                  <c:v>14.0</c:v>
                </c:pt>
                <c:pt idx="14">
                  <c:v>15.0</c:v>
                </c:pt>
                <c:pt idx="15">
                  <c:v>16.0</c:v>
                </c:pt>
                <c:pt idx="16">
                  <c:v>17.0</c:v>
                </c:pt>
                <c:pt idx="17">
                  <c:v>18.0</c:v>
                </c:pt>
                <c:pt idx="18">
                  <c:v>19.0</c:v>
                </c:pt>
                <c:pt idx="19">
                  <c:v>20.0</c:v>
                </c:pt>
                <c:pt idx="20">
                  <c:v>21.0</c:v>
                </c:pt>
                <c:pt idx="21">
                  <c:v>22.0</c:v>
                </c:pt>
                <c:pt idx="22">
                  <c:v>23.0</c:v>
                </c:pt>
                <c:pt idx="23">
                  <c:v>24.0</c:v>
                </c:pt>
                <c:pt idx="24">
                  <c:v>25.0</c:v>
                </c:pt>
                <c:pt idx="25">
                  <c:v>26.0</c:v>
                </c:pt>
                <c:pt idx="26">
                  <c:v>27.0</c:v>
                </c:pt>
                <c:pt idx="27">
                  <c:v>28.0</c:v>
                </c:pt>
                <c:pt idx="28">
                  <c:v>29.0</c:v>
                </c:pt>
                <c:pt idx="29">
                  <c:v>30.0</c:v>
                </c:pt>
                <c:pt idx="30">
                  <c:v>31.0</c:v>
                </c:pt>
                <c:pt idx="31">
                  <c:v>32.0</c:v>
                </c:pt>
                <c:pt idx="32">
                  <c:v>33.0</c:v>
                </c:pt>
                <c:pt idx="33">
                  <c:v>34.0</c:v>
                </c:pt>
                <c:pt idx="34">
                  <c:v>35.0</c:v>
                </c:pt>
                <c:pt idx="35">
                  <c:v>36.0</c:v>
                </c:pt>
                <c:pt idx="36">
                  <c:v>37.0</c:v>
                </c:pt>
                <c:pt idx="37">
                  <c:v>38.0</c:v>
                </c:pt>
                <c:pt idx="38">
                  <c:v>39.0</c:v>
                </c:pt>
                <c:pt idx="39">
                  <c:v>40.0</c:v>
                </c:pt>
              </c:numCache>
            </c:numRef>
          </c:xVal>
          <c:yVal>
            <c:numRef>
              <c:f>'qPCR Analysis'!$E$1200:$E$1239</c:f>
              <c:numCache>
                <c:formatCode>General</c:formatCode>
                <c:ptCount val="40"/>
                <c:pt idx="0">
                  <c:v>0.0315206508475967</c:v>
                </c:pt>
                <c:pt idx="1">
                  <c:v>0.0477017078410427</c:v>
                </c:pt>
                <c:pt idx="2">
                  <c:v>0.0721892620877043</c:v>
                </c:pt>
                <c:pt idx="3">
                  <c:v>0.109247412519835</c:v>
                </c:pt>
                <c:pt idx="4">
                  <c:v>0.165329190562261</c:v>
                </c:pt>
                <c:pt idx="5">
                  <c:v>0.250200199056053</c:v>
                </c:pt>
                <c:pt idx="6">
                  <c:v>0.378639010117695</c:v>
                </c:pt>
                <c:pt idx="7">
                  <c:v>0.573010323727431</c:v>
                </c:pt>
                <c:pt idx="8">
                  <c:v>0.867158742285028</c:v>
                </c:pt>
                <c:pt idx="9">
                  <c:v>1.312300696263264</c:v>
                </c:pt>
                <c:pt idx="10">
                  <c:v>1.985939350593981</c:v>
                </c:pt>
                <c:pt idx="11">
                  <c:v>3.005352231857614</c:v>
                </c:pt>
                <c:pt idx="12">
                  <c:v>4.547994161976001</c:v>
                </c:pt>
                <c:pt idx="13">
                  <c:v>6.882354440402196</c:v>
                </c:pt>
                <c:pt idx="14">
                  <c:v>10.41460972276946</c:v>
                </c:pt>
                <c:pt idx="15">
                  <c:v>15.75912356853223</c:v>
                </c:pt>
                <c:pt idx="16">
                  <c:v>23.84490226413254</c:v>
                </c:pt>
                <c:pt idx="17">
                  <c:v>36.07616314751613</c:v>
                </c:pt>
                <c:pt idx="18">
                  <c:v>54.57410450403219</c:v>
                </c:pt>
                <c:pt idx="19">
                  <c:v>82.53998903941283</c:v>
                </c:pt>
                <c:pt idx="20">
                  <c:v>124.7982373616178</c:v>
                </c:pt>
                <c:pt idx="21">
                  <c:v>188.6038171716482</c:v>
                </c:pt>
                <c:pt idx="22">
                  <c:v>284.8312638641382</c:v>
                </c:pt>
                <c:pt idx="23">
                  <c:v>429.7001327918836</c:v>
                </c:pt>
                <c:pt idx="24">
                  <c:v>647.2211387071965</c:v>
                </c:pt>
                <c:pt idx="25">
                  <c:v>972.5344189056577</c:v>
                </c:pt>
                <c:pt idx="26">
                  <c:v>1456.176722936159</c:v>
                </c:pt>
                <c:pt idx="27">
                  <c:v>2168.897517489893</c:v>
                </c:pt>
                <c:pt idx="28">
                  <c:v>3205.676329766853</c:v>
                </c:pt>
                <c:pt idx="29">
                  <c:v>4685.769727067165</c:v>
                </c:pt>
                <c:pt idx="30">
                  <c:v>6743.00546216847</c:v>
                </c:pt>
                <c:pt idx="31">
                  <c:v>9498.675962758913</c:v>
                </c:pt>
                <c:pt idx="32">
                  <c:v>13012.67298216727</c:v>
                </c:pt>
                <c:pt idx="33">
                  <c:v>17222.90230710834</c:v>
                </c:pt>
                <c:pt idx="34">
                  <c:v>21906.41421303491</c:v>
                </c:pt>
                <c:pt idx="35">
                  <c:v>26705.07686740426</c:v>
                </c:pt>
                <c:pt idx="36">
                  <c:v>31224.77390901226</c:v>
                </c:pt>
                <c:pt idx="37">
                  <c:v>35156.48947696359</c:v>
                </c:pt>
                <c:pt idx="38">
                  <c:v>38347.12099372027</c:v>
                </c:pt>
                <c:pt idx="39">
                  <c:v>40793.496842267</c:v>
                </c:pt>
              </c:numCache>
            </c:numRef>
          </c:yVal>
          <c:smooth val="0"/>
        </c:ser>
        <c:ser>
          <c:idx val="5"/>
          <c:order val="2"/>
          <c:tx>
            <c:v>20 P/uL</c:v>
          </c:tx>
          <c:spPr>
            <a:ln w="19050">
              <a:solidFill>
                <a:srgbClr val="5669A5"/>
              </a:solidFill>
              <a:prstDash val="solid"/>
            </a:ln>
          </c:spPr>
          <c:marker>
            <c:symbol val="none"/>
          </c:marker>
          <c:xVal>
            <c:numRef>
              <c:f>'qPCR Analysis'!$A$1200:$A$1239</c:f>
              <c:numCache>
                <c:formatCode>General</c:formatCode>
                <c:ptCount val="40"/>
                <c:pt idx="0">
                  <c:v>1.0</c:v>
                </c:pt>
                <c:pt idx="1">
                  <c:v>2.0</c:v>
                </c:pt>
                <c:pt idx="2">
                  <c:v>3.0</c:v>
                </c:pt>
                <c:pt idx="3">
                  <c:v>4.0</c:v>
                </c:pt>
                <c:pt idx="4">
                  <c:v>5.0</c:v>
                </c:pt>
                <c:pt idx="5">
                  <c:v>6.0</c:v>
                </c:pt>
                <c:pt idx="6">
                  <c:v>7.0</c:v>
                </c:pt>
                <c:pt idx="7">
                  <c:v>8.0</c:v>
                </c:pt>
                <c:pt idx="8">
                  <c:v>9.0</c:v>
                </c:pt>
                <c:pt idx="9">
                  <c:v>10.0</c:v>
                </c:pt>
                <c:pt idx="10">
                  <c:v>11.0</c:v>
                </c:pt>
                <c:pt idx="11">
                  <c:v>12.0</c:v>
                </c:pt>
                <c:pt idx="12">
                  <c:v>13.0</c:v>
                </c:pt>
                <c:pt idx="13">
                  <c:v>14.0</c:v>
                </c:pt>
                <c:pt idx="14">
                  <c:v>15.0</c:v>
                </c:pt>
                <c:pt idx="15">
                  <c:v>16.0</c:v>
                </c:pt>
                <c:pt idx="16">
                  <c:v>17.0</c:v>
                </c:pt>
                <c:pt idx="17">
                  <c:v>18.0</c:v>
                </c:pt>
                <c:pt idx="18">
                  <c:v>19.0</c:v>
                </c:pt>
                <c:pt idx="19">
                  <c:v>20.0</c:v>
                </c:pt>
                <c:pt idx="20">
                  <c:v>21.0</c:v>
                </c:pt>
                <c:pt idx="21">
                  <c:v>22.0</c:v>
                </c:pt>
                <c:pt idx="22">
                  <c:v>23.0</c:v>
                </c:pt>
                <c:pt idx="23">
                  <c:v>24.0</c:v>
                </c:pt>
                <c:pt idx="24">
                  <c:v>25.0</c:v>
                </c:pt>
                <c:pt idx="25">
                  <c:v>26.0</c:v>
                </c:pt>
                <c:pt idx="26">
                  <c:v>27.0</c:v>
                </c:pt>
                <c:pt idx="27">
                  <c:v>28.0</c:v>
                </c:pt>
                <c:pt idx="28">
                  <c:v>29.0</c:v>
                </c:pt>
                <c:pt idx="29">
                  <c:v>30.0</c:v>
                </c:pt>
                <c:pt idx="30">
                  <c:v>31.0</c:v>
                </c:pt>
                <c:pt idx="31">
                  <c:v>32.0</c:v>
                </c:pt>
                <c:pt idx="32">
                  <c:v>33.0</c:v>
                </c:pt>
                <c:pt idx="33">
                  <c:v>34.0</c:v>
                </c:pt>
                <c:pt idx="34">
                  <c:v>35.0</c:v>
                </c:pt>
                <c:pt idx="35">
                  <c:v>36.0</c:v>
                </c:pt>
                <c:pt idx="36">
                  <c:v>37.0</c:v>
                </c:pt>
                <c:pt idx="37">
                  <c:v>38.0</c:v>
                </c:pt>
                <c:pt idx="38">
                  <c:v>39.0</c:v>
                </c:pt>
                <c:pt idx="39">
                  <c:v>40.0</c:v>
                </c:pt>
              </c:numCache>
            </c:numRef>
          </c:xVal>
          <c:yVal>
            <c:numRef>
              <c:f>'qPCR Analysis'!$G$1200:$G$1239</c:f>
              <c:numCache>
                <c:formatCode>General</c:formatCode>
                <c:ptCount val="40"/>
                <c:pt idx="0">
                  <c:v>0.127758010126854</c:v>
                </c:pt>
                <c:pt idx="1">
                  <c:v>0.180980147844821</c:v>
                </c:pt>
                <c:pt idx="2">
                  <c:v>0.256373756270477</c:v>
                </c:pt>
                <c:pt idx="3">
                  <c:v>0.363175004749792</c:v>
                </c:pt>
                <c:pt idx="4">
                  <c:v>0.514467554072326</c:v>
                </c:pt>
                <c:pt idx="5">
                  <c:v>0.728785194303782</c:v>
                </c:pt>
                <c:pt idx="6">
                  <c:v>1.032381942688517</c:v>
                </c:pt>
                <c:pt idx="7">
                  <c:v>1.462447477802925</c:v>
                </c:pt>
                <c:pt idx="8">
                  <c:v>2.071661365516775</c:v>
                </c:pt>
                <c:pt idx="9">
                  <c:v>2.934643079352099</c:v>
                </c:pt>
                <c:pt idx="10">
                  <c:v>4.157086132681778</c:v>
                </c:pt>
                <c:pt idx="11">
                  <c:v>5.888691588295842</c:v>
                </c:pt>
                <c:pt idx="12">
                  <c:v>8.34147789814961</c:v>
                </c:pt>
                <c:pt idx="13">
                  <c:v>11.81569511273665</c:v>
                </c:pt>
                <c:pt idx="14">
                  <c:v>16.73648794023575</c:v>
                </c:pt>
                <c:pt idx="15">
                  <c:v>23.70573857364428</c:v>
                </c:pt>
                <c:pt idx="16">
                  <c:v>33.5753189715906</c:v>
                </c:pt>
                <c:pt idx="17">
                  <c:v>47.55048322006949</c:v>
                </c:pt>
                <c:pt idx="18">
                  <c:v>67.33557919405003</c:v>
                </c:pt>
                <c:pt idx="19">
                  <c:v>95.33895617686507</c:v>
                </c:pt>
                <c:pt idx="20">
                  <c:v>134.9602261487635</c:v>
                </c:pt>
                <c:pt idx="21">
                  <c:v>190.9911951168433</c:v>
                </c:pt>
                <c:pt idx="22">
                  <c:v>270.1718836667533</c:v>
                </c:pt>
                <c:pt idx="23">
                  <c:v>381.9545276872468</c:v>
                </c:pt>
                <c:pt idx="24">
                  <c:v>539.5392232903869</c:v>
                </c:pt>
                <c:pt idx="25">
                  <c:v>761.2497583375297</c:v>
                </c:pt>
                <c:pt idx="26">
                  <c:v>1072.305910186506</c:v>
                </c:pt>
                <c:pt idx="27">
                  <c:v>1506.997090477165</c:v>
                </c:pt>
                <c:pt idx="28">
                  <c:v>2111.13272770283</c:v>
                </c:pt>
                <c:pt idx="29">
                  <c:v>2944.376754752473</c:v>
                </c:pt>
                <c:pt idx="30">
                  <c:v>4081.593362376457</c:v>
                </c:pt>
                <c:pt idx="31">
                  <c:v>5611.599962407715</c:v>
                </c:pt>
                <c:pt idx="32">
                  <c:v>7630.870067405645</c:v>
                </c:pt>
                <c:pt idx="33">
                  <c:v>10229.295226031</c:v>
                </c:pt>
                <c:pt idx="34">
                  <c:v>13466.27926564589</c:v>
                </c:pt>
                <c:pt idx="35">
                  <c:v>17339.68322295696</c:v>
                </c:pt>
                <c:pt idx="36">
                  <c:v>21757.54154643989</c:v>
                </c:pt>
                <c:pt idx="37">
                  <c:v>26528.9617667515</c:v>
                </c:pt>
                <c:pt idx="38">
                  <c:v>31388.10537845831</c:v>
                </c:pt>
                <c:pt idx="39">
                  <c:v>36049.24906668498</c:v>
                </c:pt>
              </c:numCache>
            </c:numRef>
          </c:yVal>
          <c:smooth val="0"/>
        </c:ser>
        <c:ser>
          <c:idx val="7"/>
          <c:order val="3"/>
          <c:tx>
            <c:v>2 P/uL</c:v>
          </c:tx>
          <c:spPr>
            <a:ln w="19050">
              <a:solidFill>
                <a:srgbClr val="41C505"/>
              </a:solidFill>
              <a:prstDash val="solid"/>
            </a:ln>
          </c:spPr>
          <c:marker>
            <c:symbol val="none"/>
          </c:marker>
          <c:xVal>
            <c:numRef>
              <c:f>'qPCR Analysis'!$A$1200:$A$1239</c:f>
              <c:numCache>
                <c:formatCode>General</c:formatCode>
                <c:ptCount val="40"/>
                <c:pt idx="0">
                  <c:v>1.0</c:v>
                </c:pt>
                <c:pt idx="1">
                  <c:v>2.0</c:v>
                </c:pt>
                <c:pt idx="2">
                  <c:v>3.0</c:v>
                </c:pt>
                <c:pt idx="3">
                  <c:v>4.0</c:v>
                </c:pt>
                <c:pt idx="4">
                  <c:v>5.0</c:v>
                </c:pt>
                <c:pt idx="5">
                  <c:v>6.0</c:v>
                </c:pt>
                <c:pt idx="6">
                  <c:v>7.0</c:v>
                </c:pt>
                <c:pt idx="7">
                  <c:v>8.0</c:v>
                </c:pt>
                <c:pt idx="8">
                  <c:v>9.0</c:v>
                </c:pt>
                <c:pt idx="9">
                  <c:v>10.0</c:v>
                </c:pt>
                <c:pt idx="10">
                  <c:v>11.0</c:v>
                </c:pt>
                <c:pt idx="11">
                  <c:v>12.0</c:v>
                </c:pt>
                <c:pt idx="12">
                  <c:v>13.0</c:v>
                </c:pt>
                <c:pt idx="13">
                  <c:v>14.0</c:v>
                </c:pt>
                <c:pt idx="14">
                  <c:v>15.0</c:v>
                </c:pt>
                <c:pt idx="15">
                  <c:v>16.0</c:v>
                </c:pt>
                <c:pt idx="16">
                  <c:v>17.0</c:v>
                </c:pt>
                <c:pt idx="17">
                  <c:v>18.0</c:v>
                </c:pt>
                <c:pt idx="18">
                  <c:v>19.0</c:v>
                </c:pt>
                <c:pt idx="19">
                  <c:v>20.0</c:v>
                </c:pt>
                <c:pt idx="20">
                  <c:v>21.0</c:v>
                </c:pt>
                <c:pt idx="21">
                  <c:v>22.0</c:v>
                </c:pt>
                <c:pt idx="22">
                  <c:v>23.0</c:v>
                </c:pt>
                <c:pt idx="23">
                  <c:v>24.0</c:v>
                </c:pt>
                <c:pt idx="24">
                  <c:v>25.0</c:v>
                </c:pt>
                <c:pt idx="25">
                  <c:v>26.0</c:v>
                </c:pt>
                <c:pt idx="26">
                  <c:v>27.0</c:v>
                </c:pt>
                <c:pt idx="27">
                  <c:v>28.0</c:v>
                </c:pt>
                <c:pt idx="28">
                  <c:v>29.0</c:v>
                </c:pt>
                <c:pt idx="29">
                  <c:v>30.0</c:v>
                </c:pt>
                <c:pt idx="30">
                  <c:v>31.0</c:v>
                </c:pt>
                <c:pt idx="31">
                  <c:v>32.0</c:v>
                </c:pt>
                <c:pt idx="32">
                  <c:v>33.0</c:v>
                </c:pt>
                <c:pt idx="33">
                  <c:v>34.0</c:v>
                </c:pt>
                <c:pt idx="34">
                  <c:v>35.0</c:v>
                </c:pt>
                <c:pt idx="35">
                  <c:v>36.0</c:v>
                </c:pt>
                <c:pt idx="36">
                  <c:v>37.0</c:v>
                </c:pt>
                <c:pt idx="37">
                  <c:v>38.0</c:v>
                </c:pt>
                <c:pt idx="38">
                  <c:v>39.0</c:v>
                </c:pt>
                <c:pt idx="39">
                  <c:v>40.0</c:v>
                </c:pt>
              </c:numCache>
            </c:numRef>
          </c:xVal>
          <c:yVal>
            <c:numRef>
              <c:f>'qPCR Analysis'!$I$1200:$I$1239</c:f>
              <c:numCache>
                <c:formatCode>General</c:formatCode>
                <c:ptCount val="40"/>
                <c:pt idx="0">
                  <c:v>0.626086350177502</c:v>
                </c:pt>
                <c:pt idx="1">
                  <c:v>0.823810913643683</c:v>
                </c:pt>
                <c:pt idx="2">
                  <c:v>1.083978788496097</c:v>
                </c:pt>
                <c:pt idx="3">
                  <c:v>1.42631005612202</c:v>
                </c:pt>
                <c:pt idx="4">
                  <c:v>1.87675246856088</c:v>
                </c:pt>
                <c:pt idx="5">
                  <c:v>2.469448107389326</c:v>
                </c:pt>
                <c:pt idx="6">
                  <c:v>3.249321056193366</c:v>
                </c:pt>
                <c:pt idx="7">
                  <c:v>4.275482151831965</c:v>
                </c:pt>
                <c:pt idx="8">
                  <c:v>5.6257087571048</c:v>
                </c:pt>
                <c:pt idx="9">
                  <c:v>7.40233888543117</c:v>
                </c:pt>
                <c:pt idx="10">
                  <c:v>9.74002604612724</c:v>
                </c:pt>
                <c:pt idx="11">
                  <c:v>12.81594192800367</c:v>
                </c:pt>
                <c:pt idx="12">
                  <c:v>16.86319907833778</c:v>
                </c:pt>
                <c:pt idx="13">
                  <c:v>22.18850893393208</c:v>
                </c:pt>
                <c:pt idx="14">
                  <c:v>29.19541008634769</c:v>
                </c:pt>
                <c:pt idx="15">
                  <c:v>38.41482126837017</c:v>
                </c:pt>
                <c:pt idx="16">
                  <c:v>50.54522423349954</c:v>
                </c:pt>
                <c:pt idx="17">
                  <c:v>66.50550381229341</c:v>
                </c:pt>
                <c:pt idx="18">
                  <c:v>87.50441829352137</c:v>
                </c:pt>
                <c:pt idx="19">
                  <c:v>115.131910421831</c:v>
                </c:pt>
                <c:pt idx="20">
                  <c:v>151.479084297478</c:v>
                </c:pt>
                <c:pt idx="21">
                  <c:v>199.2957762782407</c:v>
                </c:pt>
                <c:pt idx="22">
                  <c:v>262.1973765289276</c:v>
                </c:pt>
                <c:pt idx="23">
                  <c:v>344.9360819144766</c:v>
                </c:pt>
                <c:pt idx="24">
                  <c:v>453.7562837971726</c:v>
                </c:pt>
                <c:pt idx="25">
                  <c:v>596.8595490745179</c:v>
                </c:pt>
                <c:pt idx="26">
                  <c:v>785.0118874011296</c:v>
                </c:pt>
                <c:pt idx="27">
                  <c:v>1032.334938199945</c:v>
                </c:pt>
                <c:pt idx="28">
                  <c:v>1357.333486400012</c:v>
                </c:pt>
                <c:pt idx="29">
                  <c:v>1784.224211516615</c:v>
                </c:pt>
                <c:pt idx="30">
                  <c:v>2344.644169811751</c:v>
                </c:pt>
                <c:pt idx="31">
                  <c:v>3079.830617834723</c:v>
                </c:pt>
                <c:pt idx="32">
                  <c:v>4043.373089983472</c:v>
                </c:pt>
                <c:pt idx="33">
                  <c:v>5304.637866725557</c:v>
                </c:pt>
                <c:pt idx="34">
                  <c:v>6952.943022800197</c:v>
                </c:pt>
                <c:pt idx="35">
                  <c:v>9102.500635317067</c:v>
                </c:pt>
                <c:pt idx="36">
                  <c:v>11898.01246449395</c:v>
                </c:pt>
                <c:pt idx="37">
                  <c:v>15520.56441832425</c:v>
                </c:pt>
                <c:pt idx="38">
                  <c:v>20193.05909242466</c:v>
                </c:pt>
                <c:pt idx="39">
                  <c:v>26183.79888656721</c:v>
                </c:pt>
              </c:numCache>
            </c:numRef>
          </c:yVal>
          <c:smooth val="0"/>
        </c:ser>
        <c:ser>
          <c:idx val="9"/>
          <c:order val="4"/>
          <c:tx>
            <c:v>0.2 P/uL</c:v>
          </c:tx>
          <c:spPr>
            <a:ln w="19050">
              <a:solidFill>
                <a:srgbClr val="4B21A7"/>
              </a:solidFill>
              <a:prstDash val="solid"/>
            </a:ln>
          </c:spPr>
          <c:marker>
            <c:symbol val="none"/>
          </c:marker>
          <c:xVal>
            <c:numRef>
              <c:f>'qPCR Analysis'!$A$1200:$A$1239</c:f>
              <c:numCache>
                <c:formatCode>General</c:formatCode>
                <c:ptCount val="40"/>
                <c:pt idx="0">
                  <c:v>1.0</c:v>
                </c:pt>
                <c:pt idx="1">
                  <c:v>2.0</c:v>
                </c:pt>
                <c:pt idx="2">
                  <c:v>3.0</c:v>
                </c:pt>
                <c:pt idx="3">
                  <c:v>4.0</c:v>
                </c:pt>
                <c:pt idx="4">
                  <c:v>5.0</c:v>
                </c:pt>
                <c:pt idx="5">
                  <c:v>6.0</c:v>
                </c:pt>
                <c:pt idx="6">
                  <c:v>7.0</c:v>
                </c:pt>
                <c:pt idx="7">
                  <c:v>8.0</c:v>
                </c:pt>
                <c:pt idx="8">
                  <c:v>9.0</c:v>
                </c:pt>
                <c:pt idx="9">
                  <c:v>10.0</c:v>
                </c:pt>
                <c:pt idx="10">
                  <c:v>11.0</c:v>
                </c:pt>
                <c:pt idx="11">
                  <c:v>12.0</c:v>
                </c:pt>
                <c:pt idx="12">
                  <c:v>13.0</c:v>
                </c:pt>
                <c:pt idx="13">
                  <c:v>14.0</c:v>
                </c:pt>
                <c:pt idx="14">
                  <c:v>15.0</c:v>
                </c:pt>
                <c:pt idx="15">
                  <c:v>16.0</c:v>
                </c:pt>
                <c:pt idx="16">
                  <c:v>17.0</c:v>
                </c:pt>
                <c:pt idx="17">
                  <c:v>18.0</c:v>
                </c:pt>
                <c:pt idx="18">
                  <c:v>19.0</c:v>
                </c:pt>
                <c:pt idx="19">
                  <c:v>20.0</c:v>
                </c:pt>
                <c:pt idx="20">
                  <c:v>21.0</c:v>
                </c:pt>
                <c:pt idx="21">
                  <c:v>22.0</c:v>
                </c:pt>
                <c:pt idx="22">
                  <c:v>23.0</c:v>
                </c:pt>
                <c:pt idx="23">
                  <c:v>24.0</c:v>
                </c:pt>
                <c:pt idx="24">
                  <c:v>25.0</c:v>
                </c:pt>
                <c:pt idx="25">
                  <c:v>26.0</c:v>
                </c:pt>
                <c:pt idx="26">
                  <c:v>27.0</c:v>
                </c:pt>
                <c:pt idx="27">
                  <c:v>28.0</c:v>
                </c:pt>
                <c:pt idx="28">
                  <c:v>29.0</c:v>
                </c:pt>
                <c:pt idx="29">
                  <c:v>30.0</c:v>
                </c:pt>
                <c:pt idx="30">
                  <c:v>31.0</c:v>
                </c:pt>
                <c:pt idx="31">
                  <c:v>32.0</c:v>
                </c:pt>
                <c:pt idx="32">
                  <c:v>33.0</c:v>
                </c:pt>
                <c:pt idx="33">
                  <c:v>34.0</c:v>
                </c:pt>
                <c:pt idx="34">
                  <c:v>35.0</c:v>
                </c:pt>
                <c:pt idx="35">
                  <c:v>36.0</c:v>
                </c:pt>
                <c:pt idx="36">
                  <c:v>37.0</c:v>
                </c:pt>
                <c:pt idx="37">
                  <c:v>38.0</c:v>
                </c:pt>
                <c:pt idx="38">
                  <c:v>39.0</c:v>
                </c:pt>
                <c:pt idx="39">
                  <c:v>40.0</c:v>
                </c:pt>
              </c:numCache>
            </c:numRef>
          </c:xVal>
          <c:yVal>
            <c:numRef>
              <c:f>'qPCR Analysis'!$K$1200:$K$1239</c:f>
              <c:numCache>
                <c:formatCode>General</c:formatCode>
                <c:ptCount val="40"/>
                <c:pt idx="0">
                  <c:v>0.00286019303894136</c:v>
                </c:pt>
                <c:pt idx="1">
                  <c:v>0.00427417039645661</c:v>
                </c:pt>
                <c:pt idx="2">
                  <c:v>0.00638716769390157</c:v>
                </c:pt>
                <c:pt idx="3">
                  <c:v>0.00954475544313027</c:v>
                </c:pt>
                <c:pt idx="4">
                  <c:v>0.014263341878177</c:v>
                </c:pt>
                <c:pt idx="5">
                  <c:v>0.0213146290370787</c:v>
                </c:pt>
                <c:pt idx="6">
                  <c:v>0.0318518208987371</c:v>
                </c:pt>
                <c:pt idx="7">
                  <c:v>0.047598224326066</c:v>
                </c:pt>
                <c:pt idx="8">
                  <c:v>0.0711290875806299</c:v>
                </c:pt>
                <c:pt idx="9">
                  <c:v>0.106292769734864</c:v>
                </c:pt>
                <c:pt idx="10">
                  <c:v>0.158840121168396</c:v>
                </c:pt>
                <c:pt idx="11">
                  <c:v>0.237365007320477</c:v>
                </c:pt>
                <c:pt idx="12">
                  <c:v>0.354709793728034</c:v>
                </c:pt>
                <c:pt idx="13">
                  <c:v>0.53006565247415</c:v>
                </c:pt>
                <c:pt idx="14">
                  <c:v>0.792111184819078</c:v>
                </c:pt>
                <c:pt idx="15">
                  <c:v>1.183702665870442</c:v>
                </c:pt>
                <c:pt idx="16">
                  <c:v>1.768882976757595</c:v>
                </c:pt>
                <c:pt idx="17">
                  <c:v>2.643355498066739</c:v>
                </c:pt>
                <c:pt idx="18">
                  <c:v>3.950135911909456</c:v>
                </c:pt>
                <c:pt idx="19">
                  <c:v>5.902941673150051</c:v>
                </c:pt>
                <c:pt idx="20">
                  <c:v>8.821144348410598</c:v>
                </c:pt>
                <c:pt idx="21">
                  <c:v>13.182001028159</c:v>
                </c:pt>
                <c:pt idx="22">
                  <c:v>19.69870682571308</c:v>
                </c:pt>
                <c:pt idx="23">
                  <c:v>29.43703316782558</c:v>
                </c:pt>
                <c:pt idx="24">
                  <c:v>43.98962660182205</c:v>
                </c:pt>
                <c:pt idx="25">
                  <c:v>65.73647182827335</c:v>
                </c:pt>
                <c:pt idx="26">
                  <c:v>98.23411192098137</c:v>
                </c:pt>
                <c:pt idx="27">
                  <c:v>146.7972707507706</c:v>
                </c:pt>
                <c:pt idx="28">
                  <c:v>219.3679766622663</c:v>
                </c:pt>
                <c:pt idx="29">
                  <c:v>327.8142781615297</c:v>
                </c:pt>
                <c:pt idx="30">
                  <c:v>489.8708381436918</c:v>
                </c:pt>
                <c:pt idx="31">
                  <c:v>732.0385310423735</c:v>
                </c:pt>
                <c:pt idx="32">
                  <c:v>1093.916698809775</c:v>
                </c:pt>
                <c:pt idx="33">
                  <c:v>1634.675336663047</c:v>
                </c:pt>
                <c:pt idx="34">
                  <c:v>2442.722915565017</c:v>
                </c:pt>
                <c:pt idx="35">
                  <c:v>3650.144743545705</c:v>
                </c:pt>
                <c:pt idx="36">
                  <c:v>5454.259298259763</c:v>
                </c:pt>
                <c:pt idx="37">
                  <c:v>8149.78696310552</c:v>
                </c:pt>
                <c:pt idx="38">
                  <c:v>12176.82304603808</c:v>
                </c:pt>
                <c:pt idx="39">
                  <c:v>18192.30661699069</c:v>
                </c:pt>
              </c:numCache>
            </c:numRef>
          </c:yVal>
          <c:smooth val="0"/>
        </c:ser>
        <c:ser>
          <c:idx val="10"/>
          <c:order val="5"/>
          <c:tx>
            <c:v>negative control</c:v>
          </c:tx>
          <c:spPr>
            <a:ln w="19050">
              <a:solidFill>
                <a:schemeClr val="tx1">
                  <a:lumMod val="65000"/>
                  <a:lumOff val="35000"/>
                </a:schemeClr>
              </a:solidFill>
              <a:prstDash val="solid"/>
            </a:ln>
          </c:spPr>
          <c:marker>
            <c:symbol val="none"/>
          </c:marker>
          <c:xVal>
            <c:numRef>
              <c:f>'qPCR Analysis'!$A$1200:$A$1239</c:f>
              <c:numCache>
                <c:formatCode>General</c:formatCode>
                <c:ptCount val="40"/>
                <c:pt idx="0">
                  <c:v>1.0</c:v>
                </c:pt>
                <c:pt idx="1">
                  <c:v>2.0</c:v>
                </c:pt>
                <c:pt idx="2">
                  <c:v>3.0</c:v>
                </c:pt>
                <c:pt idx="3">
                  <c:v>4.0</c:v>
                </c:pt>
                <c:pt idx="4">
                  <c:v>5.0</c:v>
                </c:pt>
                <c:pt idx="5">
                  <c:v>6.0</c:v>
                </c:pt>
                <c:pt idx="6">
                  <c:v>7.0</c:v>
                </c:pt>
                <c:pt idx="7">
                  <c:v>8.0</c:v>
                </c:pt>
                <c:pt idx="8">
                  <c:v>9.0</c:v>
                </c:pt>
                <c:pt idx="9">
                  <c:v>10.0</c:v>
                </c:pt>
                <c:pt idx="10">
                  <c:v>11.0</c:v>
                </c:pt>
                <c:pt idx="11">
                  <c:v>12.0</c:v>
                </c:pt>
                <c:pt idx="12">
                  <c:v>13.0</c:v>
                </c:pt>
                <c:pt idx="13">
                  <c:v>14.0</c:v>
                </c:pt>
                <c:pt idx="14">
                  <c:v>15.0</c:v>
                </c:pt>
                <c:pt idx="15">
                  <c:v>16.0</c:v>
                </c:pt>
                <c:pt idx="16">
                  <c:v>17.0</c:v>
                </c:pt>
                <c:pt idx="17">
                  <c:v>18.0</c:v>
                </c:pt>
                <c:pt idx="18">
                  <c:v>19.0</c:v>
                </c:pt>
                <c:pt idx="19">
                  <c:v>20.0</c:v>
                </c:pt>
                <c:pt idx="20">
                  <c:v>21.0</c:v>
                </c:pt>
                <c:pt idx="21">
                  <c:v>22.0</c:v>
                </c:pt>
                <c:pt idx="22">
                  <c:v>23.0</c:v>
                </c:pt>
                <c:pt idx="23">
                  <c:v>24.0</c:v>
                </c:pt>
                <c:pt idx="24">
                  <c:v>25.0</c:v>
                </c:pt>
                <c:pt idx="25">
                  <c:v>26.0</c:v>
                </c:pt>
                <c:pt idx="26">
                  <c:v>27.0</c:v>
                </c:pt>
                <c:pt idx="27">
                  <c:v>28.0</c:v>
                </c:pt>
                <c:pt idx="28">
                  <c:v>29.0</c:v>
                </c:pt>
                <c:pt idx="29">
                  <c:v>30.0</c:v>
                </c:pt>
                <c:pt idx="30">
                  <c:v>31.0</c:v>
                </c:pt>
                <c:pt idx="31">
                  <c:v>32.0</c:v>
                </c:pt>
                <c:pt idx="32">
                  <c:v>33.0</c:v>
                </c:pt>
                <c:pt idx="33">
                  <c:v>34.0</c:v>
                </c:pt>
                <c:pt idx="34">
                  <c:v>35.0</c:v>
                </c:pt>
                <c:pt idx="35">
                  <c:v>36.0</c:v>
                </c:pt>
                <c:pt idx="36">
                  <c:v>37.0</c:v>
                </c:pt>
                <c:pt idx="37">
                  <c:v>38.0</c:v>
                </c:pt>
                <c:pt idx="38">
                  <c:v>39.0</c:v>
                </c:pt>
                <c:pt idx="39">
                  <c:v>40.0</c:v>
                </c:pt>
              </c:numCache>
            </c:numRef>
          </c:xVal>
          <c:yVal>
            <c:numRef>
              <c:f>'qPCR Analysis'!$L$1200:$L$1239</c:f>
              <c:numCache>
                <c:formatCode>General</c:formatCode>
                <c:ptCount val="40"/>
                <c:pt idx="0">
                  <c:v>0.00114310683420626</c:v>
                </c:pt>
                <c:pt idx="1">
                  <c:v>0.00173631347570335</c:v>
                </c:pt>
                <c:pt idx="2">
                  <c:v>0.00263736021224759</c:v>
                </c:pt>
                <c:pt idx="3">
                  <c:v>0.00400599833301385</c:v>
                </c:pt>
                <c:pt idx="4">
                  <c:v>0.00608488084253622</c:v>
                </c:pt>
                <c:pt idx="5">
                  <c:v>0.00924258368286246</c:v>
                </c:pt>
                <c:pt idx="6">
                  <c:v>0.014038952485862</c:v>
                </c:pt>
                <c:pt idx="7">
                  <c:v>0.0213243605066964</c:v>
                </c:pt>
                <c:pt idx="8">
                  <c:v>0.0323904757151467</c:v>
                </c:pt>
                <c:pt idx="9">
                  <c:v>0.0491992672650667</c:v>
                </c:pt>
                <c:pt idx="10">
                  <c:v>0.0747308530644659</c:v>
                </c:pt>
                <c:pt idx="11">
                  <c:v>0.113511859961363</c:v>
                </c:pt>
                <c:pt idx="12">
                  <c:v>0.172417971967661</c:v>
                </c:pt>
                <c:pt idx="13">
                  <c:v>0.261892953616552</c:v>
                </c:pt>
                <c:pt idx="14">
                  <c:v>0.397800273560279</c:v>
                </c:pt>
                <c:pt idx="15">
                  <c:v>0.604235607941518</c:v>
                </c:pt>
                <c:pt idx="16">
                  <c:v>0.917798856689842</c:v>
                </c:pt>
                <c:pt idx="17">
                  <c:v>1.394083056968157</c:v>
                </c:pt>
                <c:pt idx="18">
                  <c:v>2.117530592244293</c:v>
                </c:pt>
                <c:pt idx="19">
                  <c:v>3.216404029002661</c:v>
                </c:pt>
                <c:pt idx="20">
                  <c:v>4.885525546394974</c:v>
                </c:pt>
                <c:pt idx="21">
                  <c:v>7.420815876132077</c:v>
                </c:pt>
                <c:pt idx="22">
                  <c:v>11.27175478428398</c:v>
                </c:pt>
                <c:pt idx="23">
                  <c:v>17.12106049455542</c:v>
                </c:pt>
                <c:pt idx="24">
                  <c:v>26.00570654394678</c:v>
                </c:pt>
                <c:pt idx="25">
                  <c:v>39.50071265504084</c:v>
                </c:pt>
                <c:pt idx="26">
                  <c:v>59.9982507449058</c:v>
                </c:pt>
                <c:pt idx="27">
                  <c:v>91.13144844651987</c:v>
                </c:pt>
                <c:pt idx="28">
                  <c:v>138.4177936987999</c:v>
                </c:pt>
                <c:pt idx="29">
                  <c:v>210.2356714744801</c:v>
                </c:pt>
                <c:pt idx="30">
                  <c:v>319.3059193242407</c:v>
                </c:pt>
                <c:pt idx="31">
                  <c:v>484.9381961274829</c:v>
                </c:pt>
                <c:pt idx="32">
                  <c:v>736.433802297839</c:v>
                </c:pt>
                <c:pt idx="33">
                  <c:v>1118.232983752698</c:v>
                </c:pt>
                <c:pt idx="34">
                  <c:v>1697.684183812285</c:v>
                </c:pt>
                <c:pt idx="35">
                  <c:v>2576.732016696191</c:v>
                </c:pt>
                <c:pt idx="36">
                  <c:v>3909.411335960172</c:v>
                </c:pt>
                <c:pt idx="37">
                  <c:v>5927.82701868739</c:v>
                </c:pt>
                <c:pt idx="38">
                  <c:v>8980.26748201059</c:v>
                </c:pt>
                <c:pt idx="39">
                  <c:v>13586.05235892765</c:v>
                </c:pt>
              </c:numCache>
            </c:numRef>
          </c:yVal>
          <c:smooth val="0"/>
        </c:ser>
        <c:ser>
          <c:idx val="11"/>
          <c:order val="6"/>
          <c:tx>
            <c:v>positive control</c:v>
          </c:tx>
          <c:spPr>
            <a:ln w="1905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'qPCR Analysis'!$A$1200:$A$1239</c:f>
              <c:numCache>
                <c:formatCode>General</c:formatCode>
                <c:ptCount val="40"/>
                <c:pt idx="0">
                  <c:v>1.0</c:v>
                </c:pt>
                <c:pt idx="1">
                  <c:v>2.0</c:v>
                </c:pt>
                <c:pt idx="2">
                  <c:v>3.0</c:v>
                </c:pt>
                <c:pt idx="3">
                  <c:v>4.0</c:v>
                </c:pt>
                <c:pt idx="4">
                  <c:v>5.0</c:v>
                </c:pt>
                <c:pt idx="5">
                  <c:v>6.0</c:v>
                </c:pt>
                <c:pt idx="6">
                  <c:v>7.0</c:v>
                </c:pt>
                <c:pt idx="7">
                  <c:v>8.0</c:v>
                </c:pt>
                <c:pt idx="8">
                  <c:v>9.0</c:v>
                </c:pt>
                <c:pt idx="9">
                  <c:v>10.0</c:v>
                </c:pt>
                <c:pt idx="10">
                  <c:v>11.0</c:v>
                </c:pt>
                <c:pt idx="11">
                  <c:v>12.0</c:v>
                </c:pt>
                <c:pt idx="12">
                  <c:v>13.0</c:v>
                </c:pt>
                <c:pt idx="13">
                  <c:v>14.0</c:v>
                </c:pt>
                <c:pt idx="14">
                  <c:v>15.0</c:v>
                </c:pt>
                <c:pt idx="15">
                  <c:v>16.0</c:v>
                </c:pt>
                <c:pt idx="16">
                  <c:v>17.0</c:v>
                </c:pt>
                <c:pt idx="17">
                  <c:v>18.0</c:v>
                </c:pt>
                <c:pt idx="18">
                  <c:v>19.0</c:v>
                </c:pt>
                <c:pt idx="19">
                  <c:v>20.0</c:v>
                </c:pt>
                <c:pt idx="20">
                  <c:v>21.0</c:v>
                </c:pt>
                <c:pt idx="21">
                  <c:v>22.0</c:v>
                </c:pt>
                <c:pt idx="22">
                  <c:v>23.0</c:v>
                </c:pt>
                <c:pt idx="23">
                  <c:v>24.0</c:v>
                </c:pt>
                <c:pt idx="24">
                  <c:v>25.0</c:v>
                </c:pt>
                <c:pt idx="25">
                  <c:v>26.0</c:v>
                </c:pt>
                <c:pt idx="26">
                  <c:v>27.0</c:v>
                </c:pt>
                <c:pt idx="27">
                  <c:v>28.0</c:v>
                </c:pt>
                <c:pt idx="28">
                  <c:v>29.0</c:v>
                </c:pt>
                <c:pt idx="29">
                  <c:v>30.0</c:v>
                </c:pt>
                <c:pt idx="30">
                  <c:v>31.0</c:v>
                </c:pt>
                <c:pt idx="31">
                  <c:v>32.0</c:v>
                </c:pt>
                <c:pt idx="32">
                  <c:v>33.0</c:v>
                </c:pt>
                <c:pt idx="33">
                  <c:v>34.0</c:v>
                </c:pt>
                <c:pt idx="34">
                  <c:v>35.0</c:v>
                </c:pt>
                <c:pt idx="35">
                  <c:v>36.0</c:v>
                </c:pt>
                <c:pt idx="36">
                  <c:v>37.0</c:v>
                </c:pt>
                <c:pt idx="37">
                  <c:v>38.0</c:v>
                </c:pt>
                <c:pt idx="38">
                  <c:v>39.0</c:v>
                </c:pt>
                <c:pt idx="39">
                  <c:v>40.0</c:v>
                </c:pt>
              </c:numCache>
            </c:numRef>
          </c:xVal>
          <c:yVal>
            <c:numRef>
              <c:f>'qPCR Analysis'!$M$1200:$M$1239</c:f>
              <c:numCache>
                <c:formatCode>General</c:formatCode>
                <c:ptCount val="40"/>
                <c:pt idx="0">
                  <c:v>0.0134388549649884</c:v>
                </c:pt>
                <c:pt idx="1">
                  <c:v>0.022590464564928</c:v>
                </c:pt>
                <c:pt idx="2">
                  <c:v>0.0379741449814901</c:v>
                </c:pt>
                <c:pt idx="3">
                  <c:v>0.0638338085809664</c:v>
                </c:pt>
                <c:pt idx="4">
                  <c:v>0.107303369490182</c:v>
                </c:pt>
                <c:pt idx="5">
                  <c:v>0.180374736735757</c:v>
                </c:pt>
                <c:pt idx="6">
                  <c:v>0.303205892290862</c:v>
                </c:pt>
                <c:pt idx="7">
                  <c:v>0.509681477151389</c:v>
                </c:pt>
                <c:pt idx="8">
                  <c:v>0.856759377686103</c:v>
                </c:pt>
                <c:pt idx="9">
                  <c:v>1.440180309924472</c:v>
                </c:pt>
                <c:pt idx="10">
                  <c:v>2.4208700987856</c:v>
                </c:pt>
                <c:pt idx="11">
                  <c:v>4.069306610032072</c:v>
                </c:pt>
                <c:pt idx="12">
                  <c:v>6.840057895833528</c:v>
                </c:pt>
                <c:pt idx="13">
                  <c:v>11.49696123293324</c:v>
                </c:pt>
                <c:pt idx="14">
                  <c:v>19.32321296634291</c:v>
                </c:pt>
                <c:pt idx="15">
                  <c:v>32.47358345724178</c:v>
                </c:pt>
                <c:pt idx="16">
                  <c:v>54.56382652160934</c:v>
                </c:pt>
                <c:pt idx="17">
                  <c:v>91.65398056927915</c:v>
                </c:pt>
                <c:pt idx="18">
                  <c:v>153.8802410140833</c:v>
                </c:pt>
                <c:pt idx="19">
                  <c:v>258.1391893418622</c:v>
                </c:pt>
                <c:pt idx="20">
                  <c:v>432.4359395372636</c:v>
                </c:pt>
                <c:pt idx="21">
                  <c:v>722.7415146437361</c:v>
                </c:pt>
                <c:pt idx="22">
                  <c:v>1203.296847743621</c:v>
                </c:pt>
                <c:pt idx="23">
                  <c:v>1990.718279236507</c:v>
                </c:pt>
                <c:pt idx="24">
                  <c:v>3259.670073499297</c:v>
                </c:pt>
                <c:pt idx="25">
                  <c:v>5250.786880415178</c:v>
                </c:pt>
                <c:pt idx="26">
                  <c:v>8247.904030863769</c:v>
                </c:pt>
                <c:pt idx="27">
                  <c:v>12488.49610105169</c:v>
                </c:pt>
                <c:pt idx="28">
                  <c:v>17991.27141078435</c:v>
                </c:pt>
                <c:pt idx="29">
                  <c:v>24382.55078489434</c:v>
                </c:pt>
                <c:pt idx="30">
                  <c:v>30916.07157655362</c:v>
                </c:pt>
                <c:pt idx="31">
                  <c:v>36778.84729682013</c:v>
                </c:pt>
                <c:pt idx="32">
                  <c:v>41455.536915725</c:v>
                </c:pt>
                <c:pt idx="33">
                  <c:v>44848.04572577843</c:v>
                </c:pt>
                <c:pt idx="34">
                  <c:v>47143.10357473987</c:v>
                </c:pt>
                <c:pt idx="35">
                  <c:v>48623.34295730143</c:v>
                </c:pt>
                <c:pt idx="36">
                  <c:v>49548.86012593559</c:v>
                </c:pt>
                <c:pt idx="37">
                  <c:v>50116.34736869593</c:v>
                </c:pt>
                <c:pt idx="38">
                  <c:v>50460.14904575241</c:v>
                </c:pt>
                <c:pt idx="39">
                  <c:v>50666.9202770917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4466184"/>
        <c:axId val="2124470760"/>
      </c:scatterChart>
      <c:valAx>
        <c:axId val="2124466184"/>
        <c:scaling>
          <c:orientation val="minMax"/>
          <c:max val="40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124470760"/>
        <c:crosses val="autoZero"/>
        <c:crossBetween val="midCat"/>
      </c:valAx>
      <c:valAx>
        <c:axId val="2124470760"/>
        <c:scaling>
          <c:orientation val="minMax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124466184"/>
        <c:crosses val="autoZero"/>
        <c:crossBetween val="midCat"/>
        <c:majorUnit val="30000.0"/>
      </c:valAx>
      <c:spPr>
        <a:noFill/>
        <a:ln w="1230">
          <a:noFill/>
          <a:prstDash val="solid"/>
        </a:ln>
      </c:spPr>
    </c:plotArea>
    <c:plotVisOnly val="1"/>
    <c:dispBlanksAs val="gap"/>
    <c:showDLblsOverMax val="0"/>
  </c:chart>
  <c:spPr>
    <a:noFill/>
    <a:ln w="1230">
      <a:noFill/>
      <a:prstDash val="solid"/>
    </a:ln>
  </c:spPr>
  <c:txPr>
    <a:bodyPr/>
    <a:lstStyle/>
    <a:p>
      <a:pPr>
        <a:defRPr sz="46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F81BAC-CAA8-504F-A2EF-604DA8EA0E49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080569-ECBB-C349-A2BA-0CE07D22BE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1007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080569-ECBB-C349-A2BA-0CE07D22BE6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7235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340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381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539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557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651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075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982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599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53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789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7240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93C19-F017-C947-B16E-16272F31E0B5}" type="datetimeFigureOut">
              <a:rPr lang="en-US" smtClean="0"/>
              <a:t>2014-04-3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BA209-E6D5-FE4D-8CD8-EBAE71AF0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154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0087191"/>
              </p:ext>
            </p:extLst>
          </p:nvPr>
        </p:nvGraphicFramePr>
        <p:xfrm>
          <a:off x="3867081" y="2902424"/>
          <a:ext cx="3236442" cy="27311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4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1817639"/>
              </p:ext>
            </p:extLst>
          </p:nvPr>
        </p:nvGraphicFramePr>
        <p:xfrm>
          <a:off x="413511" y="2902424"/>
          <a:ext cx="3293316" cy="2573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8" name="Rectangle 17"/>
          <p:cNvSpPr/>
          <p:nvPr/>
        </p:nvSpPr>
        <p:spPr>
          <a:xfrm rot="16200000">
            <a:off x="-245901" y="4147958"/>
            <a:ext cx="127508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000" dirty="0" smtClean="0">
                <a:latin typeface="Arial"/>
                <a:cs typeface="Arial"/>
              </a:rPr>
              <a:t>Fluorescence (</a:t>
            </a:r>
            <a:r>
              <a:rPr lang="en-US" sz="1000" dirty="0" err="1">
                <a:latin typeface="Arial"/>
                <a:cs typeface="Arial"/>
              </a:rPr>
              <a:t>Arb</a:t>
            </a:r>
            <a:r>
              <a:rPr lang="en-US" sz="1000" dirty="0">
                <a:latin typeface="Arial"/>
                <a:cs typeface="Arial"/>
              </a:rPr>
              <a:t>)</a:t>
            </a:r>
          </a:p>
        </p:txBody>
      </p:sp>
      <p:sp>
        <p:nvSpPr>
          <p:cNvPr id="19" name="Rectangle 18"/>
          <p:cNvSpPr/>
          <p:nvPr/>
        </p:nvSpPr>
        <p:spPr>
          <a:xfrm>
            <a:off x="1900606" y="5322858"/>
            <a:ext cx="5053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000" dirty="0" smtClean="0">
                <a:latin typeface="Arial"/>
                <a:cs typeface="Arial"/>
              </a:rPr>
              <a:t>Cycle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4851858" y="5322858"/>
            <a:ext cx="11695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000" dirty="0">
                <a:latin typeface="Arial"/>
                <a:cs typeface="Arial"/>
              </a:rPr>
              <a:t>Temperature (°C)</a:t>
            </a:r>
          </a:p>
        </p:txBody>
      </p:sp>
      <p:sp>
        <p:nvSpPr>
          <p:cNvPr id="22" name="Rectangle 21"/>
          <p:cNvSpPr/>
          <p:nvPr/>
        </p:nvSpPr>
        <p:spPr>
          <a:xfrm rot="16200000">
            <a:off x="3288281" y="4183470"/>
            <a:ext cx="8805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sz="1000" dirty="0">
                <a:latin typeface="Arial"/>
                <a:cs typeface="Arial"/>
              </a:rPr>
              <a:t>-dF/</a:t>
            </a:r>
            <a:r>
              <a:rPr lang="en-US" sz="1000" dirty="0" err="1">
                <a:latin typeface="Arial"/>
                <a:cs typeface="Arial"/>
              </a:rPr>
              <a:t>dT</a:t>
            </a:r>
            <a:r>
              <a:rPr lang="en-US" sz="1000" dirty="0">
                <a:latin typeface="Arial"/>
                <a:cs typeface="Arial"/>
              </a:rPr>
              <a:t> (</a:t>
            </a:r>
            <a:r>
              <a:rPr lang="en-US" sz="1000" dirty="0" err="1">
                <a:latin typeface="Arial"/>
                <a:cs typeface="Arial"/>
              </a:rPr>
              <a:t>Arb</a:t>
            </a:r>
            <a:r>
              <a:rPr lang="en-US" sz="1000" dirty="0">
                <a:latin typeface="Arial"/>
                <a:cs typeface="Arial"/>
              </a:rPr>
              <a:t>)</a:t>
            </a:r>
          </a:p>
        </p:txBody>
      </p:sp>
      <p:sp>
        <p:nvSpPr>
          <p:cNvPr id="26" name="Rectangle 25"/>
          <p:cNvSpPr/>
          <p:nvPr/>
        </p:nvSpPr>
        <p:spPr>
          <a:xfrm>
            <a:off x="214746" y="2873000"/>
            <a:ext cx="53775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000" b="1" dirty="0" smtClean="0">
                <a:latin typeface="Arial"/>
                <a:cs typeface="Arial"/>
              </a:rPr>
              <a:t>A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3507938" y="2873000"/>
            <a:ext cx="53775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000" b="1" dirty="0" smtClean="0">
                <a:latin typeface="Arial"/>
                <a:cs typeface="Arial"/>
              </a:rPr>
              <a:t>B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1028322" y="3367273"/>
            <a:ext cx="92849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000" dirty="0" smtClean="0">
                <a:solidFill>
                  <a:prstClr val="black"/>
                </a:solidFill>
                <a:latin typeface="Arial"/>
                <a:cs typeface="Arial"/>
              </a:rPr>
              <a:t>Parasites </a:t>
            </a:r>
            <a:r>
              <a:rPr lang="en-US" sz="1000" dirty="0">
                <a:solidFill>
                  <a:prstClr val="black"/>
                </a:solidFill>
                <a:latin typeface="Arial"/>
                <a:cs typeface="Arial"/>
              </a:rPr>
              <a:t>/ </a:t>
            </a:r>
            <a:r>
              <a:rPr lang="en-US" sz="1000" dirty="0">
                <a:solidFill>
                  <a:prstClr val="black"/>
                </a:solidFill>
                <a:latin typeface="Symbol" charset="2"/>
                <a:cs typeface="Symbol" charset="2"/>
              </a:rPr>
              <a:t>m</a:t>
            </a:r>
            <a:r>
              <a:rPr lang="en-US" sz="1000" dirty="0">
                <a:solidFill>
                  <a:prstClr val="black"/>
                </a:solidFill>
                <a:latin typeface="Arial"/>
                <a:cs typeface="Arial"/>
              </a:rPr>
              <a:t>l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382444" y="3519305"/>
            <a:ext cx="4128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dirty="0" smtClean="0">
                <a:latin typeface="Arial"/>
                <a:cs typeface="Arial"/>
              </a:rPr>
              <a:t>2000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38" name="Straight Connector 37"/>
          <p:cNvCxnSpPr/>
          <p:nvPr/>
        </p:nvCxnSpPr>
        <p:spPr>
          <a:xfrm>
            <a:off x="1739402" y="3634856"/>
            <a:ext cx="234000" cy="0"/>
          </a:xfrm>
          <a:prstGeom prst="line">
            <a:avLst/>
          </a:prstGeom>
          <a:ln w="25400">
            <a:solidFill>
              <a:srgbClr val="4E6428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1439500" y="3637687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dirty="0" smtClean="0">
                <a:latin typeface="Arial"/>
                <a:cs typeface="Arial"/>
              </a:rPr>
              <a:t>200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>
            <a:off x="1739408" y="3754145"/>
            <a:ext cx="234000" cy="0"/>
          </a:xfrm>
          <a:prstGeom prst="line">
            <a:avLst/>
          </a:prstGeom>
          <a:ln w="25400">
            <a:solidFill>
              <a:srgbClr val="D400FA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1496557" y="3756069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20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1739408" y="3873434"/>
            <a:ext cx="234000" cy="0"/>
          </a:xfrm>
          <a:prstGeom prst="line">
            <a:avLst/>
          </a:prstGeom>
          <a:ln w="25400">
            <a:solidFill>
              <a:srgbClr val="5B66A5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1553614" y="3874451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dirty="0" smtClean="0">
                <a:latin typeface="Arial"/>
                <a:cs typeface="Arial"/>
              </a:rPr>
              <a:t>2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44" name="Straight Connector 43"/>
          <p:cNvCxnSpPr/>
          <p:nvPr/>
        </p:nvCxnSpPr>
        <p:spPr>
          <a:xfrm>
            <a:off x="1739408" y="3992723"/>
            <a:ext cx="234000" cy="0"/>
          </a:xfrm>
          <a:prstGeom prst="line">
            <a:avLst/>
          </a:prstGeom>
          <a:ln w="25400">
            <a:solidFill>
              <a:srgbClr val="49CA05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1468054" y="3992833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800" dirty="0" smtClean="0">
                <a:latin typeface="Arial"/>
                <a:cs typeface="Arial"/>
              </a:rPr>
              <a:t>0.2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46" name="Straight Connector 45"/>
          <p:cNvCxnSpPr/>
          <p:nvPr/>
        </p:nvCxnSpPr>
        <p:spPr>
          <a:xfrm>
            <a:off x="1739408" y="4112012"/>
            <a:ext cx="234000" cy="0"/>
          </a:xfrm>
          <a:prstGeom prst="line">
            <a:avLst/>
          </a:prstGeom>
          <a:ln w="25400">
            <a:solidFill>
              <a:srgbClr val="18009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238774" y="4111215"/>
            <a:ext cx="5565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Positive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48" name="Straight Connector 47"/>
          <p:cNvCxnSpPr/>
          <p:nvPr/>
        </p:nvCxnSpPr>
        <p:spPr>
          <a:xfrm>
            <a:off x="1739402" y="4231301"/>
            <a:ext cx="234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1200301" y="4229598"/>
            <a:ext cx="5950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Negative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1739402" y="4350592"/>
            <a:ext cx="234000" cy="0"/>
          </a:xfrm>
          <a:prstGeom prst="line">
            <a:avLst/>
          </a:prstGeom>
          <a:ln w="254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33641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03</TotalTime>
  <Words>30</Words>
  <Application>Microsoft Macintosh PowerPoint</Application>
  <PresentationFormat>On-screen Show 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Brian Taylor</dc:creator>
  <cp:keywords/>
  <dc:description/>
  <cp:lastModifiedBy>Brian Taylor</cp:lastModifiedBy>
  <cp:revision>32</cp:revision>
  <dcterms:created xsi:type="dcterms:W3CDTF">2013-05-31T05:47:18Z</dcterms:created>
  <dcterms:modified xsi:type="dcterms:W3CDTF">2014-04-30T21:46:56Z</dcterms:modified>
  <cp:category/>
</cp:coreProperties>
</file>